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notesSlides/notesSlide2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8" r:id="rId2"/>
    <p:sldId id="269" r:id="rId3"/>
    <p:sldId id="257" r:id="rId4"/>
    <p:sldId id="258" r:id="rId5"/>
    <p:sldId id="261" r:id="rId6"/>
    <p:sldId id="260" r:id="rId7"/>
    <p:sldId id="266" r:id="rId8"/>
  </p:sldIdLst>
  <p:sldSz cx="6858000" cy="9906000" type="A4"/>
  <p:notesSz cx="6819900" cy="9931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96"/>
    <p:restoredTop sz="86364"/>
  </p:normalViewPr>
  <p:slideViewPr>
    <p:cSldViewPr>
      <p:cViewPr varScale="1">
        <p:scale>
          <a:sx n="45" d="100"/>
          <a:sy n="45" d="100"/>
        </p:scale>
        <p:origin x="2184" y="4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NULL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EILEEN1\Work\ZALF\Chlorofilter\Experiments\SIPs\2017_DNA_SIP_Steigerwald\2017_Chloromethane_degradation_SIP_Steigerwal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EILEEN1\Work\ZALF\Chlorofilter\Experiments\SIPs\2017_DNA_SIP_Steigerwald\2017_Chloromethane_degradation_SIP_Steigerwald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EILEEN1\Work\ZALF\Chlorofilter\Experiments\SIPs\2017_DNA_SIP_Steigerwald\2017_Chloromethane_degradation_SIP_Steigerwal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45273295528001"/>
          <c:y val="5.0925925925925902E-2"/>
          <c:w val="0.56528706566687104"/>
          <c:h val="0.81216565952511799"/>
        </c:manualLayout>
      </c:layout>
      <c:scatterChart>
        <c:scatterStyle val="lineMarker"/>
        <c:varyColors val="0"/>
        <c:ser>
          <c:idx val="0"/>
          <c:order val="0"/>
          <c:tx>
            <c:strRef>
              <c:f>'[2017_Chloromethane_degradation_SIP_Steigerwald.xlsx]CH3Cl degradation (mM_DW)'!$A$8</c:f>
              <c:strCache>
                <c:ptCount val="1"/>
                <c:pt idx="0">
                  <c:v>Organic Soil</c:v>
                </c:pt>
              </c:strCache>
            </c:strRef>
          </c:tx>
          <c:spPr>
            <a:ln w="22225">
              <a:solidFill>
                <a:schemeClr val="bg1">
                  <a:lumMod val="85000"/>
                </a:schemeClr>
              </a:solidFill>
              <a:prstDash val="dash"/>
            </a:ln>
          </c:spPr>
          <c:marker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17_Chloromethane_degradation_SIP_Steigerwald.xlsx]CH3Cl degradation (mM_DW)'!$C$22:$O$22</c:f>
                <c:numCache>
                  <c:formatCode>General</c:formatCode>
                  <c:ptCount val="13"/>
                  <c:pt idx="0">
                    <c:v>20.670318097364429</c:v>
                  </c:pt>
                  <c:pt idx="1">
                    <c:v>17.473388564522871</c:v>
                  </c:pt>
                  <c:pt idx="2">
                    <c:v>14.200971963910771</c:v>
                  </c:pt>
                  <c:pt idx="3">
                    <c:v>14.200971963910771</c:v>
                  </c:pt>
                  <c:pt idx="4">
                    <c:v>9.4951240980871567</c:v>
                  </c:pt>
                  <c:pt idx="5">
                    <c:v>8.5083789102893252</c:v>
                  </c:pt>
                  <c:pt idx="6">
                    <c:v>3.1257912284053782</c:v>
                  </c:pt>
                  <c:pt idx="7">
                    <c:v>15.260907090124981</c:v>
                  </c:pt>
                  <c:pt idx="8">
                    <c:v>11.907886821257479</c:v>
                  </c:pt>
                  <c:pt idx="9">
                    <c:v>3.530735022838317</c:v>
                  </c:pt>
                  <c:pt idx="10">
                    <c:v>18.043846669401692</c:v>
                  </c:pt>
                  <c:pt idx="11">
                    <c:v>1.821791440149612</c:v>
                  </c:pt>
                  <c:pt idx="12">
                    <c:v>1.880815015429351</c:v>
                  </c:pt>
                </c:numCache>
              </c:numRef>
            </c:plus>
            <c:minus>
              <c:numRef>
                <c:f>'[2017_Chloromethane_degradation_SIP_Steigerwald.xlsx]CH3Cl degradation (mM_DW)'!$C$22:$O$22</c:f>
                <c:numCache>
                  <c:formatCode>General</c:formatCode>
                  <c:ptCount val="13"/>
                  <c:pt idx="0">
                    <c:v>20.670318097364429</c:v>
                  </c:pt>
                  <c:pt idx="1">
                    <c:v>17.473388564522871</c:v>
                  </c:pt>
                  <c:pt idx="2">
                    <c:v>14.200971963910771</c:v>
                  </c:pt>
                  <c:pt idx="3">
                    <c:v>14.200971963910771</c:v>
                  </c:pt>
                  <c:pt idx="4">
                    <c:v>9.4951240980871567</c:v>
                  </c:pt>
                  <c:pt idx="5">
                    <c:v>8.5083789102893252</c:v>
                  </c:pt>
                  <c:pt idx="6">
                    <c:v>3.1257912284053782</c:v>
                  </c:pt>
                  <c:pt idx="7">
                    <c:v>15.260907090124981</c:v>
                  </c:pt>
                  <c:pt idx="8">
                    <c:v>11.907886821257479</c:v>
                  </c:pt>
                  <c:pt idx="9">
                    <c:v>3.530735022838317</c:v>
                  </c:pt>
                  <c:pt idx="10">
                    <c:v>18.043846669401692</c:v>
                  </c:pt>
                  <c:pt idx="11">
                    <c:v>1.821791440149612</c:v>
                  </c:pt>
                  <c:pt idx="12">
                    <c:v>1.88081501542935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[2017_Chloromethane_degradation_SIP_Steigerwald.xlsx]CH3Cl degradation (mM_D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[2017_Chloromethane_degradation_SIP_Steigerwald.xlsx]CH3Cl degradation (mM_DW)'!$C$8:$O$8</c:f>
              <c:numCache>
                <c:formatCode>0.0</c:formatCode>
                <c:ptCount val="13"/>
                <c:pt idx="0">
                  <c:v>241.58141578856549</c:v>
                </c:pt>
                <c:pt idx="1">
                  <c:v>241.03776948620731</c:v>
                </c:pt>
                <c:pt idx="2">
                  <c:v>151.35395147820171</c:v>
                </c:pt>
                <c:pt idx="3">
                  <c:v>110.751852052573</c:v>
                </c:pt>
                <c:pt idx="4">
                  <c:v>50.482924490669369</c:v>
                </c:pt>
                <c:pt idx="5">
                  <c:v>36.392531003701023</c:v>
                </c:pt>
                <c:pt idx="6">
                  <c:v>19.603783632020999</c:v>
                </c:pt>
                <c:pt idx="7">
                  <c:v>143.40141489157111</c:v>
                </c:pt>
                <c:pt idx="8">
                  <c:v>133.18659196690879</c:v>
                </c:pt>
                <c:pt idx="9">
                  <c:v>17.144640817721189</c:v>
                </c:pt>
                <c:pt idx="10">
                  <c:v>118.7931220073913</c:v>
                </c:pt>
                <c:pt idx="11">
                  <c:v>23.322836066977899</c:v>
                </c:pt>
                <c:pt idx="12">
                  <c:v>18.38678860973130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4F6-9341-83AC-4C92EE9DD768}"/>
            </c:ext>
          </c:extLst>
        </c:ser>
        <c:ser>
          <c:idx val="1"/>
          <c:order val="1"/>
          <c:tx>
            <c:strRef>
              <c:f>'[2017_Chloromethane_degradation_SIP_Steigerwald.xlsx]CH3Cl degradation (mM_DW)'!$A$9</c:f>
              <c:strCache>
                <c:ptCount val="1"/>
                <c:pt idx="0">
                  <c:v>Mineral Soil</c:v>
                </c:pt>
              </c:strCache>
            </c:strRef>
          </c:tx>
          <c:spPr>
            <a:ln w="22225">
              <a:solidFill>
                <a:schemeClr val="bg1">
                  <a:lumMod val="50000"/>
                </a:schemeClr>
              </a:solidFill>
              <a:prstDash val="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17_Chloromethane_degradation_SIP_Steigerwald.xlsx]CH3Cl degradation (mM_DW)'!$C$23:$O$23</c:f>
                <c:numCache>
                  <c:formatCode>General</c:formatCode>
                  <c:ptCount val="13"/>
                  <c:pt idx="0">
                    <c:v>5.3469149061808858</c:v>
                  </c:pt>
                  <c:pt idx="1">
                    <c:v>13.416991571544161</c:v>
                  </c:pt>
                  <c:pt idx="2">
                    <c:v>9.1647600115094452</c:v>
                  </c:pt>
                  <c:pt idx="3">
                    <c:v>9.1647600115094452</c:v>
                  </c:pt>
                  <c:pt idx="4">
                    <c:v>2.0763848542427472</c:v>
                  </c:pt>
                  <c:pt idx="5">
                    <c:v>3.363553830732795</c:v>
                  </c:pt>
                  <c:pt idx="6">
                    <c:v>4.5917472621056916</c:v>
                  </c:pt>
                  <c:pt idx="7">
                    <c:v>22.617586064506341</c:v>
                  </c:pt>
                  <c:pt idx="8">
                    <c:v>5.4583167663511309</c:v>
                  </c:pt>
                  <c:pt idx="9">
                    <c:v>4.6683226961301107</c:v>
                  </c:pt>
                  <c:pt idx="10">
                    <c:v>6.6460806650081352</c:v>
                  </c:pt>
                  <c:pt idx="11">
                    <c:v>4.5509733051326098</c:v>
                  </c:pt>
                  <c:pt idx="12">
                    <c:v>2.594521821903232</c:v>
                  </c:pt>
                </c:numCache>
              </c:numRef>
            </c:plus>
            <c:minus>
              <c:numRef>
                <c:f>'[2017_Chloromethane_degradation_SIP_Steigerwald.xlsx]CH3Cl degradation (mM_DW)'!$C$23:$O$23</c:f>
                <c:numCache>
                  <c:formatCode>General</c:formatCode>
                  <c:ptCount val="13"/>
                  <c:pt idx="0">
                    <c:v>5.3469149061808858</c:v>
                  </c:pt>
                  <c:pt idx="1">
                    <c:v>13.416991571544161</c:v>
                  </c:pt>
                  <c:pt idx="2">
                    <c:v>9.1647600115094452</c:v>
                  </c:pt>
                  <c:pt idx="3">
                    <c:v>9.1647600115094452</c:v>
                  </c:pt>
                  <c:pt idx="4">
                    <c:v>2.0763848542427472</c:v>
                  </c:pt>
                  <c:pt idx="5">
                    <c:v>3.363553830732795</c:v>
                  </c:pt>
                  <c:pt idx="6">
                    <c:v>4.5917472621056916</c:v>
                  </c:pt>
                  <c:pt idx="7">
                    <c:v>22.617586064506341</c:v>
                  </c:pt>
                  <c:pt idx="8">
                    <c:v>5.4583167663511309</c:v>
                  </c:pt>
                  <c:pt idx="9">
                    <c:v>4.6683226961301107</c:v>
                  </c:pt>
                  <c:pt idx="10">
                    <c:v>6.6460806650081352</c:v>
                  </c:pt>
                  <c:pt idx="11">
                    <c:v>4.5509733051326098</c:v>
                  </c:pt>
                  <c:pt idx="12">
                    <c:v>2.59452182190323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[2017_Chloromethane_degradation_SIP_Steigerwald.xlsx]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[2017_Chloromethane_degradation_SIP_Steigerwald.xlsx]CH3Cl degradation (mM_DW)'!$C$9:$O$9</c:f>
              <c:numCache>
                <c:formatCode>0.0</c:formatCode>
                <c:ptCount val="13"/>
                <c:pt idx="0">
                  <c:v>114.12617808146619</c:v>
                </c:pt>
                <c:pt idx="1">
                  <c:v>115.48554437035639</c:v>
                </c:pt>
                <c:pt idx="2">
                  <c:v>82.014023547618436</c:v>
                </c:pt>
                <c:pt idx="3">
                  <c:v>59.633354108125367</c:v>
                </c:pt>
                <c:pt idx="4">
                  <c:v>34.473031916553538</c:v>
                </c:pt>
                <c:pt idx="5">
                  <c:v>33.53318720823988</c:v>
                </c:pt>
                <c:pt idx="6">
                  <c:v>32.805354963852047</c:v>
                </c:pt>
                <c:pt idx="7">
                  <c:v>46.2728732981112</c:v>
                </c:pt>
                <c:pt idx="8">
                  <c:v>77.572573513746647</c:v>
                </c:pt>
                <c:pt idx="9">
                  <c:v>62.513455525327537</c:v>
                </c:pt>
                <c:pt idx="10">
                  <c:v>48.874830648418659</c:v>
                </c:pt>
                <c:pt idx="11">
                  <c:v>35.482841906101633</c:v>
                </c:pt>
                <c:pt idx="12">
                  <c:v>35.15163981235971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4F6-9341-83AC-4C92EE9DD768}"/>
            </c:ext>
          </c:extLst>
        </c:ser>
        <c:ser>
          <c:idx val="2"/>
          <c:order val="2"/>
          <c:tx>
            <c:strRef>
              <c:f>'[2017_Chloromethane_degradation_SIP_Steigerwald.xlsx]CH3Cl degradation (mM_DW)'!$A$6</c:f>
              <c:strCache>
                <c:ptCount val="1"/>
                <c:pt idx="0">
                  <c:v>Leaf litter</c:v>
                </c:pt>
              </c:strCache>
            </c:strRef>
          </c:tx>
          <c:spPr>
            <a:ln w="22225">
              <a:solidFill>
                <a:schemeClr val="accent3">
                  <a:lumMod val="60000"/>
                  <a:lumOff val="40000"/>
                </a:schemeClr>
              </a:solidFill>
              <a:prstDash val="dash"/>
            </a:ln>
          </c:spPr>
          <c:marker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17_Chloromethane_degradation_SIP_Steigerwald.xlsx]CH3Cl degradation (mM_DW)'!$C$20:$O$20</c:f>
                <c:numCache>
                  <c:formatCode>General</c:formatCode>
                  <c:ptCount val="13"/>
                  <c:pt idx="0">
                    <c:v>10.63743996384324</c:v>
                  </c:pt>
                  <c:pt idx="1">
                    <c:v>21.274879927686449</c:v>
                  </c:pt>
                  <c:pt idx="2">
                    <c:v>16.65083891103426</c:v>
                  </c:pt>
                  <c:pt idx="3">
                    <c:v>16.65083891103426</c:v>
                  </c:pt>
                  <c:pt idx="4">
                    <c:v>12.395958851650651</c:v>
                  </c:pt>
                  <c:pt idx="5">
                    <c:v>8.7689482860891488</c:v>
                  </c:pt>
                  <c:pt idx="6">
                    <c:v>1.6508913032142081</c:v>
                  </c:pt>
                  <c:pt idx="7">
                    <c:v>13.39969288883883</c:v>
                  </c:pt>
                  <c:pt idx="8">
                    <c:v>14.320221786382939</c:v>
                  </c:pt>
                  <c:pt idx="9">
                    <c:v>12.72097188927178</c:v>
                  </c:pt>
                  <c:pt idx="10">
                    <c:v>6.9838031989403273</c:v>
                  </c:pt>
                  <c:pt idx="11">
                    <c:v>9.5570022802273211</c:v>
                  </c:pt>
                  <c:pt idx="12">
                    <c:v>8.819705764615513</c:v>
                  </c:pt>
                </c:numCache>
              </c:numRef>
            </c:plus>
            <c:minus>
              <c:numRef>
                <c:f>'[2017_Chloromethane_degradation_SIP_Steigerwald.xlsx]CH3Cl degradation (mM_DW)'!$C$20:$O$20</c:f>
                <c:numCache>
                  <c:formatCode>General</c:formatCode>
                  <c:ptCount val="13"/>
                  <c:pt idx="0">
                    <c:v>10.63743996384324</c:v>
                  </c:pt>
                  <c:pt idx="1">
                    <c:v>21.274879927686449</c:v>
                  </c:pt>
                  <c:pt idx="2">
                    <c:v>16.65083891103426</c:v>
                  </c:pt>
                  <c:pt idx="3">
                    <c:v>16.65083891103426</c:v>
                  </c:pt>
                  <c:pt idx="4">
                    <c:v>12.395958851650651</c:v>
                  </c:pt>
                  <c:pt idx="5">
                    <c:v>8.7689482860891488</c:v>
                  </c:pt>
                  <c:pt idx="6">
                    <c:v>1.6508913032142081</c:v>
                  </c:pt>
                  <c:pt idx="7">
                    <c:v>13.39969288883883</c:v>
                  </c:pt>
                  <c:pt idx="8">
                    <c:v>14.320221786382939</c:v>
                  </c:pt>
                  <c:pt idx="9">
                    <c:v>12.72097188927178</c:v>
                  </c:pt>
                  <c:pt idx="10">
                    <c:v>6.9838031989403273</c:v>
                  </c:pt>
                  <c:pt idx="11">
                    <c:v>9.5570022802273211</c:v>
                  </c:pt>
                  <c:pt idx="12">
                    <c:v>8.81970576461551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[2017_Chloromethane_degradation_SIP_Steigerwald.xlsx]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[2017_Chloromethane_degradation_SIP_Steigerwald.xlsx]CH3Cl degradation (mM_DW)'!$C$6:$O$6</c:f>
              <c:numCache>
                <c:formatCode>0.0</c:formatCode>
                <c:ptCount val="13"/>
                <c:pt idx="0">
                  <c:v>130.56775428850381</c:v>
                </c:pt>
                <c:pt idx="1">
                  <c:v>130.56775428850381</c:v>
                </c:pt>
                <c:pt idx="2">
                  <c:v>92.123478398386951</c:v>
                </c:pt>
                <c:pt idx="3">
                  <c:v>70.336986023659108</c:v>
                </c:pt>
                <c:pt idx="4">
                  <c:v>31.57432769459885</c:v>
                </c:pt>
                <c:pt idx="5">
                  <c:v>22.896587671232471</c:v>
                </c:pt>
                <c:pt idx="6">
                  <c:v>19.818650826503159</c:v>
                </c:pt>
                <c:pt idx="7">
                  <c:v>84.070085661811973</c:v>
                </c:pt>
                <c:pt idx="8">
                  <c:v>84.544698207184652</c:v>
                </c:pt>
                <c:pt idx="9">
                  <c:v>67.396731958523645</c:v>
                </c:pt>
                <c:pt idx="10">
                  <c:v>35.969634398013831</c:v>
                </c:pt>
                <c:pt idx="11">
                  <c:v>31.049372299346349</c:v>
                </c:pt>
                <c:pt idx="12">
                  <c:v>28.1880217975925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84F6-9341-83AC-4C92EE9DD768}"/>
            </c:ext>
          </c:extLst>
        </c:ser>
        <c:ser>
          <c:idx val="3"/>
          <c:order val="3"/>
          <c:tx>
            <c:strRef>
              <c:f>'[2017_Chloromethane_degradation_SIP_Steigerwald.xlsx]CH3Cl degradation (mM_DW)'!$A$7</c:f>
              <c:strCache>
                <c:ptCount val="1"/>
                <c:pt idx="0">
                  <c:v>Degraded leaves</c:v>
                </c:pt>
              </c:strCache>
            </c:strRef>
          </c:tx>
          <c:spPr>
            <a:ln w="22225">
              <a:solidFill>
                <a:schemeClr val="bg2">
                  <a:lumMod val="50000"/>
                </a:schemeClr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[2017_Chloromethane_degradation_SIP_Steigerwald.xlsx]CH3Cl degradation (mM_DW)'!$C$21:$O$21</c:f>
                <c:numCache>
                  <c:formatCode>General</c:formatCode>
                  <c:ptCount val="13"/>
                  <c:pt idx="0">
                    <c:v>14.259538299810551</c:v>
                  </c:pt>
                  <c:pt idx="1">
                    <c:v>14.259538299810551</c:v>
                  </c:pt>
                  <c:pt idx="2">
                    <c:v>15.58855265493335</c:v>
                  </c:pt>
                  <c:pt idx="3">
                    <c:v>15.58855265493335</c:v>
                  </c:pt>
                  <c:pt idx="4">
                    <c:v>12.72396879556816</c:v>
                  </c:pt>
                  <c:pt idx="5">
                    <c:v>0.73450157093146595</c:v>
                  </c:pt>
                  <c:pt idx="6">
                    <c:v>0</c:v>
                  </c:pt>
                  <c:pt idx="7">
                    <c:v>13.305730692164889</c:v>
                  </c:pt>
                  <c:pt idx="8">
                    <c:v>9.9250237469187272</c:v>
                  </c:pt>
                  <c:pt idx="9">
                    <c:v>0</c:v>
                  </c:pt>
                  <c:pt idx="10">
                    <c:v>17.426433615918</c:v>
                  </c:pt>
                  <c:pt idx="11">
                    <c:v>6.1797538654078199</c:v>
                  </c:pt>
                  <c:pt idx="12">
                    <c:v>1.481534199523471</c:v>
                  </c:pt>
                </c:numCache>
              </c:numRef>
            </c:plus>
            <c:minus>
              <c:numRef>
                <c:f>'[2017_Chloromethane_degradation_SIP_Steigerwald.xlsx]CH3Cl degradation (mM_DW)'!$C$21:$O$21</c:f>
                <c:numCache>
                  <c:formatCode>General</c:formatCode>
                  <c:ptCount val="13"/>
                  <c:pt idx="0">
                    <c:v>14.259538299810551</c:v>
                  </c:pt>
                  <c:pt idx="1">
                    <c:v>14.259538299810551</c:v>
                  </c:pt>
                  <c:pt idx="2">
                    <c:v>15.58855265493335</c:v>
                  </c:pt>
                  <c:pt idx="3">
                    <c:v>15.58855265493335</c:v>
                  </c:pt>
                  <c:pt idx="4">
                    <c:v>12.72396879556816</c:v>
                  </c:pt>
                  <c:pt idx="5">
                    <c:v>0.73450157093146595</c:v>
                  </c:pt>
                  <c:pt idx="6">
                    <c:v>0</c:v>
                  </c:pt>
                  <c:pt idx="7">
                    <c:v>13.305730692164889</c:v>
                  </c:pt>
                  <c:pt idx="8">
                    <c:v>9.9250237469187272</c:v>
                  </c:pt>
                  <c:pt idx="9">
                    <c:v>0</c:v>
                  </c:pt>
                  <c:pt idx="10">
                    <c:v>17.426433615918</c:v>
                  </c:pt>
                  <c:pt idx="11">
                    <c:v>6.1797538654078199</c:v>
                  </c:pt>
                  <c:pt idx="12">
                    <c:v>1.48153419952347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[2017_Chloromethane_degradation_SIP_Steigerwald.xlsx]CH3Cl degradation (mM_D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[2017_Chloromethane_degradation_SIP_Steigerwald.xlsx]CH3Cl degradation (mM_DW)'!$C$7:$O$7</c:f>
              <c:numCache>
                <c:formatCode>0.0</c:formatCode>
                <c:ptCount val="13"/>
                <c:pt idx="0">
                  <c:v>225.88512748692051</c:v>
                </c:pt>
                <c:pt idx="1">
                  <c:v>225.88512748692051</c:v>
                </c:pt>
                <c:pt idx="2">
                  <c:v>143.0398972820698</c:v>
                </c:pt>
                <c:pt idx="3">
                  <c:v>96.369940854566408</c:v>
                </c:pt>
                <c:pt idx="4">
                  <c:v>37.17673628897893</c:v>
                </c:pt>
                <c:pt idx="5">
                  <c:v>8.3242373772197151</c:v>
                </c:pt>
                <c:pt idx="6">
                  <c:v>0</c:v>
                </c:pt>
                <c:pt idx="7">
                  <c:v>157.41320470951669</c:v>
                </c:pt>
                <c:pt idx="8">
                  <c:v>38.946383501863657</c:v>
                </c:pt>
                <c:pt idx="9">
                  <c:v>3.9784383927622097E-2</c:v>
                </c:pt>
                <c:pt idx="10">
                  <c:v>107.50034359982411</c:v>
                </c:pt>
                <c:pt idx="11">
                  <c:v>46.584631515700138</c:v>
                </c:pt>
                <c:pt idx="12">
                  <c:v>14.27289221095909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84F6-9341-83AC-4C92EE9DD7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9130312"/>
        <c:axId val="329130696"/>
      </c:scatterChart>
      <c:valAx>
        <c:axId val="329130312"/>
        <c:scaling>
          <c:orientation val="minMax"/>
          <c:max val="65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Time [h]</a:t>
                </a:r>
              </a:p>
            </c:rich>
          </c:tx>
          <c:layout>
            <c:manualLayout>
              <c:xMode val="edge"/>
              <c:yMode val="edge"/>
              <c:x val="0.348993137254902"/>
              <c:y val="0.9364370370370369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29130696"/>
        <c:crosses val="autoZero"/>
        <c:crossBetween val="midCat"/>
        <c:majorUnit val="200"/>
        <c:minorUnit val="40"/>
      </c:valAx>
      <c:valAx>
        <c:axId val="329130696"/>
        <c:scaling>
          <c:orientation val="minMax"/>
          <c:max val="25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H</a:t>
                </a:r>
                <a:r>
                  <a:rPr lang="en-GB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l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concentration [mM g</a:t>
                </a:r>
                <a:r>
                  <a:rPr lang="en-GB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DW]</a:t>
                </a:r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58982511923688E-2"/>
              <c:y val="0.1299157663431609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29130312"/>
        <c:crossesAt val="0"/>
        <c:crossBetween val="midCat"/>
      </c:valAx>
    </c:plotArea>
    <c:legend>
      <c:legendPos val="r"/>
      <c:layout>
        <c:manualLayout>
          <c:xMode val="edge"/>
          <c:yMode val="edge"/>
          <c:x val="0.72773714891361896"/>
          <c:y val="0.23494021580635799"/>
          <c:w val="0.24682564917859001"/>
          <c:h val="0.52086030912802495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558856209150326"/>
          <c:y val="8.6724990849802383E-2"/>
          <c:w val="0.60087728758169934"/>
          <c:h val="0.78190366281702717"/>
        </c:manualLayout>
      </c:layout>
      <c:scatterChart>
        <c:scatterStyle val="lineMarker"/>
        <c:varyColors val="0"/>
        <c:ser>
          <c:idx val="0"/>
          <c:order val="0"/>
          <c:tx>
            <c:strRef>
              <c:f>'CH3Cl degradation (mM_DW)'!$A$26</c:f>
              <c:strCache>
                <c:ptCount val="1"/>
                <c:pt idx="0">
                  <c:v>Organic Soil</c:v>
                </c:pt>
              </c:strCache>
            </c:strRef>
          </c:tx>
          <c:spPr>
            <a:ln w="22225">
              <a:solidFill>
                <a:schemeClr val="bg1">
                  <a:lumMod val="85000"/>
                </a:schemeClr>
              </a:solidFill>
              <a:prstDash val="dash"/>
            </a:ln>
          </c:spPr>
          <c:marker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C$26:$O$26</c:f>
                <c:numCache>
                  <c:formatCode>General</c:formatCode>
                  <c:ptCount val="13"/>
                  <c:pt idx="0">
                    <c:v>45.121802705214712</c:v>
                  </c:pt>
                  <c:pt idx="1">
                    <c:v>81.613252212774469</c:v>
                  </c:pt>
                  <c:pt idx="2">
                    <c:v>27.946047798740903</c:v>
                  </c:pt>
                  <c:pt idx="3">
                    <c:v>57.260431057792601</c:v>
                  </c:pt>
                  <c:pt idx="4">
                    <c:v>23.85299736571773</c:v>
                  </c:pt>
                  <c:pt idx="5">
                    <c:v>21.819505172829089</c:v>
                  </c:pt>
                  <c:pt idx="6">
                    <c:v>13.904587915175279</c:v>
                  </c:pt>
                  <c:pt idx="7">
                    <c:v>63.873890401504852</c:v>
                  </c:pt>
                  <c:pt idx="8">
                    <c:v>13.376672296952822</c:v>
                  </c:pt>
                  <c:pt idx="9">
                    <c:v>1.5797748123431625</c:v>
                  </c:pt>
                  <c:pt idx="10">
                    <c:v>42.766601721060709</c:v>
                  </c:pt>
                  <c:pt idx="11">
                    <c:v>11.087220051263643</c:v>
                  </c:pt>
                  <c:pt idx="12">
                    <c:v>12.221991497985554</c:v>
                  </c:pt>
                </c:numCache>
              </c:numRef>
            </c:plus>
            <c:minus>
              <c:numRef>
                <c:f>'CH3Cl degradation (mM_DW)'!$C$26:$O$26</c:f>
                <c:numCache>
                  <c:formatCode>General</c:formatCode>
                  <c:ptCount val="13"/>
                  <c:pt idx="0">
                    <c:v>45.121802705214712</c:v>
                  </c:pt>
                  <c:pt idx="1">
                    <c:v>81.613252212774469</c:v>
                  </c:pt>
                  <c:pt idx="2">
                    <c:v>27.946047798740903</c:v>
                  </c:pt>
                  <c:pt idx="3">
                    <c:v>57.260431057792601</c:v>
                  </c:pt>
                  <c:pt idx="4">
                    <c:v>23.85299736571773</c:v>
                  </c:pt>
                  <c:pt idx="5">
                    <c:v>21.819505172829089</c:v>
                  </c:pt>
                  <c:pt idx="6">
                    <c:v>13.904587915175279</c:v>
                  </c:pt>
                  <c:pt idx="7">
                    <c:v>63.873890401504852</c:v>
                  </c:pt>
                  <c:pt idx="8">
                    <c:v>13.376672296952822</c:v>
                  </c:pt>
                  <c:pt idx="9">
                    <c:v>1.5797748123431625</c:v>
                  </c:pt>
                  <c:pt idx="10">
                    <c:v>42.766601721060709</c:v>
                  </c:pt>
                  <c:pt idx="11">
                    <c:v>11.087220051263643</c:v>
                  </c:pt>
                  <c:pt idx="12">
                    <c:v>12.22199149798555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CH3Cl degradation (mM_DW)'!$C$12:$O$12</c:f>
              <c:numCache>
                <c:formatCode>0.0</c:formatCode>
                <c:ptCount val="13"/>
                <c:pt idx="0">
                  <c:v>320.44585992917661</c:v>
                </c:pt>
                <c:pt idx="1">
                  <c:v>321.46200461604752</c:v>
                </c:pt>
                <c:pt idx="2">
                  <c:v>221.28434681258349</c:v>
                </c:pt>
                <c:pt idx="3">
                  <c:v>175.92218143531591</c:v>
                </c:pt>
                <c:pt idx="4">
                  <c:v>80.097951877236909</c:v>
                </c:pt>
                <c:pt idx="5">
                  <c:v>65.598825680731309</c:v>
                </c:pt>
                <c:pt idx="6">
                  <c:v>51.454178710814091</c:v>
                </c:pt>
                <c:pt idx="7">
                  <c:v>289.10791641079487</c:v>
                </c:pt>
                <c:pt idx="8">
                  <c:v>102.16496564673038</c:v>
                </c:pt>
                <c:pt idx="9">
                  <c:v>17.561919105649686</c:v>
                </c:pt>
                <c:pt idx="10">
                  <c:v>169.27649466650203</c:v>
                </c:pt>
                <c:pt idx="11">
                  <c:v>58.931670197166582</c:v>
                </c:pt>
                <c:pt idx="12">
                  <c:v>57.8260633594957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A1E9-8C4A-B1A7-852887FE4D51}"/>
            </c:ext>
          </c:extLst>
        </c:ser>
        <c:ser>
          <c:idx val="1"/>
          <c:order val="1"/>
          <c:tx>
            <c:strRef>
              <c:f>'CH3Cl degradation (mM_DW)'!$A$13</c:f>
              <c:strCache>
                <c:ptCount val="1"/>
                <c:pt idx="0">
                  <c:v>Mineral Soil</c:v>
                </c:pt>
              </c:strCache>
            </c:strRef>
          </c:tx>
          <c:spPr>
            <a:ln w="22225">
              <a:solidFill>
                <a:schemeClr val="bg1">
                  <a:lumMod val="50000"/>
                </a:schemeClr>
              </a:solidFill>
              <a:prstDash val="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C$27:$O$27</c:f>
                <c:numCache>
                  <c:formatCode>General</c:formatCode>
                  <c:ptCount val="13"/>
                  <c:pt idx="0">
                    <c:v>29.405438180584248</c:v>
                  </c:pt>
                  <c:pt idx="1">
                    <c:v>59.441051932230074</c:v>
                  </c:pt>
                  <c:pt idx="2">
                    <c:v>28.106671835227647</c:v>
                  </c:pt>
                  <c:pt idx="3">
                    <c:v>37.15325539019797</c:v>
                  </c:pt>
                  <c:pt idx="4">
                    <c:v>19.505817048381811</c:v>
                  </c:pt>
                  <c:pt idx="5">
                    <c:v>18.119198130105133</c:v>
                  </c:pt>
                  <c:pt idx="6">
                    <c:v>6.612963064332555</c:v>
                  </c:pt>
                  <c:pt idx="7">
                    <c:v>12.13450892309568</c:v>
                  </c:pt>
                  <c:pt idx="8">
                    <c:v>10.095345741248504</c:v>
                  </c:pt>
                  <c:pt idx="9">
                    <c:v>8.3003350927542687</c:v>
                  </c:pt>
                  <c:pt idx="10">
                    <c:v>14.70772078803016</c:v>
                  </c:pt>
                  <c:pt idx="11">
                    <c:v>17.693949260445518</c:v>
                  </c:pt>
                  <c:pt idx="12">
                    <c:v>12.223761426715773</c:v>
                  </c:pt>
                </c:numCache>
              </c:numRef>
            </c:plus>
            <c:minus>
              <c:numRef>
                <c:f>'CH3Cl degradation (mM_DW)'!$C$27:$O$27</c:f>
                <c:numCache>
                  <c:formatCode>General</c:formatCode>
                  <c:ptCount val="13"/>
                  <c:pt idx="0">
                    <c:v>29.405438180584248</c:v>
                  </c:pt>
                  <c:pt idx="1">
                    <c:v>59.441051932230074</c:v>
                  </c:pt>
                  <c:pt idx="2">
                    <c:v>28.106671835227647</c:v>
                  </c:pt>
                  <c:pt idx="3">
                    <c:v>37.15325539019797</c:v>
                  </c:pt>
                  <c:pt idx="4">
                    <c:v>19.505817048381811</c:v>
                  </c:pt>
                  <c:pt idx="5">
                    <c:v>18.119198130105133</c:v>
                  </c:pt>
                  <c:pt idx="6">
                    <c:v>6.612963064332555</c:v>
                  </c:pt>
                  <c:pt idx="7">
                    <c:v>12.13450892309568</c:v>
                  </c:pt>
                  <c:pt idx="8">
                    <c:v>10.095345741248504</c:v>
                  </c:pt>
                  <c:pt idx="9">
                    <c:v>8.3003350927542687</c:v>
                  </c:pt>
                  <c:pt idx="10">
                    <c:v>14.70772078803016</c:v>
                  </c:pt>
                  <c:pt idx="11">
                    <c:v>17.693949260445518</c:v>
                  </c:pt>
                  <c:pt idx="12">
                    <c:v>12.22376142671577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CH3Cl degradation (mM_DW)'!$C$13:$O$13</c:f>
              <c:numCache>
                <c:formatCode>0.0</c:formatCode>
                <c:ptCount val="13"/>
                <c:pt idx="0">
                  <c:v>242.80001722005602</c:v>
                </c:pt>
                <c:pt idx="1">
                  <c:v>245.01411399383829</c:v>
                </c:pt>
                <c:pt idx="2">
                  <c:v>177.09424396931234</c:v>
                </c:pt>
                <c:pt idx="3">
                  <c:v>136.17401075901623</c:v>
                </c:pt>
                <c:pt idx="4">
                  <c:v>83.181666776565308</c:v>
                </c:pt>
                <c:pt idx="5">
                  <c:v>77.519083620562967</c:v>
                </c:pt>
                <c:pt idx="6">
                  <c:v>75.739781370238745</c:v>
                </c:pt>
                <c:pt idx="7">
                  <c:v>187.58678646510955</c:v>
                </c:pt>
                <c:pt idx="8">
                  <c:v>106.74134377884755</c:v>
                </c:pt>
                <c:pt idx="9">
                  <c:v>89.166041616998186</c:v>
                </c:pt>
                <c:pt idx="10">
                  <c:v>139.25013243377464</c:v>
                </c:pt>
                <c:pt idx="11">
                  <c:v>128.74663908663638</c:v>
                </c:pt>
                <c:pt idx="12">
                  <c:v>117.2939386524715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A1E9-8C4A-B1A7-852887FE4D51}"/>
            </c:ext>
          </c:extLst>
        </c:ser>
        <c:ser>
          <c:idx val="2"/>
          <c:order val="2"/>
          <c:tx>
            <c:strRef>
              <c:f>'CH3Cl degradation (mM_DW)'!$A$10</c:f>
              <c:strCache>
                <c:ptCount val="1"/>
                <c:pt idx="0">
                  <c:v>Leaf litter</c:v>
                </c:pt>
              </c:strCache>
            </c:strRef>
          </c:tx>
          <c:spPr>
            <a:ln w="22225">
              <a:solidFill>
                <a:schemeClr val="accent3">
                  <a:lumMod val="60000"/>
                  <a:lumOff val="40000"/>
                </a:schemeClr>
              </a:solidFill>
              <a:prstDash val="dash"/>
            </a:ln>
          </c:spPr>
          <c:marker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C$24:$O$24</c:f>
                <c:numCache>
                  <c:formatCode>General</c:formatCode>
                  <c:ptCount val="13"/>
                  <c:pt idx="0">
                    <c:v>10.637439963843235</c:v>
                  </c:pt>
                  <c:pt idx="1">
                    <c:v>21.274879927686449</c:v>
                  </c:pt>
                  <c:pt idx="2">
                    <c:v>16.650838911034256</c:v>
                  </c:pt>
                  <c:pt idx="3">
                    <c:v>16.650838911034256</c:v>
                  </c:pt>
                  <c:pt idx="4">
                    <c:v>12.395958851650644</c:v>
                  </c:pt>
                  <c:pt idx="5">
                    <c:v>8.7689482860891506</c:v>
                  </c:pt>
                  <c:pt idx="6">
                    <c:v>1.6508913032142076</c:v>
                  </c:pt>
                  <c:pt idx="7">
                    <c:v>13.399692888838832</c:v>
                  </c:pt>
                  <c:pt idx="8">
                    <c:v>14.320221786382946</c:v>
                  </c:pt>
                  <c:pt idx="9">
                    <c:v>12.72097188927178</c:v>
                  </c:pt>
                  <c:pt idx="10">
                    <c:v>6.9838031989403246</c:v>
                  </c:pt>
                  <c:pt idx="11">
                    <c:v>9.5570022802273211</c:v>
                  </c:pt>
                  <c:pt idx="12">
                    <c:v>8.8197057646155148</c:v>
                  </c:pt>
                </c:numCache>
              </c:numRef>
            </c:plus>
            <c:minus>
              <c:numRef>
                <c:f>'CH3Cl degradation (mM_DW)'!$C$24:$O$24</c:f>
                <c:numCache>
                  <c:formatCode>General</c:formatCode>
                  <c:ptCount val="13"/>
                  <c:pt idx="0">
                    <c:v>10.637439963843235</c:v>
                  </c:pt>
                  <c:pt idx="1">
                    <c:v>21.274879927686449</c:v>
                  </c:pt>
                  <c:pt idx="2">
                    <c:v>16.650838911034256</c:v>
                  </c:pt>
                  <c:pt idx="3">
                    <c:v>16.650838911034256</c:v>
                  </c:pt>
                  <c:pt idx="4">
                    <c:v>12.395958851650644</c:v>
                  </c:pt>
                  <c:pt idx="5">
                    <c:v>8.7689482860891506</c:v>
                  </c:pt>
                  <c:pt idx="6">
                    <c:v>1.6508913032142076</c:v>
                  </c:pt>
                  <c:pt idx="7">
                    <c:v>13.399692888838832</c:v>
                  </c:pt>
                  <c:pt idx="8">
                    <c:v>14.320221786382946</c:v>
                  </c:pt>
                  <c:pt idx="9">
                    <c:v>12.72097188927178</c:v>
                  </c:pt>
                  <c:pt idx="10">
                    <c:v>6.9838031989403246</c:v>
                  </c:pt>
                  <c:pt idx="11">
                    <c:v>9.5570022802273211</c:v>
                  </c:pt>
                  <c:pt idx="12">
                    <c:v>8.8197057646155148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CH3Cl degradation (mM_DW)'!$C$10:$O$10</c:f>
              <c:numCache>
                <c:formatCode>0.0</c:formatCode>
                <c:ptCount val="13"/>
                <c:pt idx="0">
                  <c:v>343.1647349173985</c:v>
                </c:pt>
                <c:pt idx="1">
                  <c:v>345.42910280834849</c:v>
                </c:pt>
                <c:pt idx="2">
                  <c:v>248.24535851650566</c:v>
                </c:pt>
                <c:pt idx="3">
                  <c:v>145.2546672905209</c:v>
                </c:pt>
                <c:pt idx="4">
                  <c:v>102.52696925720568</c:v>
                </c:pt>
                <c:pt idx="5">
                  <c:v>85.716625439009121</c:v>
                </c:pt>
                <c:pt idx="6">
                  <c:v>72.01677806974665</c:v>
                </c:pt>
                <c:pt idx="7">
                  <c:v>349.56346970351314</c:v>
                </c:pt>
                <c:pt idx="8">
                  <c:v>90.58065890776237</c:v>
                </c:pt>
                <c:pt idx="9">
                  <c:v>79.422700775302786</c:v>
                </c:pt>
                <c:pt idx="10">
                  <c:v>210.99036363591955</c:v>
                </c:pt>
                <c:pt idx="11">
                  <c:v>184.97777293625322</c:v>
                </c:pt>
                <c:pt idx="12">
                  <c:v>174.0928565921704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A1E9-8C4A-B1A7-852887FE4D51}"/>
            </c:ext>
          </c:extLst>
        </c:ser>
        <c:ser>
          <c:idx val="3"/>
          <c:order val="3"/>
          <c:tx>
            <c:strRef>
              <c:f>'CH3Cl degradation (mM_DW)'!$A$11</c:f>
              <c:strCache>
                <c:ptCount val="1"/>
                <c:pt idx="0">
                  <c:v>Degraded leaves</c:v>
                </c:pt>
              </c:strCache>
            </c:strRef>
          </c:tx>
          <c:spPr>
            <a:ln w="22225">
              <a:solidFill>
                <a:schemeClr val="bg2">
                  <a:lumMod val="50000"/>
                </a:schemeClr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C$25:$O$25</c:f>
                <c:numCache>
                  <c:formatCode>General</c:formatCode>
                  <c:ptCount val="13"/>
                  <c:pt idx="0">
                    <c:v>14.259538299810554</c:v>
                  </c:pt>
                  <c:pt idx="1">
                    <c:v>14.259538299810554</c:v>
                  </c:pt>
                  <c:pt idx="2">
                    <c:v>15.588552654933352</c:v>
                  </c:pt>
                  <c:pt idx="3">
                    <c:v>15.588552654933352</c:v>
                  </c:pt>
                  <c:pt idx="4">
                    <c:v>12.723968795568162</c:v>
                  </c:pt>
                  <c:pt idx="5">
                    <c:v>0.73450157093146606</c:v>
                  </c:pt>
                  <c:pt idx="6">
                    <c:v>0</c:v>
                  </c:pt>
                  <c:pt idx="7">
                    <c:v>13.305730692164884</c:v>
                  </c:pt>
                  <c:pt idx="8">
                    <c:v>9.925023746918729</c:v>
                  </c:pt>
                  <c:pt idx="9">
                    <c:v>0</c:v>
                  </c:pt>
                  <c:pt idx="10">
                    <c:v>17.426433615918004</c:v>
                  </c:pt>
                  <c:pt idx="11">
                    <c:v>6.1797538654078199</c:v>
                  </c:pt>
                  <c:pt idx="12">
                    <c:v>1.4815341995234712</c:v>
                  </c:pt>
                </c:numCache>
              </c:numRef>
            </c:plus>
            <c:minus>
              <c:numRef>
                <c:f>'CH3Cl degradation (mM_DW)'!$C$25:$O$25</c:f>
                <c:numCache>
                  <c:formatCode>General</c:formatCode>
                  <c:ptCount val="13"/>
                  <c:pt idx="0">
                    <c:v>14.259538299810554</c:v>
                  </c:pt>
                  <c:pt idx="1">
                    <c:v>14.259538299810554</c:v>
                  </c:pt>
                  <c:pt idx="2">
                    <c:v>15.588552654933352</c:v>
                  </c:pt>
                  <c:pt idx="3">
                    <c:v>15.588552654933352</c:v>
                  </c:pt>
                  <c:pt idx="4">
                    <c:v>12.723968795568162</c:v>
                  </c:pt>
                  <c:pt idx="5">
                    <c:v>0.73450157093146606</c:v>
                  </c:pt>
                  <c:pt idx="6">
                    <c:v>0</c:v>
                  </c:pt>
                  <c:pt idx="7">
                    <c:v>13.305730692164884</c:v>
                  </c:pt>
                  <c:pt idx="8">
                    <c:v>9.925023746918729</c:v>
                  </c:pt>
                  <c:pt idx="9">
                    <c:v>0</c:v>
                  </c:pt>
                  <c:pt idx="10">
                    <c:v>17.426433615918004</c:v>
                  </c:pt>
                  <c:pt idx="11">
                    <c:v>6.1797538654078199</c:v>
                  </c:pt>
                  <c:pt idx="12">
                    <c:v>1.481534199523471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ppm_FW)'!$C$5:$O$5</c:f>
              <c:numCache>
                <c:formatCode>General</c:formatCode>
                <c:ptCount val="13"/>
                <c:pt idx="0" formatCode="0.0">
                  <c:v>0</c:v>
                </c:pt>
                <c:pt idx="1">
                  <c:v>6.5</c:v>
                </c:pt>
                <c:pt idx="2">
                  <c:v>23.5</c:v>
                </c:pt>
                <c:pt idx="3">
                  <c:v>50</c:v>
                </c:pt>
                <c:pt idx="4">
                  <c:v>95.5</c:v>
                </c:pt>
                <c:pt idx="5">
                  <c:v>142</c:v>
                </c:pt>
                <c:pt idx="6">
                  <c:v>173.5</c:v>
                </c:pt>
                <c:pt idx="7">
                  <c:v>245.5</c:v>
                </c:pt>
                <c:pt idx="8">
                  <c:v>291.5</c:v>
                </c:pt>
                <c:pt idx="9">
                  <c:v>478</c:v>
                </c:pt>
                <c:pt idx="10">
                  <c:v>479</c:v>
                </c:pt>
                <c:pt idx="11">
                  <c:v>625.5</c:v>
                </c:pt>
                <c:pt idx="12">
                  <c:v>648</c:v>
                </c:pt>
              </c:numCache>
            </c:numRef>
          </c:xVal>
          <c:yVal>
            <c:numRef>
              <c:f>'CH3Cl degradation (mM_DW)'!$C$11:$O$11</c:f>
              <c:numCache>
                <c:formatCode>0.0</c:formatCode>
                <c:ptCount val="13"/>
                <c:pt idx="0">
                  <c:v>317.06971121991535</c:v>
                </c:pt>
                <c:pt idx="1">
                  <c:v>317.06971121991535</c:v>
                </c:pt>
                <c:pt idx="2">
                  <c:v>229.9790652718533</c:v>
                </c:pt>
                <c:pt idx="3">
                  <c:v>168.35118796929541</c:v>
                </c:pt>
                <c:pt idx="4">
                  <c:v>82.489800583158541</c:v>
                </c:pt>
                <c:pt idx="5">
                  <c:v>59.318137167956522</c:v>
                </c:pt>
                <c:pt idx="6">
                  <c:v>55.319257043073371</c:v>
                </c:pt>
                <c:pt idx="7">
                  <c:v>421.96499675496921</c:v>
                </c:pt>
                <c:pt idx="8">
                  <c:v>36.865942869823925</c:v>
                </c:pt>
                <c:pt idx="9">
                  <c:v>0</c:v>
                </c:pt>
                <c:pt idx="10">
                  <c:v>68.929483912698544</c:v>
                </c:pt>
                <c:pt idx="11">
                  <c:v>25.954490423989846</c:v>
                </c:pt>
                <c:pt idx="12">
                  <c:v>14.78530271641542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A1E9-8C4A-B1A7-852887FE4D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0080896"/>
        <c:axId val="330081280"/>
      </c:scatterChart>
      <c:valAx>
        <c:axId val="330080896"/>
        <c:scaling>
          <c:orientation val="minMax"/>
          <c:max val="65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Time [h]</a:t>
                </a:r>
              </a:p>
            </c:rich>
          </c:tx>
          <c:layout>
            <c:manualLayout>
              <c:xMode val="edge"/>
              <c:yMode val="edge"/>
              <c:x val="0.36933050978075843"/>
              <c:y val="0.9379769235635133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0081280"/>
        <c:crosses val="autoZero"/>
        <c:crossBetween val="midCat"/>
      </c:valAx>
      <c:valAx>
        <c:axId val="330081280"/>
        <c:scaling>
          <c:orientation val="minMax"/>
          <c:max val="45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 sz="1000" b="1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CH3Cl concentration [mM g-1 DW]</a:t>
                </a:r>
                <a:endParaRPr lang="en-GB" sz="100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6.918627450980392E-3"/>
              <c:y val="0.1249061728395061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008089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45273295528042"/>
          <c:y val="5.0925925925925923E-2"/>
          <c:w val="0.56528706566687104"/>
          <c:h val="0.81216565952511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H3Cl degradation (mM_DW)'!$A$101</c:f>
              <c:strCache>
                <c:ptCount val="1"/>
                <c:pt idx="0">
                  <c:v>Organic Soil</c:v>
                </c:pt>
              </c:strCache>
            </c:strRef>
          </c:tx>
          <c:spPr>
            <a:ln w="22225">
              <a:solidFill>
                <a:schemeClr val="bg1">
                  <a:lumMod val="85000"/>
                </a:schemeClr>
              </a:solidFill>
              <a:prstDash val="dash"/>
            </a:ln>
          </c:spPr>
          <c:marker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1:$R$101</c:f>
                <c:numCache>
                  <c:formatCode>General</c:formatCode>
                  <c:ptCount val="7"/>
                  <c:pt idx="0">
                    <c:v>8.2464461991644991E-2</c:v>
                  </c:pt>
                  <c:pt idx="1">
                    <c:v>0.29893367471971305</c:v>
                  </c:pt>
                  <c:pt idx="2">
                    <c:v>0.12369669298746747</c:v>
                  </c:pt>
                  <c:pt idx="3">
                    <c:v>0.28862561697075745</c:v>
                  </c:pt>
                  <c:pt idx="4">
                    <c:v>0.38139813671135808</c:v>
                  </c:pt>
                  <c:pt idx="5">
                    <c:v>0.19585309723015684</c:v>
                  </c:pt>
                  <c:pt idx="6">
                    <c:v>0.2370853282259793</c:v>
                  </c:pt>
                </c:numCache>
              </c:numRef>
            </c:plus>
            <c:minus>
              <c:numRef>
                <c:f>'CH3Cl degradation (mM_DW)'!$L$101:$R$101</c:f>
                <c:numCache>
                  <c:formatCode>General</c:formatCode>
                  <c:ptCount val="7"/>
                  <c:pt idx="0">
                    <c:v>8.2464461991644991E-2</c:v>
                  </c:pt>
                  <c:pt idx="1">
                    <c:v>0.29893367471971305</c:v>
                  </c:pt>
                  <c:pt idx="2">
                    <c:v>0.12369669298746747</c:v>
                  </c:pt>
                  <c:pt idx="3">
                    <c:v>0.28862561697075745</c:v>
                  </c:pt>
                  <c:pt idx="4">
                    <c:v>0.38139813671135808</c:v>
                  </c:pt>
                  <c:pt idx="5">
                    <c:v>0.19585309723015684</c:v>
                  </c:pt>
                  <c:pt idx="6">
                    <c:v>0.237085328225979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1:$H$101</c:f>
              <c:numCache>
                <c:formatCode>0.0</c:formatCode>
                <c:ptCount val="7"/>
                <c:pt idx="0">
                  <c:v>99.142899429455184</c:v>
                </c:pt>
                <c:pt idx="1">
                  <c:v>100.0706246268612</c:v>
                </c:pt>
                <c:pt idx="2">
                  <c:v>99.513989508417595</c:v>
                </c:pt>
                <c:pt idx="3">
                  <c:v>99.142899429455184</c:v>
                </c:pt>
                <c:pt idx="4">
                  <c:v>99.452141161923862</c:v>
                </c:pt>
                <c:pt idx="5">
                  <c:v>100.0706246268612</c:v>
                </c:pt>
                <c:pt idx="6">
                  <c:v>99.5139895084175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333F-A64D-908F-4E030B490D8B}"/>
            </c:ext>
          </c:extLst>
        </c:ser>
        <c:ser>
          <c:idx val="1"/>
          <c:order val="1"/>
          <c:tx>
            <c:strRef>
              <c:f>'CH3Cl degradation (mM_DW)'!$A$102</c:f>
              <c:strCache>
                <c:ptCount val="1"/>
                <c:pt idx="0">
                  <c:v>Mineral Soil</c:v>
                </c:pt>
              </c:strCache>
            </c:strRef>
          </c:tx>
          <c:spPr>
            <a:ln w="22225">
              <a:solidFill>
                <a:schemeClr val="bg1">
                  <a:lumMod val="50000"/>
                </a:schemeClr>
              </a:solidFill>
              <a:prstDash val="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2:$R$102</c:f>
                <c:numCache>
                  <c:formatCode>General</c:formatCode>
                  <c:ptCount val="7"/>
                  <c:pt idx="0">
                    <c:v>0.34530838134969699</c:v>
                  </c:pt>
                  <c:pt idx="1">
                    <c:v>0.38477219636109095</c:v>
                  </c:pt>
                  <c:pt idx="2">
                    <c:v>0.3354424275968485</c:v>
                  </c:pt>
                  <c:pt idx="3">
                    <c:v>0.3354424275968485</c:v>
                  </c:pt>
                  <c:pt idx="4">
                    <c:v>6.9061676269939393E-2</c:v>
                  </c:pt>
                  <c:pt idx="5">
                    <c:v>0.32557647384400001</c:v>
                  </c:pt>
                  <c:pt idx="6">
                    <c:v>0.20718502880981823</c:v>
                  </c:pt>
                </c:numCache>
              </c:numRef>
            </c:plus>
            <c:minus>
              <c:numRef>
                <c:f>'CH3Cl degradation (mM_DW)'!$L$102:$R$102</c:f>
                <c:numCache>
                  <c:formatCode>General</c:formatCode>
                  <c:ptCount val="7"/>
                  <c:pt idx="0">
                    <c:v>0.34530838134969699</c:v>
                  </c:pt>
                  <c:pt idx="1">
                    <c:v>0.38477219636109095</c:v>
                  </c:pt>
                  <c:pt idx="2">
                    <c:v>0.3354424275968485</c:v>
                  </c:pt>
                  <c:pt idx="3">
                    <c:v>0.3354424275968485</c:v>
                  </c:pt>
                  <c:pt idx="4">
                    <c:v>6.9061676269939393E-2</c:v>
                  </c:pt>
                  <c:pt idx="5">
                    <c:v>0.32557647384400001</c:v>
                  </c:pt>
                  <c:pt idx="6">
                    <c:v>0.2071850288098182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2:$H$102</c:f>
              <c:numCache>
                <c:formatCode>0.0</c:formatCode>
                <c:ptCount val="7"/>
                <c:pt idx="0">
                  <c:v>98.205703655853839</c:v>
                </c:pt>
                <c:pt idx="1">
                  <c:v>98.560877990956385</c:v>
                </c:pt>
                <c:pt idx="2">
                  <c:v>98.087312210819647</c:v>
                </c:pt>
                <c:pt idx="3">
                  <c:v>98.738465158507651</c:v>
                </c:pt>
                <c:pt idx="4">
                  <c:v>99.389618106195655</c:v>
                </c:pt>
                <c:pt idx="5">
                  <c:v>99.212030938644375</c:v>
                </c:pt>
                <c:pt idx="6">
                  <c:v>98.6200737134734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333F-A64D-908F-4E030B490D8B}"/>
            </c:ext>
          </c:extLst>
        </c:ser>
        <c:ser>
          <c:idx val="2"/>
          <c:order val="2"/>
          <c:tx>
            <c:strRef>
              <c:f>'CH3Cl degradation (mM_DW)'!$A$99</c:f>
              <c:strCache>
                <c:ptCount val="1"/>
                <c:pt idx="0">
                  <c:v>Leaf litter</c:v>
                </c:pt>
              </c:strCache>
            </c:strRef>
          </c:tx>
          <c:spPr>
            <a:ln w="22225">
              <a:solidFill>
                <a:schemeClr val="accent3">
                  <a:lumMod val="60000"/>
                  <a:lumOff val="40000"/>
                </a:schemeClr>
              </a:solidFill>
              <a:prstDash val="dash"/>
            </a:ln>
          </c:spPr>
          <c:marker>
            <c:spPr>
              <a:solidFill>
                <a:schemeClr val="accent3">
                  <a:lumMod val="60000"/>
                  <a:lumOff val="40000"/>
                </a:schemeClr>
              </a:solidFill>
              <a:ln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99:$R$99</c:f>
                <c:numCache>
                  <c:formatCode>General</c:formatCode>
                  <c:ptCount val="7"/>
                  <c:pt idx="0">
                    <c:v>9.7558652070496255</c:v>
                  </c:pt>
                  <c:pt idx="1">
                    <c:v>8.7254331068161033</c:v>
                  </c:pt>
                  <c:pt idx="2">
                    <c:v>7.6285215162449358</c:v>
                  </c:pt>
                  <c:pt idx="3">
                    <c:v>7.0135862306217067</c:v>
                  </c:pt>
                  <c:pt idx="4">
                    <c:v>6.1493528562323014</c:v>
                  </c:pt>
                  <c:pt idx="5">
                    <c:v>6.6978086515178843</c:v>
                  </c:pt>
                  <c:pt idx="6">
                    <c:v>8.1769773115305213</c:v>
                  </c:pt>
                </c:numCache>
              </c:numRef>
            </c:plus>
            <c:minus>
              <c:numRef>
                <c:f>'CH3Cl degradation (mM_DW)'!$L$99:$R$99</c:f>
                <c:numCache>
                  <c:formatCode>General</c:formatCode>
                  <c:ptCount val="7"/>
                  <c:pt idx="0">
                    <c:v>9.7558652070496255</c:v>
                  </c:pt>
                  <c:pt idx="1">
                    <c:v>8.7254331068161033</c:v>
                  </c:pt>
                  <c:pt idx="2">
                    <c:v>7.6285215162449358</c:v>
                  </c:pt>
                  <c:pt idx="3">
                    <c:v>7.0135862306217067</c:v>
                  </c:pt>
                  <c:pt idx="4">
                    <c:v>6.1493528562323014</c:v>
                  </c:pt>
                  <c:pt idx="5">
                    <c:v>6.6978086515178843</c:v>
                  </c:pt>
                  <c:pt idx="6">
                    <c:v>8.176977311530521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99:$H$99</c:f>
              <c:numCache>
                <c:formatCode>0.0</c:formatCode>
                <c:ptCount val="7"/>
                <c:pt idx="0">
                  <c:v>126.5270899851257</c:v>
                </c:pt>
                <c:pt idx="1">
                  <c:v>125.43017839455453</c:v>
                </c:pt>
                <c:pt idx="2">
                  <c:v>124.79862323634688</c:v>
                </c:pt>
                <c:pt idx="3">
                  <c:v>124.58256489274955</c:v>
                </c:pt>
                <c:pt idx="4">
                  <c:v>124.44960591207425</c:v>
                </c:pt>
                <c:pt idx="5">
                  <c:v>124.61580463791837</c:v>
                </c:pt>
                <c:pt idx="6">
                  <c:v>124.4662257846586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333F-A64D-908F-4E030B490D8B}"/>
            </c:ext>
          </c:extLst>
        </c:ser>
        <c:ser>
          <c:idx val="3"/>
          <c:order val="3"/>
          <c:tx>
            <c:strRef>
              <c:f>'CH3Cl degradation (mM_DW)'!$A$100</c:f>
              <c:strCache>
                <c:ptCount val="1"/>
                <c:pt idx="0">
                  <c:v>Degraded leaves</c:v>
                </c:pt>
              </c:strCache>
            </c:strRef>
          </c:tx>
          <c:spPr>
            <a:ln w="22225">
              <a:solidFill>
                <a:schemeClr val="bg2">
                  <a:lumMod val="50000"/>
                </a:schemeClr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0:$R$100</c:f>
                <c:numCache>
                  <c:formatCode>General</c:formatCode>
                  <c:ptCount val="7"/>
                  <c:pt idx="0">
                    <c:v>4.1658654756096443</c:v>
                  </c:pt>
                  <c:pt idx="1">
                    <c:v>4.1986675659687753</c:v>
                  </c:pt>
                  <c:pt idx="2">
                    <c:v>3.509823668427023</c:v>
                  </c:pt>
                  <c:pt idx="3">
                    <c:v>2.9193860419626643</c:v>
                  </c:pt>
                  <c:pt idx="4">
                    <c:v>2.2961463251391745</c:v>
                  </c:pt>
                  <c:pt idx="5">
                    <c:v>3.2310059003744089</c:v>
                  </c:pt>
                  <c:pt idx="6">
                    <c:v>3.6082299395044162</c:v>
                  </c:pt>
                </c:numCache>
              </c:numRef>
            </c:plus>
            <c:minus>
              <c:numRef>
                <c:f>'CH3Cl degradation (mM_DW)'!$L$100:$R$100</c:f>
                <c:numCache>
                  <c:formatCode>General</c:formatCode>
                  <c:ptCount val="7"/>
                  <c:pt idx="0">
                    <c:v>4.1658654756096443</c:v>
                  </c:pt>
                  <c:pt idx="1">
                    <c:v>4.1986675659687753</c:v>
                  </c:pt>
                  <c:pt idx="2">
                    <c:v>3.509823668427023</c:v>
                  </c:pt>
                  <c:pt idx="3">
                    <c:v>2.9193860419626643</c:v>
                  </c:pt>
                  <c:pt idx="4">
                    <c:v>2.2961463251391745</c:v>
                  </c:pt>
                  <c:pt idx="5">
                    <c:v>3.2310059003744089</c:v>
                  </c:pt>
                  <c:pt idx="6">
                    <c:v>3.608229939504416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0:$H$100</c:f>
              <c:numCache>
                <c:formatCode>0.0</c:formatCode>
                <c:ptCount val="7"/>
                <c:pt idx="0">
                  <c:v>105.85234558891594</c:v>
                </c:pt>
                <c:pt idx="1">
                  <c:v>107.29563756471769</c:v>
                </c:pt>
                <c:pt idx="2">
                  <c:v>106.57399157681681</c:v>
                </c:pt>
                <c:pt idx="3">
                  <c:v>106.67239784789422</c:v>
                </c:pt>
                <c:pt idx="4">
                  <c:v>106.57399157681681</c:v>
                </c:pt>
                <c:pt idx="5">
                  <c:v>107.13162711292205</c:v>
                </c:pt>
                <c:pt idx="6">
                  <c:v>107.1644292032811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333F-A64D-908F-4E030B490D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1262480"/>
        <c:axId val="331266792"/>
      </c:scatterChart>
      <c:valAx>
        <c:axId val="331262480"/>
        <c:scaling>
          <c:orientation val="minMax"/>
          <c:max val="65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Time [h]</a:t>
                </a:r>
              </a:p>
            </c:rich>
          </c:tx>
          <c:layout>
            <c:manualLayout>
              <c:xMode val="edge"/>
              <c:yMode val="edge"/>
              <c:x val="0.34899313725490194"/>
              <c:y val="0.93643703703703707"/>
            </c:manualLayout>
          </c:layout>
          <c:overlay val="0"/>
        </c:title>
        <c:numFmt formatCode="0.0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1266792"/>
        <c:crosses val="autoZero"/>
        <c:crossBetween val="midCat"/>
      </c:valAx>
      <c:valAx>
        <c:axId val="331266792"/>
        <c:scaling>
          <c:orientation val="minMax"/>
          <c:max val="150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H</a:t>
                </a:r>
                <a:r>
                  <a:rPr lang="en-GB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l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concentration [mM g</a:t>
                </a:r>
                <a:r>
                  <a:rPr lang="en-GB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DW]</a:t>
                </a:r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5898251192368838E-2"/>
              <c:y val="0.129915766343160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126248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2773714891361951"/>
          <c:y val="0.23494021580635754"/>
          <c:w val="0.24682564917859035"/>
          <c:h val="0.52086030912802561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45273295528042"/>
          <c:y val="5.0925925925925923E-2"/>
          <c:w val="0.56528706566687104"/>
          <c:h val="0.81216565952511754"/>
        </c:manualLayout>
      </c:layout>
      <c:scatterChart>
        <c:scatterStyle val="lineMarker"/>
        <c:varyColors val="0"/>
        <c:ser>
          <c:idx val="0"/>
          <c:order val="0"/>
          <c:tx>
            <c:strRef>
              <c:f>'CH3Cl degradation (mM_DW)'!$A$101</c:f>
              <c:strCache>
                <c:ptCount val="1"/>
                <c:pt idx="0">
                  <c:v>Organic Soil</c:v>
                </c:pt>
              </c:strCache>
            </c:strRef>
          </c:tx>
          <c:spPr>
            <a:ln w="22225">
              <a:solidFill>
                <a:schemeClr val="bg1">
                  <a:lumMod val="85000"/>
                </a:schemeClr>
              </a:solidFill>
              <a:prstDash val="dash"/>
            </a:ln>
          </c:spPr>
          <c:marker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7:$R$10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CH3Cl degradation (mM_DW)'!$L$107:$R$107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7:$H$107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0308057748955624E-2</c:v>
                </c:pt>
                <c:pt idx="5">
                  <c:v>1.0308057748955624E-2</c:v>
                </c:pt>
                <c:pt idx="6">
                  <c:v>1.0308057748955624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F0FC-604A-8EC4-F3864E9BCA57}"/>
            </c:ext>
          </c:extLst>
        </c:ser>
        <c:ser>
          <c:idx val="1"/>
          <c:order val="1"/>
          <c:tx>
            <c:strRef>
              <c:f>'CH3Cl degradation (mM_DW)'!$A$102</c:f>
              <c:strCache>
                <c:ptCount val="1"/>
                <c:pt idx="0">
                  <c:v>Mineral Soil</c:v>
                </c:pt>
              </c:strCache>
            </c:strRef>
          </c:tx>
          <c:spPr>
            <a:ln w="22225">
              <a:solidFill>
                <a:schemeClr val="bg1">
                  <a:lumMod val="50000"/>
                </a:schemeClr>
              </a:solidFill>
              <a:prstDash val="dash"/>
            </a:ln>
          </c:spPr>
          <c:marker>
            <c:symbol val="square"/>
            <c:size val="4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8:$R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CH3Cl degradation (mM_DW)'!$L$108:$R$108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8:$H$108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9.8659537528484869E-3</c:v>
                </c:pt>
                <c:pt idx="5">
                  <c:v>9.8659537528484869E-3</c:v>
                </c:pt>
                <c:pt idx="6">
                  <c:v>9.8659537528484869E-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F0FC-604A-8EC4-F3864E9BCA57}"/>
            </c:ext>
          </c:extLst>
        </c:ser>
        <c:ser>
          <c:idx val="2"/>
          <c:order val="2"/>
          <c:tx>
            <c:strRef>
              <c:f>'CH3Cl degradation (mM_DW)'!$A$105</c:f>
              <c:strCache>
                <c:ptCount val="1"/>
                <c:pt idx="0">
                  <c:v>Leaf litter</c:v>
                </c:pt>
              </c:strCache>
            </c:strRef>
          </c:tx>
          <c:spPr>
            <a:ln w="22225">
              <a:solidFill>
                <a:schemeClr val="accent3">
                  <a:lumMod val="40000"/>
                  <a:lumOff val="60000"/>
                </a:schemeClr>
              </a:solidFill>
              <a:prstDash val="dash"/>
            </a:ln>
          </c:spPr>
          <c:marker>
            <c:spPr>
              <a:solidFill>
                <a:schemeClr val="accent3">
                  <a:lumMod val="40000"/>
                  <a:lumOff val="60000"/>
                </a:schemeClr>
              </a:solidFill>
              <a:ln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5:$R$10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CH3Cl degradation (mM_DW)'!$L$105:$R$10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5:$H$105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9.9719235506469758E-2</c:v>
                </c:pt>
                <c:pt idx="5">
                  <c:v>9.9719235506469758E-2</c:v>
                </c:pt>
                <c:pt idx="6">
                  <c:v>9.9719235506469758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F0FC-604A-8EC4-F3864E9BCA57}"/>
            </c:ext>
          </c:extLst>
        </c:ser>
        <c:ser>
          <c:idx val="3"/>
          <c:order val="3"/>
          <c:tx>
            <c:strRef>
              <c:f>'CH3Cl degradation (mM_DW)'!$A$100</c:f>
              <c:strCache>
                <c:ptCount val="1"/>
                <c:pt idx="0">
                  <c:v>Degraded leaves</c:v>
                </c:pt>
              </c:strCache>
            </c:strRef>
          </c:tx>
          <c:spPr>
            <a:ln w="22225">
              <a:solidFill>
                <a:schemeClr val="bg2">
                  <a:lumMod val="50000"/>
                </a:schemeClr>
              </a:solidFill>
              <a:prstDash val="dash"/>
            </a:ln>
          </c:spPr>
          <c:marker>
            <c:symbol val="circle"/>
            <c:size val="5"/>
            <c:spPr>
              <a:solidFill>
                <a:schemeClr val="bg2">
                  <a:lumMod val="75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CH3Cl degradation (mM_DW)'!$L$106:$R$10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plus>
            <c:minus>
              <c:numRef>
                <c:f>'CH3Cl degradation (mM_DW)'!$L$106:$R$106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'CH3Cl degradation (mM_DW)'!$B$98:$H$98</c:f>
              <c:numCache>
                <c:formatCode>General</c:formatCode>
                <c:ptCount val="7"/>
                <c:pt idx="0" formatCode="0.0">
                  <c:v>0</c:v>
                </c:pt>
                <c:pt idx="1">
                  <c:v>23.5</c:v>
                </c:pt>
                <c:pt idx="2">
                  <c:v>95.5</c:v>
                </c:pt>
                <c:pt idx="3">
                  <c:v>173.5</c:v>
                </c:pt>
                <c:pt idx="4">
                  <c:v>291.5</c:v>
                </c:pt>
                <c:pt idx="5">
                  <c:v>479</c:v>
                </c:pt>
                <c:pt idx="6">
                  <c:v>648</c:v>
                </c:pt>
              </c:numCache>
            </c:numRef>
          </c:xVal>
          <c:yVal>
            <c:numRef>
              <c:f>'CH3Cl degradation (mM_DW)'!$B$106:$H$106</c:f>
              <c:numCache>
                <c:formatCode>0.0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9203135538696582E-2</c:v>
                </c:pt>
                <c:pt idx="5">
                  <c:v>4.9203135538696582E-2</c:v>
                </c:pt>
                <c:pt idx="6">
                  <c:v>4.9203135538696582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F0FC-604A-8EC4-F3864E9BCA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1266400"/>
        <c:axId val="331264048"/>
      </c:scatterChart>
      <c:valAx>
        <c:axId val="331266400"/>
        <c:scaling>
          <c:orientation val="minMax"/>
          <c:max val="65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Time [h]</a:t>
                </a:r>
              </a:p>
            </c:rich>
          </c:tx>
          <c:layout>
            <c:manualLayout>
              <c:xMode val="edge"/>
              <c:yMode val="edge"/>
              <c:x val="0.34899313725490194"/>
              <c:y val="0.93643703703703707"/>
            </c:manualLayout>
          </c:layout>
          <c:overlay val="0"/>
        </c:title>
        <c:numFmt formatCode="0.0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1264048"/>
        <c:crossesAt val="-5"/>
        <c:crossBetween val="midCat"/>
      </c:valAx>
      <c:valAx>
        <c:axId val="331264048"/>
        <c:scaling>
          <c:orientation val="minMax"/>
          <c:max val="5"/>
          <c:min val="-1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H</a:t>
                </a:r>
                <a:r>
                  <a:rPr lang="en-GB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>
                    <a:latin typeface="Arial" panose="020B0604020202020204" pitchFamily="34" charset="0"/>
                    <a:cs typeface="Arial" panose="020B0604020202020204" pitchFamily="34" charset="0"/>
                  </a:rPr>
                  <a:t>Cl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concentration [mM g</a:t>
                </a:r>
                <a:r>
                  <a:rPr lang="en-GB" baseline="3000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  <a:r>
                  <a:rPr lang="en-GB" baseline="0">
                    <a:latin typeface="Arial" panose="020B0604020202020204" pitchFamily="34" charset="0"/>
                    <a:cs typeface="Arial" panose="020B0604020202020204" pitchFamily="34" charset="0"/>
                  </a:rPr>
                  <a:t> DW]</a:t>
                </a:r>
                <a:endParaRPr lang="en-GB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5898251192368838E-2"/>
              <c:y val="0.129915766343160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331266400"/>
        <c:crossesAt val="-5"/>
        <c:crossBetween val="midCat"/>
      </c:valAx>
    </c:plotArea>
    <c:legend>
      <c:legendPos val="r"/>
      <c:layout>
        <c:manualLayout>
          <c:xMode val="edge"/>
          <c:yMode val="edge"/>
          <c:x val="0.72773714891361951"/>
          <c:y val="0.23494021580635754"/>
          <c:w val="0.24682564917859035"/>
          <c:h val="0.52086030912802561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59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62388" y="0"/>
            <a:ext cx="295592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A0F2B3-34D6-8640-AC38-86ECAC6B1473}" type="datetimeFigureOut">
              <a:rPr lang="en-US" smtClean="0"/>
              <a:t>4/25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9488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2625" y="4779963"/>
            <a:ext cx="5454650" cy="39100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2925"/>
            <a:ext cx="29559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62388" y="9432925"/>
            <a:ext cx="295592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7A50FA-2C2C-ED44-8361-4A5103BAC8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527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 smtClean="0"/>
              <a:t>Figure </a:t>
            </a:r>
            <a:r>
              <a:rPr lang="en-US" b="1" dirty="0"/>
              <a:t>S1. CH</a:t>
            </a:r>
            <a:r>
              <a:rPr lang="en-US" b="1" baseline="-25000" dirty="0"/>
              <a:t>3</a:t>
            </a:r>
            <a:r>
              <a:rPr lang="en-US" b="1" dirty="0"/>
              <a:t>Cl degradation in deciduous forest soil samples during SIP incubations. S1a CH</a:t>
            </a:r>
            <a:r>
              <a:rPr lang="en-US" b="1" baseline="-25000" dirty="0"/>
              <a:t>3</a:t>
            </a:r>
            <a:r>
              <a:rPr lang="en-US" b="1" dirty="0"/>
              <a:t>Cl concentrations in </a:t>
            </a:r>
            <a:r>
              <a:rPr lang="en-US" b="1" baseline="30000" dirty="0"/>
              <a:t>13</a:t>
            </a:r>
            <a:r>
              <a:rPr lang="en-US" b="1" dirty="0"/>
              <a:t>C-CH</a:t>
            </a:r>
            <a:r>
              <a:rPr lang="en-US" b="1" baseline="-25000" dirty="0"/>
              <a:t>3</a:t>
            </a:r>
            <a:r>
              <a:rPr lang="en-US" b="1" dirty="0"/>
              <a:t>Cl DNA SIP experiments. S1b CH</a:t>
            </a:r>
            <a:r>
              <a:rPr lang="en-US" b="1" baseline="-25000" dirty="0"/>
              <a:t>3</a:t>
            </a:r>
            <a:r>
              <a:rPr lang="en-US" b="1" dirty="0"/>
              <a:t>Cl concentrations in </a:t>
            </a:r>
            <a:r>
              <a:rPr lang="en-US" b="1" baseline="30000" dirty="0"/>
              <a:t>12</a:t>
            </a:r>
            <a:r>
              <a:rPr lang="en-US" b="1" dirty="0"/>
              <a:t>C-CH</a:t>
            </a:r>
            <a:r>
              <a:rPr lang="en-US" b="1" baseline="-25000" dirty="0"/>
              <a:t>3</a:t>
            </a:r>
            <a:r>
              <a:rPr lang="en-US" b="1" dirty="0"/>
              <a:t>Cl DNA control SIP experiment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C336DB-A565-6B4D-8B98-BC052DF122F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3352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b="1" dirty="0" smtClean="0"/>
              <a:t>Figure </a:t>
            </a:r>
            <a:r>
              <a:rPr lang="en-US" b="1" dirty="0"/>
              <a:t>S1. CH</a:t>
            </a:r>
            <a:r>
              <a:rPr lang="en-US" b="1" baseline="-25000" dirty="0"/>
              <a:t>3</a:t>
            </a:r>
            <a:r>
              <a:rPr lang="en-US" b="1" dirty="0"/>
              <a:t>Cl degradation in deciduous forest soil samples during SIP incubations. S1a CH</a:t>
            </a:r>
            <a:r>
              <a:rPr lang="en-US" b="1" baseline="-25000" dirty="0"/>
              <a:t>3</a:t>
            </a:r>
            <a:r>
              <a:rPr lang="en-US" b="1" dirty="0"/>
              <a:t>Cl concentrations in </a:t>
            </a:r>
            <a:r>
              <a:rPr lang="en-US" b="1" baseline="30000" dirty="0"/>
              <a:t>13</a:t>
            </a:r>
            <a:r>
              <a:rPr lang="en-US" b="1" dirty="0"/>
              <a:t>C-CH</a:t>
            </a:r>
            <a:r>
              <a:rPr lang="en-US" b="1" baseline="-25000" dirty="0"/>
              <a:t>3</a:t>
            </a:r>
            <a:r>
              <a:rPr lang="en-US" b="1" dirty="0"/>
              <a:t>Cl DNA SIP experiments. S1b CH</a:t>
            </a:r>
            <a:r>
              <a:rPr lang="en-US" b="1" baseline="-25000" dirty="0"/>
              <a:t>3</a:t>
            </a:r>
            <a:r>
              <a:rPr lang="en-US" b="1" dirty="0"/>
              <a:t>Cl concentrations in </a:t>
            </a:r>
            <a:r>
              <a:rPr lang="en-US" b="1" baseline="30000" dirty="0"/>
              <a:t>12</a:t>
            </a:r>
            <a:r>
              <a:rPr lang="en-US" b="1" dirty="0"/>
              <a:t>C-CH</a:t>
            </a:r>
            <a:r>
              <a:rPr lang="en-US" b="1" baseline="-25000" dirty="0"/>
              <a:t>3</a:t>
            </a:r>
            <a:r>
              <a:rPr lang="en-US" b="1" dirty="0"/>
              <a:t>Cl DNA control SIP experiment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C336DB-A565-6B4D-8B98-BC052DF122F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0855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2: Relative distribution of terminal restriction fragments (TRFs) detected by bacterial T-RFLP of fractionated DNA from [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]-CH</a:t>
            </a:r>
            <a:r>
              <a:rPr lang="en-GB" sz="1200" b="1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 and [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2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]-CH</a:t>
            </a:r>
            <a:r>
              <a:rPr lang="en-GB" sz="1200" b="1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 SIP incubations of mineral and organic soil samples and degraded leave samples from 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eigerwald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fter incorporation of 100 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ol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 g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ample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ch column represents relative abundance of microbial taxa (TRFs) detected in a sample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7A50FA-2C2C-ED44-8361-4A5103BAC8B1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544476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3: Relative distribution and phylogenetic affiliation of OTUs detected by bacterial 16S rRNA high-throughput amplicon sequencing of samples before SIP experiments (T0) and fractionated DNA from [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]-CH</a:t>
            </a:r>
            <a:r>
              <a:rPr lang="en-GB" sz="1200" b="1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 and [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2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]-CH</a:t>
            </a:r>
            <a:r>
              <a:rPr lang="en-GB" sz="1200" b="1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 SIP incubations of mineral and organic soil samples and degraded leave samples from 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eigerwald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fter incorporation of 100 </a:t>
            </a:r>
            <a:r>
              <a:rPr lang="en-GB" sz="1200" b="1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ol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 g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1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ample. </a:t>
            </a:r>
            <a:r>
              <a:rPr lang="en-GB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ach column represents relative abundance of microbial taxa detected in a sample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7A50FA-2C2C-ED44-8361-4A5103BAC8B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44672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Figure </a:t>
            </a:r>
            <a:r>
              <a:rPr lang="en-US" b="1" dirty="0"/>
              <a:t>S4: </a:t>
            </a:r>
            <a:r>
              <a:rPr lang="en-GB" sz="1200" b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Average nucleotide identity (ANI) analysis of </a:t>
            </a:r>
            <a:r>
              <a:rPr lang="en-GB" sz="1200" b="1" i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“</a:t>
            </a:r>
            <a:r>
              <a:rPr lang="en-GB" sz="1200" b="1" i="0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Degraded leaves bin 11</a:t>
            </a:r>
            <a:r>
              <a:rPr lang="en-GB" sz="1200" b="1" i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” </a:t>
            </a:r>
            <a:r>
              <a:rPr lang="en-GB" sz="1200" b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and the closely related </a:t>
            </a:r>
            <a:r>
              <a:rPr lang="en-GB" sz="1200" b="1" i="1" dirty="0" err="1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Granulicella</a:t>
            </a:r>
            <a:r>
              <a:rPr lang="en-GB" sz="1200" b="1" i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 b="1" i="1" dirty="0" err="1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mallensis</a:t>
            </a:r>
            <a:r>
              <a:rPr lang="en-GB" sz="1200" b="1" i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Times" pitchFamily="2" charset="0"/>
                <a:ea typeface="MS Mincho" panose="02020609040205080304" pitchFamily="49" charset="-128"/>
                <a:cs typeface="Arial" panose="020B0604020202020204" pitchFamily="34" charset="0"/>
              </a:rPr>
              <a:t>and AAI analysis between those two species.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7A50FA-2C2C-ED44-8361-4A5103BAC8B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2421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5. Metabolic reconstruction of [</a:t>
            </a:r>
            <a:r>
              <a:rPr lang="en-GB" sz="1200" b="1" kern="1200" baseline="30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]-CH</a:t>
            </a:r>
            <a:r>
              <a:rPr lang="en-GB" sz="1200" b="1" kern="1200" baseline="-250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3</a:t>
            </a:r>
            <a:r>
              <a:rPr lang="en-GB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l labelled metagenome assembled genome “Degraded leaves Bin 11”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7A50FA-2C2C-ED44-8361-4A5103BAC8B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81811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dirty="0" smtClean="0">
                <a:latin typeface="Palatino Linotype" panose="02040502050505030304" pitchFamily="18" charset="0"/>
              </a:rPr>
              <a:t>Table </a:t>
            </a:r>
            <a:r>
              <a:rPr lang="en-GB" sz="1200" b="1" dirty="0">
                <a:latin typeface="Palatino Linotype" panose="02040502050505030304" pitchFamily="18" charset="0"/>
              </a:rPr>
              <a:t>S1. Summary of metagenome-assembled genomes (MAGs) from the CH</a:t>
            </a:r>
            <a:r>
              <a:rPr lang="en-GB" sz="1200" b="1" baseline="-25000" dirty="0">
                <a:latin typeface="Palatino Linotype" panose="02040502050505030304" pitchFamily="18" charset="0"/>
              </a:rPr>
              <a:t>3</a:t>
            </a:r>
            <a:r>
              <a:rPr lang="en-GB" sz="1200" b="1" dirty="0">
                <a:latin typeface="Palatino Linotype" panose="02040502050505030304" pitchFamily="18" charset="0"/>
              </a:rPr>
              <a:t>Cl-stable isotope probing enrichment. </a:t>
            </a:r>
            <a:r>
              <a:rPr lang="en-GB" sz="1200" dirty="0">
                <a:latin typeface="Palatino Linotype" panose="02040502050505030304" pitchFamily="18" charset="0"/>
              </a:rPr>
              <a:t>Only MAGs with high quality (completeness &gt; 70%, contamination &lt;10%) are shown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7A50FA-2C2C-ED44-8361-4A5103BAC8B1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5684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5745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5578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0841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88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42101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97732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27860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82017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1370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150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928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2FBE6-B834-4CDC-9BB6-6398AB65CEF9}" type="datetimeFigureOut">
              <a:rPr lang="en-GB" smtClean="0"/>
              <a:t>25/04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71BA7E-F28C-40CC-AA70-CB506E3699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7503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4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83312" y="560912"/>
            <a:ext cx="5904000" cy="3095944"/>
            <a:chOff x="0" y="161843"/>
            <a:chExt cx="6120000" cy="3478207"/>
          </a:xfrm>
        </p:grpSpPr>
        <p:graphicFrame>
          <p:nvGraphicFramePr>
            <p:cNvPr id="5" name="Chart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35446563"/>
                </p:ext>
              </p:extLst>
            </p:nvPr>
          </p:nvGraphicFramePr>
          <p:xfrm>
            <a:off x="0" y="400050"/>
            <a:ext cx="6120000" cy="32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6" name="Straight Arrow Connector 5"/>
            <p:cNvCxnSpPr/>
            <p:nvPr/>
          </p:nvCxnSpPr>
          <p:spPr>
            <a:xfrm>
              <a:off x="781050" y="161843"/>
              <a:ext cx="0" cy="404450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/>
            <p:cNvCxnSpPr/>
            <p:nvPr/>
          </p:nvCxnSpPr>
          <p:spPr>
            <a:xfrm>
              <a:off x="2076450" y="970788"/>
              <a:ext cx="0" cy="404450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/>
            <p:cNvCxnSpPr/>
            <p:nvPr/>
          </p:nvCxnSpPr>
          <p:spPr>
            <a:xfrm>
              <a:off x="3333751" y="1294429"/>
              <a:ext cx="0" cy="404450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xmlns="" id="{2149291D-41DB-4749-A237-029D71B6C2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5219136"/>
              </p:ext>
            </p:extLst>
          </p:nvPr>
        </p:nvGraphicFramePr>
        <p:xfrm>
          <a:off x="368823" y="3705984"/>
          <a:ext cx="5178489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9257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69257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79333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25160">
                <a:tc gridSpan="3"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H</a:t>
                      </a:r>
                      <a:r>
                        <a:rPr lang="en-GB" sz="1000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l dissipation rate [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M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 CH</a:t>
                      </a:r>
                      <a:r>
                        <a:rPr lang="en-GB" sz="1000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l g</a:t>
                      </a:r>
                      <a:r>
                        <a:rPr lang="en-GB" sz="1000" baseline="30000" dirty="0">
                          <a:solidFill>
                            <a:schemeClr val="tx1"/>
                          </a:solidFill>
                          <a:latin typeface="+mn-lt"/>
                        </a:rPr>
                        <a:t>-1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 DW h</a:t>
                      </a:r>
                      <a:r>
                        <a:rPr lang="en-GB" sz="1000" baseline="30000" dirty="0">
                          <a:solidFill>
                            <a:schemeClr val="tx1"/>
                          </a:solidFill>
                          <a:latin typeface="+mn-lt"/>
                        </a:rPr>
                        <a:t>-1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Samp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72h [T2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23.5h</a:t>
                      </a:r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 – T4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95.5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  <a:endParaRPr lang="en-GB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169h [T10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479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 – T12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648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  <a:endParaRPr lang="en-GB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Leaf litt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84 (± 0.06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5 (± 0.01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Degraded leave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47 (± 0.04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5 (± 0.09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Organic Soi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40 (± 0.07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59 (± 0.10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Mineral soi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6 (± 0.10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08 (± 0.02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xmlns="" id="{B48465B1-4C7F-7B4E-A09B-7D3553DC09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7044932"/>
              </p:ext>
            </p:extLst>
          </p:nvPr>
        </p:nvGraphicFramePr>
        <p:xfrm>
          <a:off x="368823" y="8398838"/>
          <a:ext cx="5178489" cy="14630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9257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69257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79333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225160">
                <a:tc gridSpan="3">
                  <a:txBody>
                    <a:bodyPr/>
                    <a:lstStyle/>
                    <a:p>
                      <a:pPr algn="l"/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H</a:t>
                      </a:r>
                      <a:r>
                        <a:rPr lang="en-GB" sz="1000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l dissipation rate [</a:t>
                      </a:r>
                      <a:r>
                        <a:rPr lang="en-GB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mM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 CH</a:t>
                      </a:r>
                      <a:r>
                        <a:rPr lang="en-GB" sz="1000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3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l g</a:t>
                      </a:r>
                      <a:r>
                        <a:rPr lang="en-GB" sz="1000" baseline="30000" dirty="0">
                          <a:solidFill>
                            <a:schemeClr val="tx1"/>
                          </a:solidFill>
                          <a:latin typeface="+mn-lt"/>
                        </a:rPr>
                        <a:t>-1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 DW h</a:t>
                      </a:r>
                      <a:r>
                        <a:rPr lang="en-GB" sz="1000" baseline="30000" dirty="0">
                          <a:solidFill>
                            <a:schemeClr val="tx1"/>
                          </a:solidFill>
                          <a:latin typeface="+mn-lt"/>
                        </a:rPr>
                        <a:t>-1</a:t>
                      </a: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sz="10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Samp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72h [T2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23.5h</a:t>
                      </a:r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 – T4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95.5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  <a:endParaRPr lang="en-GB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GB" sz="1000" b="1" dirty="0">
                          <a:solidFill>
                            <a:schemeClr val="tx1"/>
                          </a:solidFill>
                          <a:latin typeface="+mn-lt"/>
                        </a:rPr>
                        <a:t>169h [T10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479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 – T12</a:t>
                      </a:r>
                      <a:r>
                        <a:rPr lang="en-GB" sz="1000" b="1" baseline="-25000" dirty="0">
                          <a:solidFill>
                            <a:schemeClr val="tx1"/>
                          </a:solidFill>
                          <a:latin typeface="+mn-lt"/>
                        </a:rPr>
                        <a:t>648h</a:t>
                      </a:r>
                      <a:r>
                        <a:rPr lang="en-GB" sz="1000" b="1" baseline="0" dirty="0">
                          <a:solidFill>
                            <a:schemeClr val="tx1"/>
                          </a:solidFill>
                          <a:latin typeface="+mn-lt"/>
                        </a:rPr>
                        <a:t>]</a:t>
                      </a:r>
                      <a:endParaRPr lang="en-GB" sz="1000" b="1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Leaf litter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02 (± 0.06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22 (± 0.01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Degraded leaves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.05 (± 0.04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32 (± 0.09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Organic Soi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96 (± 0.06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66 (± 0.18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25160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Mineral soil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.30 (± 0.12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0.13 (± 0.01)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05C5623-5CAC-E946-96A7-694517B3248F}"/>
              </a:ext>
            </a:extLst>
          </p:cNvPr>
          <p:cNvSpPr txBox="1"/>
          <p:nvPr/>
        </p:nvSpPr>
        <p:spPr>
          <a:xfrm>
            <a:off x="26455" y="623228"/>
            <a:ext cx="365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D47D0E0-6D34-6C43-9CFC-C46CD295E264}"/>
              </a:ext>
            </a:extLst>
          </p:cNvPr>
          <p:cNvSpPr txBox="1"/>
          <p:nvPr/>
        </p:nvSpPr>
        <p:spPr>
          <a:xfrm>
            <a:off x="3455" y="5231740"/>
            <a:ext cx="365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3DABC1C-21C7-2440-A164-FCAFDC5E4AB1}"/>
              </a:ext>
            </a:extLst>
          </p:cNvPr>
          <p:cNvSpPr txBox="1"/>
          <p:nvPr/>
        </p:nvSpPr>
        <p:spPr>
          <a:xfrm>
            <a:off x="26455" y="47704"/>
            <a:ext cx="68315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Palatino Linotype" panose="02040502050505030304" pitchFamily="18" charset="0"/>
              </a:rPr>
              <a:t>Supplementary Figure S1</a:t>
            </a:r>
            <a:r>
              <a:rPr lang="en-US" sz="1050" dirty="0">
                <a:latin typeface="Palatino Linotype" panose="02040502050505030304" pitchFamily="18" charset="0"/>
              </a:rPr>
              <a:t>.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degradation in deciduous forest soil samples during SIP incubations. S1a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concentrations in </a:t>
            </a:r>
            <a:r>
              <a:rPr lang="en-US" sz="1050" baseline="30000" dirty="0">
                <a:latin typeface="Palatino Linotype" panose="02040502050505030304" pitchFamily="18" charset="0"/>
              </a:rPr>
              <a:t>13</a:t>
            </a:r>
            <a:r>
              <a:rPr lang="en-US" sz="1050" dirty="0">
                <a:latin typeface="Palatino Linotype" panose="02040502050505030304" pitchFamily="18" charset="0"/>
              </a:rPr>
              <a:t>C-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DNA SIP experiments. S1b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concentrations in </a:t>
            </a:r>
            <a:r>
              <a:rPr lang="en-US" sz="1050" baseline="30000" dirty="0">
                <a:latin typeface="Palatino Linotype" panose="02040502050505030304" pitchFamily="18" charset="0"/>
              </a:rPr>
              <a:t>12</a:t>
            </a:r>
            <a:r>
              <a:rPr lang="en-US" sz="1050" dirty="0">
                <a:latin typeface="Palatino Linotype" panose="02040502050505030304" pitchFamily="18" charset="0"/>
              </a:rPr>
              <a:t>C-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DNA control SIP experiments. Read arrows indicate point of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addition.</a:t>
            </a:r>
          </a:p>
          <a:p>
            <a:endParaRPr lang="en-US" sz="1050" dirty="0">
              <a:latin typeface="Palatino Linotype" panose="02040502050505030304" pitchFamily="18" charset="0"/>
            </a:endParaRP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xmlns="" id="{00000000-0008-0000-0500-00000C000000}"/>
              </a:ext>
            </a:extLst>
          </p:cNvPr>
          <p:cNvGrpSpPr/>
          <p:nvPr/>
        </p:nvGrpSpPr>
        <p:grpSpPr>
          <a:xfrm>
            <a:off x="209138" y="5244117"/>
            <a:ext cx="5878174" cy="3092859"/>
            <a:chOff x="572992" y="2012157"/>
            <a:chExt cx="6157839" cy="3240000"/>
          </a:xfrm>
        </p:grpSpPr>
        <p:graphicFrame>
          <p:nvGraphicFramePr>
            <p:cNvPr id="19" name="Chart 18">
              <a:extLst>
                <a:ext uri="{FF2B5EF4-FFF2-40B4-BE49-F238E27FC236}">
                  <a16:creationId xmlns:a16="http://schemas.microsoft.com/office/drawing/2014/main" xmlns="" id="{00000000-0008-0000-0500-00000800000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68732755"/>
                </p:ext>
              </p:extLst>
            </p:nvPr>
          </p:nvGraphicFramePr>
          <p:xfrm>
            <a:off x="572992" y="2012157"/>
            <a:ext cx="6157839" cy="3240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xmlns="" id="{00000000-0008-0000-0500-000009000000}"/>
                </a:ext>
              </a:extLst>
            </p:cNvPr>
            <p:cNvCxnSpPr>
              <a:cxnSpLocks/>
            </p:cNvCxnSpPr>
            <p:nvPr/>
          </p:nvCxnSpPr>
          <p:spPr>
            <a:xfrm>
              <a:off x="1381292" y="2174716"/>
              <a:ext cx="0" cy="312032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xmlns="" id="{00000000-0008-0000-0500-00000A000000}"/>
                </a:ext>
              </a:extLst>
            </p:cNvPr>
            <p:cNvCxnSpPr>
              <a:cxnSpLocks/>
            </p:cNvCxnSpPr>
            <p:nvPr/>
          </p:nvCxnSpPr>
          <p:spPr>
            <a:xfrm>
              <a:off x="2739102" y="2030526"/>
              <a:ext cx="0" cy="312016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xmlns="" id="{00000000-0008-0000-0500-00000B000000}"/>
                </a:ext>
              </a:extLst>
            </p:cNvPr>
            <p:cNvCxnSpPr/>
            <p:nvPr/>
          </p:nvCxnSpPr>
          <p:spPr>
            <a:xfrm>
              <a:off x="4096913" y="3257215"/>
              <a:ext cx="0" cy="312016"/>
            </a:xfrm>
            <a:prstGeom prst="straightConnector1">
              <a:avLst/>
            </a:prstGeom>
            <a:ln w="15875">
              <a:solidFill>
                <a:srgbClr val="C0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3837376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05C5623-5CAC-E946-96A7-694517B3248F}"/>
              </a:ext>
            </a:extLst>
          </p:cNvPr>
          <p:cNvSpPr txBox="1"/>
          <p:nvPr/>
        </p:nvSpPr>
        <p:spPr>
          <a:xfrm>
            <a:off x="28534" y="807894"/>
            <a:ext cx="365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3D47D0E0-6D34-6C43-9CFC-C46CD295E264}"/>
              </a:ext>
            </a:extLst>
          </p:cNvPr>
          <p:cNvSpPr txBox="1"/>
          <p:nvPr/>
        </p:nvSpPr>
        <p:spPr>
          <a:xfrm>
            <a:off x="26455" y="4583213"/>
            <a:ext cx="365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33DABC1C-21C7-2440-A164-FCAFDC5E4AB1}"/>
              </a:ext>
            </a:extLst>
          </p:cNvPr>
          <p:cNvSpPr txBox="1"/>
          <p:nvPr/>
        </p:nvSpPr>
        <p:spPr>
          <a:xfrm>
            <a:off x="26455" y="47704"/>
            <a:ext cx="68315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Palatino Linotype" panose="02040502050505030304" pitchFamily="18" charset="0"/>
              </a:rPr>
              <a:t>Supplementary Figure S2</a:t>
            </a:r>
            <a:r>
              <a:rPr lang="en-US" sz="1050" dirty="0">
                <a:latin typeface="Palatino Linotype" panose="02040502050505030304" pitchFamily="18" charset="0"/>
              </a:rPr>
              <a:t>.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degradation in control deciduous forest soil samples during SIP incubations. S2a CH</a:t>
            </a:r>
            <a:r>
              <a:rPr lang="en-US" sz="1050" baseline="-25000" dirty="0">
                <a:latin typeface="Palatino Linotype" panose="02040502050505030304" pitchFamily="18" charset="0"/>
              </a:rPr>
              <a:t>3</a:t>
            </a:r>
            <a:r>
              <a:rPr lang="en-US" sz="1050" dirty="0">
                <a:latin typeface="Palatino Linotype" panose="02040502050505030304" pitchFamily="18" charset="0"/>
              </a:rPr>
              <a:t>Cl control incubations with potassium cyanide (20 mM) were set up to determine non-microbial chloromethane dissipation. S2b No substrate-added control incubations were set up to determine intrinsic chloromethane formation.</a:t>
            </a:r>
          </a:p>
        </p:txBody>
      </p:sp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xmlns="" id="{00000000-0008-0000-0500-00000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7966287"/>
              </p:ext>
            </p:extLst>
          </p:nvPr>
        </p:nvGraphicFramePr>
        <p:xfrm>
          <a:off x="85033" y="992560"/>
          <a:ext cx="67931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xmlns="" id="{00000000-0008-0000-0500-00000E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691405"/>
              </p:ext>
            </p:extLst>
          </p:nvPr>
        </p:nvGraphicFramePr>
        <p:xfrm>
          <a:off x="0" y="4949007"/>
          <a:ext cx="682485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1559952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1" name="Group 70"/>
          <p:cNvGrpSpPr/>
          <p:nvPr/>
        </p:nvGrpSpPr>
        <p:grpSpPr>
          <a:xfrm>
            <a:off x="-59440" y="258328"/>
            <a:ext cx="7020000" cy="3097290"/>
            <a:chOff x="-224290" y="833305"/>
            <a:chExt cx="7020000" cy="3097290"/>
          </a:xfrm>
        </p:grpSpPr>
        <p:grpSp>
          <p:nvGrpSpPr>
            <p:cNvPr id="4" name="Group 3"/>
            <p:cNvGrpSpPr/>
            <p:nvPr/>
          </p:nvGrpSpPr>
          <p:grpSpPr>
            <a:xfrm>
              <a:off x="-224290" y="833305"/>
              <a:ext cx="7020000" cy="3097290"/>
              <a:chOff x="106325" y="124221"/>
              <a:chExt cx="8424000" cy="3826071"/>
            </a:xfrm>
          </p:grpSpPr>
          <p:grpSp>
            <p:nvGrpSpPr>
              <p:cNvPr id="5" name="Group 4"/>
              <p:cNvGrpSpPr/>
              <p:nvPr/>
            </p:nvGrpSpPr>
            <p:grpSpPr>
              <a:xfrm>
                <a:off x="106325" y="124221"/>
                <a:ext cx="8424000" cy="3826071"/>
                <a:chOff x="159488" y="1869327"/>
                <a:chExt cx="8763878" cy="4163218"/>
              </a:xfrm>
            </p:grpSpPr>
            <p:grpSp>
              <p:nvGrpSpPr>
                <p:cNvPr id="8" name="Group 7"/>
                <p:cNvGrpSpPr/>
                <p:nvPr/>
              </p:nvGrpSpPr>
              <p:grpSpPr>
                <a:xfrm>
                  <a:off x="159488" y="1869327"/>
                  <a:ext cx="8763878" cy="4163218"/>
                  <a:chOff x="159488" y="1869327"/>
                  <a:chExt cx="8763878" cy="4163218"/>
                </a:xfrm>
              </p:grpSpPr>
              <p:grpSp>
                <p:nvGrpSpPr>
                  <p:cNvPr id="16" name="Group 15"/>
                  <p:cNvGrpSpPr/>
                  <p:nvPr/>
                </p:nvGrpSpPr>
                <p:grpSpPr>
                  <a:xfrm>
                    <a:off x="159488" y="1869327"/>
                    <a:ext cx="8763878" cy="4163218"/>
                    <a:chOff x="159488" y="1869327"/>
                    <a:chExt cx="8763878" cy="4163218"/>
                  </a:xfrm>
                </p:grpSpPr>
                <p:grpSp>
                  <p:nvGrpSpPr>
                    <p:cNvPr id="26" name="Group 25"/>
                    <p:cNvGrpSpPr/>
                    <p:nvPr/>
                  </p:nvGrpSpPr>
                  <p:grpSpPr>
                    <a:xfrm>
                      <a:off x="159488" y="1869327"/>
                      <a:ext cx="8763878" cy="4163218"/>
                      <a:chOff x="159488" y="1869327"/>
                      <a:chExt cx="8763878" cy="4163218"/>
                    </a:xfrm>
                  </p:grpSpPr>
                  <p:grpSp>
                    <p:nvGrpSpPr>
                      <p:cNvPr id="28" name="Group 27"/>
                      <p:cNvGrpSpPr/>
                      <p:nvPr/>
                    </p:nvGrpSpPr>
                    <p:grpSpPr>
                      <a:xfrm>
                        <a:off x="159488" y="1879957"/>
                        <a:ext cx="8763878" cy="4152588"/>
                        <a:chOff x="159488" y="1879957"/>
                        <a:chExt cx="8763878" cy="4152588"/>
                      </a:xfrm>
                    </p:grpSpPr>
                    <p:grpSp>
                      <p:nvGrpSpPr>
                        <p:cNvPr id="31" name="Group 30"/>
                        <p:cNvGrpSpPr/>
                        <p:nvPr/>
                      </p:nvGrpSpPr>
                      <p:grpSpPr>
                        <a:xfrm>
                          <a:off x="159488" y="1879957"/>
                          <a:ext cx="8763878" cy="4152588"/>
                          <a:chOff x="159488" y="1879957"/>
                          <a:chExt cx="8763878" cy="4152588"/>
                        </a:xfrm>
                      </p:grpSpPr>
                      <p:grpSp>
                        <p:nvGrpSpPr>
                          <p:cNvPr id="34" name="Group 33"/>
                          <p:cNvGrpSpPr/>
                          <p:nvPr/>
                        </p:nvGrpSpPr>
                        <p:grpSpPr>
                          <a:xfrm>
                            <a:off x="244549" y="1879957"/>
                            <a:ext cx="8678817" cy="4152588"/>
                            <a:chOff x="244549" y="1879957"/>
                            <a:chExt cx="8678817" cy="4152588"/>
                          </a:xfrm>
                        </p:grpSpPr>
                        <p:grpSp>
                          <p:nvGrpSpPr>
                            <p:cNvPr id="36" name="Group 35"/>
                            <p:cNvGrpSpPr/>
                            <p:nvPr/>
                          </p:nvGrpSpPr>
                          <p:grpSpPr>
                            <a:xfrm>
                              <a:off x="244549" y="1879957"/>
                              <a:ext cx="8678817" cy="4152588"/>
                              <a:chOff x="244549" y="1879957"/>
                              <a:chExt cx="8678817" cy="4152588"/>
                            </a:xfrm>
                          </p:grpSpPr>
                          <p:grpSp>
                            <p:nvGrpSpPr>
                              <p:cNvPr id="39" name="Group 38"/>
                              <p:cNvGrpSpPr/>
                              <p:nvPr/>
                            </p:nvGrpSpPr>
                            <p:grpSpPr>
                              <a:xfrm>
                                <a:off x="244549" y="1879957"/>
                                <a:ext cx="8678817" cy="4152588"/>
                                <a:chOff x="244549" y="1879957"/>
                                <a:chExt cx="8678817" cy="4152588"/>
                              </a:xfrm>
                            </p:grpSpPr>
                            <p:grpSp>
                              <p:nvGrpSpPr>
                                <p:cNvPr id="41" name="Group 40"/>
                                <p:cNvGrpSpPr/>
                                <p:nvPr/>
                              </p:nvGrpSpPr>
                              <p:grpSpPr>
                                <a:xfrm>
                                  <a:off x="244549" y="1935126"/>
                                  <a:ext cx="8678817" cy="4097419"/>
                                  <a:chOff x="244549" y="1935126"/>
                                  <a:chExt cx="8678817" cy="4097419"/>
                                </a:xfrm>
                              </p:grpSpPr>
                              <p:grpSp>
                                <p:nvGrpSpPr>
                                  <p:cNvPr id="46" name="Group 45"/>
                                  <p:cNvGrpSpPr/>
                                  <p:nvPr/>
                                </p:nvGrpSpPr>
                                <p:grpSpPr>
                                  <a:xfrm>
                                    <a:off x="244549" y="1935126"/>
                                    <a:ext cx="8678817" cy="4097419"/>
                                    <a:chOff x="244549" y="1935126"/>
                                    <a:chExt cx="8678817" cy="4097419"/>
                                  </a:xfrm>
                                </p:grpSpPr>
                                <p:grpSp>
                                  <p:nvGrpSpPr>
                                    <p:cNvPr id="51" name="Group 50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244549" y="1935126"/>
                                      <a:ext cx="8678817" cy="4097419"/>
                                      <a:chOff x="244549" y="1935126"/>
                                      <a:chExt cx="8678817" cy="4097419"/>
                                    </a:xfrm>
                                  </p:grpSpPr>
                                  <p:grpSp>
                                    <p:nvGrpSpPr>
                                      <p:cNvPr id="54" name="Group 53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244549" y="1935126"/>
                                        <a:ext cx="8625654" cy="3927793"/>
                                        <a:chOff x="244549" y="1935126"/>
                                        <a:chExt cx="8625654" cy="3927793"/>
                                      </a:xfrm>
                                    </p:grpSpPr>
                                    <p:grpSp>
                                      <p:nvGrpSpPr>
                                        <p:cNvPr id="56" name="Group 55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357259" y="2046919"/>
                                          <a:ext cx="2645500" cy="3816000"/>
                                          <a:chOff x="357259" y="2046919"/>
                                          <a:chExt cx="2645500" cy="3816000"/>
                                        </a:xfrm>
                                      </p:grpSpPr>
                                      <p:grpSp>
                                        <p:nvGrpSpPr>
                                          <p:cNvPr id="64" name="Group 63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357259" y="2046919"/>
                                            <a:ext cx="2645500" cy="3816000"/>
                                            <a:chOff x="357259" y="2046919"/>
                                            <a:chExt cx="2645500" cy="3816000"/>
                                          </a:xfrm>
                                        </p:grpSpPr>
                                        <p:pic>
                                          <p:nvPicPr>
                                            <p:cNvPr id="66" name="Picture 2"/>
                                            <p:cNvPicPr>
                                              <a:picLocks noChangeAspect="1" noChangeArrowheads="1"/>
                                            </p:cNvPicPr>
                                            <p:nvPr/>
                                          </p:nvPicPr>
                                          <p:blipFill>
                                            <a:blip r:embed="rId3">
                                              <a:extLst>
                                                <a:ext uri="{28A0092B-C50C-407E-A947-70E740481C1C}">
                                                  <a14:useLocalDpi xmlns:a14="http://schemas.microsoft.com/office/drawing/2010/main" val="0"/>
                                                </a:ext>
                                              </a:extLst>
                                            </a:blip>
                                            <a:srcRect/>
                                            <a:stretch>
                                              <a:fillRect/>
                                            </a:stretch>
                                          </p:blipFill>
                                          <p:spPr bwMode="auto">
                                            <a:xfrm>
                                              <a:off x="357259" y="2046919"/>
                                              <a:ext cx="2645500" cy="3816000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  <a:ln>
                                              <a:noFill/>
                                            </a:ln>
                                            <a:effectLst/>
                                            <a:extLst>
                                              <a:ext uri="{909E8E84-426E-40DD-AFC4-6F175D3DCCD1}">
                                                <a14:hiddenFill xmlns:a14="http://schemas.microsoft.com/office/drawing/2010/main">
                                                  <a:solidFill>
                                                    <a:schemeClr val="accent1"/>
                                                  </a:solidFill>
                                                </a14:hiddenFill>
                                              </a:ext>
                                              <a:ext uri="{91240B29-F687-4F45-9708-019B960494DF}">
                                                <a14:hiddenLine xmlns:a14="http://schemas.microsoft.com/office/drawing/2010/main" w="9525">
                                                  <a:solidFill>
                                                    <a:schemeClr val="tx1"/>
                                                  </a:solidFill>
                                                  <a:miter lim="800000"/>
                                                  <a:headEnd/>
                                                  <a:tailEnd/>
                                                </a14:hiddenLine>
                                              </a:ext>
                                              <a:ext uri="{AF507438-7753-43E0-B8FC-AC1667EBCBE1}">
                                                <a14:hiddenEffects xmlns:a14="http://schemas.microsoft.com/office/drawing/2010/main">
                                                  <a:effectLst>
                                                    <a:outerShdw dist="35921" dir="2700000" algn="ctr" rotWithShape="0">
                                                      <a:schemeClr val="bg2"/>
                                                    </a:outerShdw>
                                                  </a:effectLst>
                                                </a14:hiddenEffects>
                                              </a:ext>
                                            </a:extLst>
                                          </p:spPr>
                                        </p:pic>
                                        <p:sp>
                                          <p:nvSpPr>
                                            <p:cNvPr id="67" name="Rectangle 66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1031358" y="5550195"/>
                                              <a:ext cx="871870" cy="212652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  <a:effectLst/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3">
                                              <a:schemeClr val="accent1"/>
                                            </a:fillRef>
                                            <a:effectRef idx="2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68" name="Rectangle 67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1929809" y="5557282"/>
                                              <a:ext cx="871870" cy="212652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solidFill>
                                              <a:schemeClr val="bg1"/>
                                            </a:solidFill>
                                            <a:ln>
                                              <a:noFill/>
                                            </a:ln>
                                            <a:effectLst/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3">
                                              <a:schemeClr val="accent1"/>
                                            </a:fillRef>
                                            <a:effectRef idx="2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65" name="TextBox 64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031357" y="5459705"/>
                                            <a:ext cx="1770321" cy="351643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1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Heavy fraction (4)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59" name="Group 58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3250422" y="2046919"/>
                                          <a:ext cx="2695830" cy="3816000"/>
                                          <a:chOff x="3250422" y="2046919"/>
                                          <a:chExt cx="2695830" cy="3816000"/>
                                        </a:xfrm>
                                      </p:grpSpPr>
                                      <p:pic>
                                        <p:nvPicPr>
                                          <p:cNvPr id="62" name="Picture 3"/>
                                          <p:cNvPicPr>
                                            <a:picLocks noChangeAspect="1" noChangeArrowheads="1"/>
                                          </p:cNvPicPr>
                                          <p:nvPr/>
                                        </p:nvPicPr>
                                        <p:blipFill>
                                          <a:blip r:embed="rId4">
                                            <a:extLst>
                                              <a:ext uri="{28A0092B-C50C-407E-A947-70E740481C1C}">
                                                <a14:useLocalDpi xmlns:a14="http://schemas.microsoft.com/office/drawing/2010/main" val="0"/>
                                              </a:ext>
                                            </a:extLst>
                                          </a:blip>
                                          <a:srcRect/>
                                          <a:stretch>
                                            <a:fillRect/>
                                          </a:stretch>
                                        </p:blipFill>
                                        <p:spPr bwMode="auto">
                                          <a:xfrm>
                                            <a:off x="3250422" y="2046919"/>
                                            <a:ext cx="2695830" cy="3816000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  <a:ln>
                                            <a:noFill/>
                                          </a:ln>
                                          <a:effectLst/>
                                          <a:extLst>
                                            <a:ext uri="{909E8E84-426E-40DD-AFC4-6F175D3DCCD1}">
                                              <a14:hiddenFill xmlns:a14="http://schemas.microsoft.com/office/drawing/2010/main">
                                                <a:solidFill>
                                                  <a:schemeClr val="accent1"/>
                                                </a:solidFill>
                                              </a14:hiddenFill>
                                            </a:ext>
                                            <a:ext uri="{91240B29-F687-4F45-9708-019B960494DF}">
                                              <a14:hiddenLine xmlns:a14="http://schemas.microsoft.com/office/drawing/2010/main" w="9525">
                                                <a:solidFill>
                                                  <a:schemeClr val="tx1"/>
                                                </a:solidFill>
                                                <a:miter lim="800000"/>
                                                <a:headEnd/>
                                                <a:tailEnd/>
                                              </a14:hiddenLine>
                                            </a:ext>
                                            <a:ext uri="{AF507438-7753-43E0-B8FC-AC1667EBCBE1}">
                                              <a14:hiddenEffects xmlns:a14="http://schemas.microsoft.com/office/drawing/2010/main">
                                                <a:effectLst>
                                                  <a:outerShdw dist="35921" dir="2700000" algn="ctr" rotWithShape="0">
                                                    <a:schemeClr val="bg2"/>
                                                  </a:outerShdw>
                                                </a:effectLst>
                                              </a14:hiddenEffects>
                                            </a:ext>
                                          </a:extLst>
                                        </p:spPr>
                                      </p:pic>
                                      <p:sp>
                                        <p:nvSpPr>
                                          <p:cNvPr id="63" name="Rectangle 62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3753293" y="5422603"/>
                                            <a:ext cx="2062716" cy="34733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solidFill>
                                            <a:schemeClr val="bg1"/>
                                          </a:solidFill>
                                          <a:ln>
                                            <a:noFill/>
                                          </a:ln>
                                          <a:effectLst/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3">
                                            <a:schemeClr val="accent1"/>
                                          </a:fillRef>
                                          <a:effectRef idx="2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</p:grpSp>
                                    <p:sp>
                                      <p:nvSpPr>
                                        <p:cNvPr id="58" name="Rectangle 57"/>
                                        <p:cNvSpPr/>
                                        <p:nvPr/>
                                      </p:nvSpPr>
                                      <p:spPr>
                                        <a:xfrm>
                                          <a:off x="244549" y="1935126"/>
                                          <a:ext cx="8625654" cy="191386"/>
                                        </a:xfrm>
                                        <a:prstGeom prst="rect">
                                          <a:avLst/>
                                        </a:prstGeom>
                                        <a:solidFill>
                                          <a:schemeClr val="bg1"/>
                                        </a:solidFill>
                                        <a:ln>
                                          <a:noFill/>
                                        </a:ln>
                                        <a:effectLst/>
                                      </p:spPr>
                                      <p:style>
                                        <a:lnRef idx="1">
                                          <a:schemeClr val="accent1"/>
                                        </a:lnRef>
                                        <a:fillRef idx="3">
                                          <a:schemeClr val="accent1"/>
                                        </a:fillRef>
                                        <a:effectRef idx="2">
                                          <a:schemeClr val="accent1"/>
                                        </a:effectRef>
                                        <a:fontRef idx="minor">
                                          <a:schemeClr val="lt1"/>
                                        </a:fontRef>
                                      </p:style>
                                      <p:txBody>
                                        <a:bodyPr rtlCol="0" anchor="ctr"/>
                                        <a:lstStyle/>
                                        <a:p>
                                          <a:pPr algn="ctr"/>
                                          <a:endParaRPr lang="en-GB"/>
                                        </a:p>
                                      </p:txBody>
                                    </p:sp>
                                  </p:grpSp>
                                  <p:sp>
                                    <p:nvSpPr>
                                      <p:cNvPr id="55" name="Rectangle 54"/>
                                      <p:cNvSpPr/>
                                      <p:nvPr/>
                                    </p:nvSpPr>
                                    <p:spPr>
                                      <a:xfrm>
                                        <a:off x="297712" y="5841159"/>
                                        <a:ext cx="8625654" cy="191386"/>
                                      </a:xfrm>
                                      <a:prstGeom prst="rect">
                                        <a:avLst/>
                                      </a:prstGeom>
                                      <a:solidFill>
                                        <a:schemeClr val="bg1"/>
                                      </a:solidFill>
                                      <a:ln>
                                        <a:noFill/>
                                      </a:ln>
                                      <a:effectLst/>
                                    </p:spPr>
                                    <p:style>
                                      <a:lnRef idx="1">
                                        <a:schemeClr val="accent1"/>
                                      </a:lnRef>
                                      <a:fillRef idx="3">
                                        <a:schemeClr val="accent1"/>
                                      </a:fillRef>
                                      <a:effectRef idx="2">
                                        <a:schemeClr val="accent1"/>
                                      </a:effectRef>
                                      <a:fontRef idx="minor">
                                        <a:schemeClr val="lt1"/>
                                      </a:fontRef>
                                    </p:style>
                                    <p:txBody>
                                      <a:bodyPr rtlCol="0" anchor="ctr"/>
                                      <a:lstStyle/>
                                      <a:p>
                                        <a:pPr algn="ctr"/>
                                        <a:endParaRPr lang="en-GB"/>
                                      </a:p>
                                    </p:txBody>
                                  </p:sp>
                                </p:grpSp>
                                <p:sp>
                                  <p:nvSpPr>
                                    <p:cNvPr id="52" name="Rectangle 51"/>
                                    <p:cNvSpPr/>
                                    <p:nvPr/>
                                  </p:nvSpPr>
                                  <p:spPr>
                                    <a:xfrm>
                                      <a:off x="365050" y="2087525"/>
                                      <a:ext cx="45719" cy="3782651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noFill/>
                                    </a:ln>
                                    <a:effectLst/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3">
                                      <a:schemeClr val="accent1"/>
                                    </a:fillRef>
                                    <a:effectRef idx="2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pPr algn="ctr"/>
                                      <a:endParaRPr lang="en-GB"/>
                                    </a:p>
                                  </p:txBody>
                                </p:sp>
                                <p:sp>
                                  <p:nvSpPr>
                                    <p:cNvPr id="53" name="Rectangle 52"/>
                                    <p:cNvSpPr/>
                                    <p:nvPr/>
                                  </p:nvSpPr>
                                  <p:spPr>
                                    <a:xfrm>
                                      <a:off x="2967316" y="2080268"/>
                                      <a:ext cx="45719" cy="3782651"/>
                                    </a:xfrm>
                                    <a:prstGeom prst="rect">
                                      <a:avLst/>
                                    </a:prstGeom>
                                    <a:solidFill>
                                      <a:schemeClr val="bg1"/>
                                    </a:solidFill>
                                    <a:ln>
                                      <a:noFill/>
                                    </a:ln>
                                    <a:effectLst/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3">
                                      <a:schemeClr val="accent1"/>
                                    </a:fillRef>
                                    <a:effectRef idx="2">
                                      <a:schemeClr val="accent1"/>
                                    </a:effectRef>
                                    <a:fontRef idx="minor">
                                      <a:schemeClr val="lt1"/>
                                    </a:fontRef>
                                  </p:style>
                                  <p:txBody>
                                    <a:bodyPr rtlCol="0" anchor="ctr"/>
                                    <a:lstStyle/>
                                    <a:p>
                                      <a:pPr algn="ctr"/>
                                      <a:endParaRPr lang="en-GB"/>
                                    </a:p>
                                  </p:txBody>
                                </p:sp>
                              </p:grpSp>
                              <p:sp>
                                <p:nvSpPr>
                                  <p:cNvPr id="47" name="Rectangle 46"/>
                                  <p:cNvSpPr/>
                                  <p:nvPr/>
                                </p:nvSpPr>
                                <p:spPr>
                                  <a:xfrm>
                                    <a:off x="3237837" y="2080268"/>
                                    <a:ext cx="45719" cy="3782651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  <a:effectLst/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3">
                                    <a:schemeClr val="accent1"/>
                                  </a:fillRef>
                                  <a:effectRef idx="2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GB"/>
                                  </a:p>
                                </p:txBody>
                              </p:sp>
                              <p:sp>
                                <p:nvSpPr>
                                  <p:cNvPr id="48" name="Rectangle 47"/>
                                  <p:cNvSpPr/>
                                  <p:nvPr/>
                                </p:nvSpPr>
                                <p:spPr>
                                  <a:xfrm>
                                    <a:off x="5911166" y="2083980"/>
                                    <a:ext cx="45719" cy="3782651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  <a:effectLst/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3">
                                    <a:schemeClr val="accent1"/>
                                  </a:fillRef>
                                  <a:effectRef idx="2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GB"/>
                                  </a:p>
                                </p:txBody>
                              </p:sp>
                              <p:sp>
                                <p:nvSpPr>
                                  <p:cNvPr id="49" name="Rectangle 48"/>
                                  <p:cNvSpPr/>
                                  <p:nvPr/>
                                </p:nvSpPr>
                                <p:spPr>
                                  <a:xfrm>
                                    <a:off x="6151515" y="2087526"/>
                                    <a:ext cx="45719" cy="3782651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  <a:effectLst/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3">
                                    <a:schemeClr val="accent1"/>
                                  </a:fillRef>
                                  <a:effectRef idx="2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GB"/>
                                  </a:p>
                                </p:txBody>
                              </p:sp>
                              <p:sp>
                                <p:nvSpPr>
                                  <p:cNvPr id="50" name="Rectangle 49"/>
                                  <p:cNvSpPr/>
                                  <p:nvPr/>
                                </p:nvSpPr>
                                <p:spPr>
                                  <a:xfrm>
                                    <a:off x="8847343" y="2080268"/>
                                    <a:ext cx="45719" cy="3782651"/>
                                  </a:xfrm>
                                  <a:prstGeom prst="rect">
                                    <a:avLst/>
                                  </a:prstGeom>
                                  <a:solidFill>
                                    <a:schemeClr val="bg1"/>
                                  </a:solidFill>
                                  <a:ln>
                                    <a:noFill/>
                                  </a:ln>
                                  <a:effectLst/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3">
                                    <a:schemeClr val="accent1"/>
                                  </a:fillRef>
                                  <a:effectRef idx="2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GB"/>
                                  </a:p>
                                </p:txBody>
                              </p:sp>
                            </p:grpSp>
                            <p:sp>
                              <p:nvSpPr>
                                <p:cNvPr id="42" name="TextBox 41"/>
                                <p:cNvSpPr txBox="1"/>
                                <p:nvPr/>
                              </p:nvSpPr>
                              <p:spPr>
                                <a:xfrm>
                                  <a:off x="1147348" y="1938167"/>
                                  <a:ext cx="618622" cy="330958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b="1" baseline="30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12</a:t>
                                  </a:r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3" name="TextBox 42"/>
                                <p:cNvSpPr txBox="1"/>
                                <p:nvPr/>
                              </p:nvSpPr>
                              <p:spPr>
                                <a:xfrm>
                                  <a:off x="2045799" y="1938159"/>
                                  <a:ext cx="618622" cy="330958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b="1" baseline="30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13</a:t>
                                  </a:r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4" name="TextBox 43"/>
                                <p:cNvSpPr txBox="1"/>
                                <p:nvPr/>
                              </p:nvSpPr>
                              <p:spPr>
                                <a:xfrm>
                                  <a:off x="3776734" y="1879958"/>
                                  <a:ext cx="468799" cy="330958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b="1" baseline="30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12</a:t>
                                  </a:r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45" name="TextBox 44"/>
                                <p:cNvSpPr txBox="1"/>
                                <p:nvPr/>
                              </p:nvSpPr>
                              <p:spPr>
                                <a:xfrm>
                                  <a:off x="4322977" y="1879957"/>
                                  <a:ext cx="468799" cy="330958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b="1" baseline="30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13</a:t>
                                  </a:r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C</a:t>
                                  </a:r>
                                </a:p>
                              </p:txBody>
                            </p:sp>
                          </p:grpSp>
                          <p:sp>
                            <p:nvSpPr>
                              <p:cNvPr id="40" name="Rectangle 39"/>
                              <p:cNvSpPr/>
                              <p:nvPr/>
                            </p:nvSpPr>
                            <p:spPr>
                              <a:xfrm>
                                <a:off x="6677247" y="5422603"/>
                                <a:ext cx="2170096" cy="447574"/>
                              </a:xfrm>
                              <a:prstGeom prst="rect">
                                <a:avLst/>
                              </a:prstGeom>
                              <a:solidFill>
                                <a:schemeClr val="bg1"/>
                              </a:solidFill>
                              <a:ln>
                                <a:noFill/>
                              </a:ln>
                              <a:effectLst/>
                            </p:spPr>
                            <p:style>
                              <a:lnRef idx="1">
                                <a:schemeClr val="accent1"/>
                              </a:lnRef>
                              <a:fillRef idx="3">
                                <a:schemeClr val="accent1"/>
                              </a:fillRef>
                              <a:effectRef idx="2">
                                <a:schemeClr val="accent1"/>
                              </a:effectRef>
                              <a:fontRef idx="minor">
                                <a:schemeClr val="lt1"/>
                              </a:fontRef>
                            </p:style>
                            <p:txBody>
                              <a:bodyPr rtlCol="0" anchor="ctr"/>
                              <a:lstStyle/>
                              <a:p>
                                <a:pPr algn="ctr"/>
                                <a:endParaRPr lang="en-GB"/>
                              </a:p>
                            </p:txBody>
                          </p:sp>
                        </p:grpSp>
                        <p:pic>
                          <p:nvPicPr>
                            <p:cNvPr id="37" name="Picture 6"/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5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6184771" y="2046919"/>
                              <a:ext cx="2585687" cy="3672000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  <a:effectLst/>
                            <a:extLst>
                              <a:ext uri="{909E8E84-426E-40DD-AFC4-6F175D3DCCD1}">
                                <a14:hiddenFill xmlns:a14="http://schemas.microsoft.com/office/drawing/2010/main">
                                  <a:solidFill>
                                    <a:schemeClr val="accent1"/>
                                  </a:solidFill>
                                </a14:hiddenFill>
                              </a:ext>
                              <a:ext uri="{91240B29-F687-4F45-9708-019B960494DF}">
                                <a14:hiddenLine xmlns:a14="http://schemas.microsoft.com/office/drawing/2010/main" w="9525">
                                  <a:solidFill>
                                    <a:schemeClr val="tx1"/>
                                  </a:solidFill>
                                  <a:miter lim="800000"/>
                                  <a:headEnd/>
                                  <a:tailEnd/>
                                </a14:hiddenLine>
                              </a:ext>
                              <a:ext uri="{AF507438-7753-43E0-B8FC-AC1667EBCBE1}">
                                <a14:hiddenEffects xmlns:a14="http://schemas.microsoft.com/office/drawing/2010/main">
                                  <a:effectLst>
                                    <a:outerShdw dist="35921" dir="2700000" algn="ctr" rotWithShape="0">
                                      <a:schemeClr val="bg2"/>
                                    </a:outerShdw>
                                  </a:effectLst>
                                </a14:hiddenEffects>
                              </a:ext>
                            </a:extLst>
                          </p:spPr>
                        </p:pic>
                        <p:sp>
                          <p:nvSpPr>
                            <p:cNvPr id="38" name="Rectangle 37"/>
                            <p:cNvSpPr/>
                            <p:nvPr/>
                          </p:nvSpPr>
                          <p:spPr>
                            <a:xfrm>
                              <a:off x="6804837" y="5459705"/>
                              <a:ext cx="1796903" cy="303142"/>
                            </a:xfrm>
                            <a:prstGeom prst="rect">
                              <a:avLst/>
                            </a:prstGeom>
                            <a:solidFill>
                              <a:schemeClr val="bg1"/>
                            </a:solidFill>
                            <a:ln>
                              <a:noFill/>
                            </a:ln>
                            <a:effectLst/>
                          </p:spPr>
                          <p:style>
                            <a:lnRef idx="1">
                              <a:schemeClr val="accent1"/>
                            </a:lnRef>
                            <a:fillRef idx="3">
                              <a:schemeClr val="accent1"/>
                            </a:fillRef>
                            <a:effectRef idx="2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</p:grpSp>
                      <p:sp>
                        <p:nvSpPr>
                          <p:cNvPr id="35" name="Rectangle 34"/>
                          <p:cNvSpPr/>
                          <p:nvPr/>
                        </p:nvSpPr>
                        <p:spPr>
                          <a:xfrm>
                            <a:off x="159488" y="1988301"/>
                            <a:ext cx="273902" cy="3977569"/>
                          </a:xfrm>
                          <a:prstGeom prst="rect">
                            <a:avLst/>
                          </a:prstGeom>
                          <a:solidFill>
                            <a:schemeClr val="bg1"/>
                          </a:solidFill>
                          <a:ln>
                            <a:noFill/>
                          </a:ln>
                          <a:effectLst/>
                        </p:spPr>
                        <p:style>
                          <a:lnRef idx="1">
                            <a:schemeClr val="accent1"/>
                          </a:lnRef>
                          <a:fillRef idx="3">
                            <a:schemeClr val="accent1"/>
                          </a:fillRef>
                          <a:effectRef idx="2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</p:grpSp>
                    <p:sp>
                      <p:nvSpPr>
                        <p:cNvPr id="32" name="TextBox 31"/>
                        <p:cNvSpPr txBox="1"/>
                        <p:nvPr/>
                      </p:nvSpPr>
                      <p:spPr>
                        <a:xfrm>
                          <a:off x="4786826" y="1894575"/>
                          <a:ext cx="468799" cy="33095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000" b="1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2</a:t>
                          </a:r>
                          <a:r>
                            <a:rPr lang="en-GB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</a:t>
                          </a:r>
                        </a:p>
                      </p:txBody>
                    </p:sp>
                    <p:sp>
                      <p:nvSpPr>
                        <p:cNvPr id="33" name="TextBox 32"/>
                        <p:cNvSpPr txBox="1"/>
                        <p:nvPr/>
                      </p:nvSpPr>
                      <p:spPr>
                        <a:xfrm>
                          <a:off x="5333069" y="1894575"/>
                          <a:ext cx="468799" cy="33095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000" b="1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3</a:t>
                          </a:r>
                          <a:r>
                            <a:rPr lang="en-GB" sz="1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</a:t>
                          </a:r>
                        </a:p>
                      </p:txBody>
                    </p:sp>
                  </p:grpSp>
                  <p:sp>
                    <p:nvSpPr>
                      <p:cNvPr id="29" name="TextBox 28"/>
                      <p:cNvSpPr txBox="1"/>
                      <p:nvPr/>
                    </p:nvSpPr>
                    <p:spPr>
                      <a:xfrm>
                        <a:off x="6852243" y="1869336"/>
                        <a:ext cx="618622" cy="33095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2</a:t>
                        </a:r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</a:p>
                    </p:txBody>
                  </p:sp>
                  <p:sp>
                    <p:nvSpPr>
                      <p:cNvPr id="30" name="TextBox 29"/>
                      <p:cNvSpPr txBox="1"/>
                      <p:nvPr/>
                    </p:nvSpPr>
                    <p:spPr>
                      <a:xfrm>
                        <a:off x="7793225" y="1869327"/>
                        <a:ext cx="618622" cy="33095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GB" sz="1000" b="1" baseline="30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3</a:t>
                        </a:r>
                        <a:r>
                          <a:rPr lang="en-GB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C</a:t>
                        </a:r>
                      </a:p>
                    </p:txBody>
                  </p:sp>
                </p:grpSp>
                <p:sp>
                  <p:nvSpPr>
                    <p:cNvPr id="27" name="TextBox 26"/>
                    <p:cNvSpPr txBox="1"/>
                    <p:nvPr/>
                  </p:nvSpPr>
                  <p:spPr>
                    <a:xfrm>
                      <a:off x="6677249" y="5465464"/>
                      <a:ext cx="1935652" cy="35164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vy fraction (6)</a:t>
                      </a:r>
                    </a:p>
                  </p:txBody>
                </p:sp>
              </p:grpSp>
              <p:sp>
                <p:nvSpPr>
                  <p:cNvPr id="17" name="TextBox 16"/>
                  <p:cNvSpPr txBox="1"/>
                  <p:nvPr/>
                </p:nvSpPr>
                <p:spPr>
                  <a:xfrm>
                    <a:off x="2014868" y="2237867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80</a:t>
                    </a:r>
                  </a:p>
                </p:txBody>
              </p:sp>
              <p:sp>
                <p:nvSpPr>
                  <p:cNvPr id="18" name="TextBox 17"/>
                  <p:cNvSpPr txBox="1"/>
                  <p:nvPr/>
                </p:nvSpPr>
                <p:spPr>
                  <a:xfrm>
                    <a:off x="2014867" y="2471397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78</a:t>
                    </a:r>
                  </a:p>
                </p:txBody>
              </p:sp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2025501" y="2662009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5</a:t>
                    </a:r>
                  </a:p>
                </p:txBody>
              </p:sp>
              <p:sp>
                <p:nvSpPr>
                  <p:cNvPr id="20" name="TextBox 19"/>
                  <p:cNvSpPr txBox="1"/>
                  <p:nvPr/>
                </p:nvSpPr>
                <p:spPr>
                  <a:xfrm>
                    <a:off x="2014866" y="2934299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3</a:t>
                    </a:r>
                  </a:p>
                </p:txBody>
              </p:sp>
              <p:sp>
                <p:nvSpPr>
                  <p:cNvPr id="21" name="TextBox 20"/>
                  <p:cNvSpPr txBox="1"/>
                  <p:nvPr/>
                </p:nvSpPr>
                <p:spPr>
                  <a:xfrm>
                    <a:off x="2014868" y="3297287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2</a:t>
                    </a:r>
                  </a:p>
                </p:txBody>
              </p:sp>
              <p:sp>
                <p:nvSpPr>
                  <p:cNvPr id="22" name="TextBox 21"/>
                  <p:cNvSpPr txBox="1"/>
                  <p:nvPr/>
                </p:nvSpPr>
                <p:spPr>
                  <a:xfrm>
                    <a:off x="2014865" y="3738542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1</a:t>
                    </a:r>
                  </a:p>
                </p:txBody>
              </p:sp>
              <p:sp>
                <p:nvSpPr>
                  <p:cNvPr id="23" name="TextBox 22"/>
                  <p:cNvSpPr txBox="1"/>
                  <p:nvPr/>
                </p:nvSpPr>
                <p:spPr>
                  <a:xfrm>
                    <a:off x="4215806" y="2789923"/>
                    <a:ext cx="805418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3</a:t>
                    </a:r>
                  </a:p>
                </p:txBody>
              </p:sp>
              <p:sp>
                <p:nvSpPr>
                  <p:cNvPr id="24" name="TextBox 23"/>
                  <p:cNvSpPr txBox="1"/>
                  <p:nvPr/>
                </p:nvSpPr>
                <p:spPr>
                  <a:xfrm>
                    <a:off x="4233375" y="3067757"/>
                    <a:ext cx="648000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86</a:t>
                    </a:r>
                  </a:p>
                </p:txBody>
              </p:sp>
              <p:sp>
                <p:nvSpPr>
                  <p:cNvPr id="25" name="TextBox 24"/>
                  <p:cNvSpPr txBox="1"/>
                  <p:nvPr/>
                </p:nvSpPr>
                <p:spPr>
                  <a:xfrm>
                    <a:off x="5228551" y="2172966"/>
                    <a:ext cx="680485" cy="26890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342</a:t>
                    </a:r>
                  </a:p>
                </p:txBody>
              </p:sp>
            </p:grpSp>
            <p:sp>
              <p:nvSpPr>
                <p:cNvPr id="9" name="TextBox 8"/>
                <p:cNvSpPr txBox="1"/>
                <p:nvPr/>
              </p:nvSpPr>
              <p:spPr>
                <a:xfrm>
                  <a:off x="5227224" y="2579058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106</a:t>
                  </a: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7837072" y="2131556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355</a:t>
                  </a:r>
                </a:p>
              </p:txBody>
            </p:sp>
            <p:sp>
              <p:nvSpPr>
                <p:cNvPr id="11" name="TextBox 10"/>
                <p:cNvSpPr txBox="1"/>
                <p:nvPr/>
              </p:nvSpPr>
              <p:spPr>
                <a:xfrm>
                  <a:off x="7837071" y="2348286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354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7848230" y="2564967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339</a:t>
                  </a:r>
                </a:p>
              </p:txBody>
            </p:sp>
            <p:sp>
              <p:nvSpPr>
                <p:cNvPr id="13" name="TextBox 12"/>
                <p:cNvSpPr txBox="1"/>
                <p:nvPr/>
              </p:nvSpPr>
              <p:spPr>
                <a:xfrm>
                  <a:off x="7848230" y="2831343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207</a:t>
                  </a:r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7837070" y="3486530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8</a:t>
                  </a: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7837070" y="5124380"/>
                  <a:ext cx="680485" cy="26890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51</a:t>
                  </a:r>
                </a:p>
              </p:txBody>
            </p:sp>
          </p:grpSp>
          <p:sp>
            <p:nvSpPr>
              <p:cNvPr id="6" name="Rectangle 5"/>
              <p:cNvSpPr/>
              <p:nvPr/>
            </p:nvSpPr>
            <p:spPr>
              <a:xfrm>
                <a:off x="237965" y="311721"/>
                <a:ext cx="589619" cy="335783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pic>
            <p:nvPicPr>
              <p:cNvPr id="7" name="Picture 3"/>
              <p:cNvPicPr>
                <a:picLocks noChangeAspect="1" noChangeArrowheads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0" t="1624" r="82628" b="3310"/>
              <a:stretch/>
            </p:blipFill>
            <p:spPr bwMode="auto">
              <a:xfrm>
                <a:off x="480767" y="360577"/>
                <a:ext cx="365671" cy="33955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9" name="TextBox 68"/>
            <p:cNvSpPr txBox="1"/>
            <p:nvPr/>
          </p:nvSpPr>
          <p:spPr>
            <a:xfrm>
              <a:off x="2633541" y="3468386"/>
              <a:ext cx="87613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Heavy fraction (4)</a:t>
              </a: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433101" y="3465922"/>
              <a:ext cx="95601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dirty="0">
                  <a:latin typeface="Arial" panose="020B0604020202020204" pitchFamily="34" charset="0"/>
                  <a:cs typeface="Arial" panose="020B0604020202020204" pitchFamily="34" charset="0"/>
                </a:rPr>
                <a:t>Heavy fraction (5)</a:t>
              </a:r>
            </a:p>
          </p:txBody>
        </p:sp>
      </p:grpSp>
      <p:sp>
        <p:nvSpPr>
          <p:cNvPr id="72" name="TextBox 71"/>
          <p:cNvSpPr txBox="1"/>
          <p:nvPr/>
        </p:nvSpPr>
        <p:spPr>
          <a:xfrm>
            <a:off x="182478" y="147928"/>
            <a:ext cx="1476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Mineral soil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-26388" y="-591616"/>
            <a:ext cx="70557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Palatino Linotype" panose="02040502050505030304" pitchFamily="18" charset="0"/>
              </a:rPr>
              <a:t>Supplementary Figure S3: Relative distribution of TRFs detected by bacterial T-RFLP of fractionated DNA from [</a:t>
            </a:r>
            <a:r>
              <a:rPr lang="en-GB" sz="1050" b="1" baseline="30000" dirty="0">
                <a:latin typeface="Palatino Linotype" panose="02040502050505030304" pitchFamily="18" charset="0"/>
              </a:rPr>
              <a:t>13</a:t>
            </a:r>
            <a:r>
              <a:rPr lang="en-GB" sz="1050" b="1" dirty="0">
                <a:latin typeface="Palatino Linotype" panose="02040502050505030304" pitchFamily="18" charset="0"/>
              </a:rPr>
              <a:t>C]-CH</a:t>
            </a:r>
            <a:r>
              <a:rPr lang="en-GB" sz="1050" b="1" baseline="-25000" dirty="0">
                <a:latin typeface="Palatino Linotype" panose="02040502050505030304" pitchFamily="18" charset="0"/>
              </a:rPr>
              <a:t>3</a:t>
            </a:r>
            <a:r>
              <a:rPr lang="en-GB" sz="1050" b="1" dirty="0">
                <a:latin typeface="Palatino Linotype" panose="02040502050505030304" pitchFamily="18" charset="0"/>
              </a:rPr>
              <a:t>Cl and [</a:t>
            </a:r>
            <a:r>
              <a:rPr lang="en-GB" sz="1050" b="1" baseline="30000" dirty="0">
                <a:latin typeface="Palatino Linotype" panose="02040502050505030304" pitchFamily="18" charset="0"/>
              </a:rPr>
              <a:t>12</a:t>
            </a:r>
            <a:r>
              <a:rPr lang="en-GB" sz="1050" b="1" dirty="0">
                <a:latin typeface="Palatino Linotype" panose="02040502050505030304" pitchFamily="18" charset="0"/>
              </a:rPr>
              <a:t>C]-CH</a:t>
            </a:r>
            <a:r>
              <a:rPr lang="en-GB" sz="1050" b="1" baseline="-25000" dirty="0">
                <a:latin typeface="Palatino Linotype" panose="02040502050505030304" pitchFamily="18" charset="0"/>
              </a:rPr>
              <a:t>3</a:t>
            </a:r>
            <a:r>
              <a:rPr lang="en-GB" sz="1050" b="1" dirty="0">
                <a:latin typeface="Palatino Linotype" panose="02040502050505030304" pitchFamily="18" charset="0"/>
              </a:rPr>
              <a:t>Cl SIP incubations of mineral and organic soil samples and degraded leave samples from </a:t>
            </a:r>
            <a:r>
              <a:rPr lang="en-GB" sz="1050" b="1" dirty="0" err="1">
                <a:latin typeface="Palatino Linotype" panose="02040502050505030304" pitchFamily="18" charset="0"/>
              </a:rPr>
              <a:t>Steigerwald</a:t>
            </a:r>
            <a:r>
              <a:rPr lang="en-GB" sz="1050" b="1" dirty="0">
                <a:latin typeface="Palatino Linotype" panose="02040502050505030304" pitchFamily="18" charset="0"/>
              </a:rPr>
              <a:t> after incorporation of 100 </a:t>
            </a:r>
            <a:r>
              <a:rPr lang="en-GB" sz="1050" b="1" dirty="0" err="1">
                <a:latin typeface="Palatino Linotype" panose="02040502050505030304" pitchFamily="18" charset="0"/>
              </a:rPr>
              <a:t>μmol</a:t>
            </a:r>
            <a:r>
              <a:rPr lang="en-GB" sz="1050" b="1" dirty="0">
                <a:latin typeface="Palatino Linotype" panose="02040502050505030304" pitchFamily="18" charset="0"/>
              </a:rPr>
              <a:t> C g</a:t>
            </a:r>
            <a:r>
              <a:rPr lang="en-GB" sz="1050" b="1" baseline="30000" dirty="0">
                <a:latin typeface="Palatino Linotype" panose="02040502050505030304" pitchFamily="18" charset="0"/>
              </a:rPr>
              <a:t>-1</a:t>
            </a:r>
            <a:r>
              <a:rPr lang="en-GB" sz="1050" b="1" dirty="0">
                <a:latin typeface="Palatino Linotype" panose="02040502050505030304" pitchFamily="18" charset="0"/>
              </a:rPr>
              <a:t> sample. </a:t>
            </a:r>
            <a:r>
              <a:rPr lang="en-GB" sz="1050" dirty="0">
                <a:latin typeface="Palatino Linotype" panose="02040502050505030304" pitchFamily="18" charset="0"/>
              </a:rPr>
              <a:t>Each column represents relative abundance of microbial taxa (TRFs) detected in a sample. </a:t>
            </a:r>
            <a:endParaRPr lang="en-US" sz="1050" dirty="0">
              <a:latin typeface="Palatino Linotype" panose="02040502050505030304" pitchFamily="18" charset="0"/>
            </a:endParaRPr>
          </a:p>
        </p:txBody>
      </p:sp>
      <p:grpSp>
        <p:nvGrpSpPr>
          <p:cNvPr id="74" name="Group 73"/>
          <p:cNvGrpSpPr/>
          <p:nvPr/>
        </p:nvGrpSpPr>
        <p:grpSpPr>
          <a:xfrm>
            <a:off x="28664" y="3452253"/>
            <a:ext cx="6829336" cy="3115050"/>
            <a:chOff x="279648" y="1688517"/>
            <a:chExt cx="8824941" cy="4372035"/>
          </a:xfrm>
        </p:grpSpPr>
        <p:grpSp>
          <p:nvGrpSpPr>
            <p:cNvPr id="75" name="Group 74"/>
            <p:cNvGrpSpPr/>
            <p:nvPr/>
          </p:nvGrpSpPr>
          <p:grpSpPr>
            <a:xfrm>
              <a:off x="279648" y="1690006"/>
              <a:ext cx="2920724" cy="4264228"/>
              <a:chOff x="375345" y="1775070"/>
              <a:chExt cx="2920724" cy="4264228"/>
            </a:xfrm>
          </p:grpSpPr>
          <p:grpSp>
            <p:nvGrpSpPr>
              <p:cNvPr id="110" name="Group 109"/>
              <p:cNvGrpSpPr/>
              <p:nvPr/>
            </p:nvGrpSpPr>
            <p:grpSpPr>
              <a:xfrm>
                <a:off x="375345" y="1775070"/>
                <a:ext cx="2875522" cy="4264228"/>
                <a:chOff x="375345" y="1775070"/>
                <a:chExt cx="2875522" cy="4264228"/>
              </a:xfrm>
            </p:grpSpPr>
            <p:grpSp>
              <p:nvGrpSpPr>
                <p:cNvPr id="118" name="Group 117"/>
                <p:cNvGrpSpPr/>
                <p:nvPr/>
              </p:nvGrpSpPr>
              <p:grpSpPr>
                <a:xfrm>
                  <a:off x="375345" y="1775070"/>
                  <a:ext cx="2875522" cy="4264228"/>
                  <a:chOff x="545473" y="1647474"/>
                  <a:chExt cx="2875522" cy="4264228"/>
                </a:xfrm>
              </p:grpSpPr>
              <p:grpSp>
                <p:nvGrpSpPr>
                  <p:cNvPr id="124" name="Group 123"/>
                  <p:cNvGrpSpPr/>
                  <p:nvPr/>
                </p:nvGrpSpPr>
                <p:grpSpPr>
                  <a:xfrm>
                    <a:off x="545473" y="1647474"/>
                    <a:ext cx="2875522" cy="4264228"/>
                    <a:chOff x="545473" y="1647474"/>
                    <a:chExt cx="2875522" cy="4264228"/>
                  </a:xfrm>
                </p:grpSpPr>
                <p:pic>
                  <p:nvPicPr>
                    <p:cNvPr id="127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545473" y="1828099"/>
                      <a:ext cx="2875522" cy="408360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28" name="TextBox 127"/>
                    <p:cNvSpPr txBox="1"/>
                    <p:nvPr/>
                  </p:nvSpPr>
                  <p:spPr>
                    <a:xfrm>
                      <a:off x="1095155" y="1647475"/>
                      <a:ext cx="515678" cy="345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29" name="TextBox 128"/>
                    <p:cNvSpPr txBox="1"/>
                    <p:nvPr/>
                  </p:nvSpPr>
                  <p:spPr>
                    <a:xfrm>
                      <a:off x="1641398" y="1647474"/>
                      <a:ext cx="515678" cy="345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30" name="TextBox 129"/>
                    <p:cNvSpPr txBox="1"/>
                    <p:nvPr/>
                  </p:nvSpPr>
                  <p:spPr>
                    <a:xfrm>
                      <a:off x="2190309" y="1651460"/>
                      <a:ext cx="515678" cy="345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31" name="TextBox 130"/>
                    <p:cNvSpPr txBox="1"/>
                    <p:nvPr/>
                  </p:nvSpPr>
                  <p:spPr>
                    <a:xfrm>
                      <a:off x="2725920" y="1651460"/>
                      <a:ext cx="515678" cy="345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32" name="Rectangle 131"/>
                    <p:cNvSpPr/>
                    <p:nvPr/>
                  </p:nvSpPr>
                  <p:spPr>
                    <a:xfrm>
                      <a:off x="1095155" y="5465135"/>
                      <a:ext cx="2243468" cy="446567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125" name="TextBox 124"/>
                  <p:cNvSpPr txBox="1"/>
                  <p:nvPr/>
                </p:nvSpPr>
                <p:spPr>
                  <a:xfrm>
                    <a:off x="999250" y="5405543"/>
                    <a:ext cx="1137896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4)</a:t>
                    </a:r>
                  </a:p>
                </p:txBody>
              </p:sp>
              <p:sp>
                <p:nvSpPr>
                  <p:cNvPr id="126" name="TextBox 125"/>
                  <p:cNvSpPr txBox="1"/>
                  <p:nvPr/>
                </p:nvSpPr>
                <p:spPr>
                  <a:xfrm>
                    <a:off x="2190310" y="5405543"/>
                    <a:ext cx="1165590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5)</a:t>
                    </a:r>
                  </a:p>
                </p:txBody>
              </p:sp>
            </p:grpSp>
            <p:sp>
              <p:nvSpPr>
                <p:cNvPr id="119" name="TextBox 118"/>
                <p:cNvSpPr txBox="1"/>
                <p:nvPr/>
              </p:nvSpPr>
              <p:spPr>
                <a:xfrm>
                  <a:off x="1394824" y="2045786"/>
                  <a:ext cx="765316" cy="28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902</a:t>
                  </a: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1394824" y="2857404"/>
                  <a:ext cx="765316" cy="28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676</a:t>
                  </a:r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1387828" y="3965597"/>
                  <a:ext cx="727984" cy="28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356</a:t>
                  </a: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1439366" y="4660254"/>
                  <a:ext cx="680485" cy="28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5</a:t>
                  </a: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1442904" y="4770121"/>
                  <a:ext cx="680485" cy="28078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4</a:t>
                  </a:r>
                </a:p>
              </p:txBody>
            </p:sp>
          </p:grpSp>
          <p:sp>
            <p:nvSpPr>
              <p:cNvPr id="111" name="TextBox 110"/>
              <p:cNvSpPr txBox="1"/>
              <p:nvPr/>
            </p:nvSpPr>
            <p:spPr>
              <a:xfrm>
                <a:off x="2478994" y="2053808"/>
                <a:ext cx="734949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918</a:t>
                </a:r>
              </a:p>
            </p:txBody>
          </p:sp>
          <p:sp>
            <p:nvSpPr>
              <p:cNvPr id="112" name="TextBox 111"/>
              <p:cNvSpPr txBox="1"/>
              <p:nvPr/>
            </p:nvSpPr>
            <p:spPr>
              <a:xfrm>
                <a:off x="2478995" y="2179528"/>
                <a:ext cx="804767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911</a:t>
                </a: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478991" y="2611183"/>
                <a:ext cx="734951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902</a:t>
                </a: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2478995" y="3571656"/>
                <a:ext cx="804767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890</a:t>
                </a: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2480670" y="4246376"/>
                <a:ext cx="815399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880</a:t>
                </a: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2478954" y="4468231"/>
                <a:ext cx="780190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864</a:t>
                </a: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2478995" y="4783363"/>
                <a:ext cx="804767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1</a:t>
                </a:r>
              </a:p>
            </p:txBody>
          </p:sp>
        </p:grpSp>
        <p:grpSp>
          <p:nvGrpSpPr>
            <p:cNvPr id="76" name="Group 75"/>
            <p:cNvGrpSpPr/>
            <p:nvPr/>
          </p:nvGrpSpPr>
          <p:grpSpPr>
            <a:xfrm>
              <a:off x="3224989" y="1688517"/>
              <a:ext cx="3101377" cy="4264733"/>
              <a:chOff x="3384484" y="1848012"/>
              <a:chExt cx="3101377" cy="4264733"/>
            </a:xfrm>
          </p:grpSpPr>
          <p:grpSp>
            <p:nvGrpSpPr>
              <p:cNvPr id="94" name="Group 93"/>
              <p:cNvGrpSpPr/>
              <p:nvPr/>
            </p:nvGrpSpPr>
            <p:grpSpPr>
              <a:xfrm>
                <a:off x="3384484" y="1848012"/>
                <a:ext cx="3101377" cy="4264733"/>
                <a:chOff x="3384484" y="1848012"/>
                <a:chExt cx="3101377" cy="4264733"/>
              </a:xfrm>
            </p:grpSpPr>
            <p:grpSp>
              <p:nvGrpSpPr>
                <p:cNvPr id="101" name="Group 100"/>
                <p:cNvGrpSpPr/>
                <p:nvPr/>
              </p:nvGrpSpPr>
              <p:grpSpPr>
                <a:xfrm>
                  <a:off x="3384484" y="2044745"/>
                  <a:ext cx="3101377" cy="4068000"/>
                  <a:chOff x="3384484" y="2044745"/>
                  <a:chExt cx="3101377" cy="4068000"/>
                </a:xfrm>
              </p:grpSpPr>
              <p:pic>
                <p:nvPicPr>
                  <p:cNvPr id="106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384484" y="2044745"/>
                    <a:ext cx="2869620" cy="4068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107" name="Rectangle 106"/>
                  <p:cNvSpPr/>
                  <p:nvPr/>
                </p:nvSpPr>
                <p:spPr>
                  <a:xfrm>
                    <a:off x="3870251" y="5667162"/>
                    <a:ext cx="2615610" cy="44558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8" name="TextBox 107"/>
                  <p:cNvSpPr txBox="1"/>
                  <p:nvPr/>
                </p:nvSpPr>
                <p:spPr>
                  <a:xfrm>
                    <a:off x="3870251" y="5625467"/>
                    <a:ext cx="1105786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4)</a:t>
                    </a:r>
                  </a:p>
                </p:txBody>
              </p:sp>
              <p:sp>
                <p:nvSpPr>
                  <p:cNvPr id="109" name="TextBox 108"/>
                  <p:cNvSpPr txBox="1"/>
                  <p:nvPr/>
                </p:nvSpPr>
                <p:spPr>
                  <a:xfrm>
                    <a:off x="5029200" y="5625467"/>
                    <a:ext cx="1133649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5)</a:t>
                    </a:r>
                  </a:p>
                </p:txBody>
              </p:sp>
            </p:grpSp>
            <p:sp>
              <p:nvSpPr>
                <p:cNvPr id="102" name="TextBox 101"/>
                <p:cNvSpPr txBox="1"/>
                <p:nvPr/>
              </p:nvSpPr>
              <p:spPr>
                <a:xfrm>
                  <a:off x="3932703" y="1848013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4478946" y="1848012"/>
                  <a:ext cx="515677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5027858" y="1851998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05" name="TextBox 104"/>
                <p:cNvSpPr txBox="1"/>
                <p:nvPr/>
              </p:nvSpPr>
              <p:spPr>
                <a:xfrm>
                  <a:off x="5563468" y="1851998"/>
                  <a:ext cx="515677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</p:grpSp>
          <p:sp>
            <p:nvSpPr>
              <p:cNvPr id="95" name="TextBox 94"/>
              <p:cNvSpPr txBox="1"/>
              <p:nvPr/>
            </p:nvSpPr>
            <p:spPr>
              <a:xfrm>
                <a:off x="4416132" y="2160138"/>
                <a:ext cx="755164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78</a:t>
                </a: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5488347" y="2798090"/>
                <a:ext cx="760219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78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4416132" y="2333804"/>
                <a:ext cx="742856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3</a:t>
                </a: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5488347" y="2963732"/>
                <a:ext cx="783881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3</a:t>
                </a:r>
              </a:p>
            </p:txBody>
          </p:sp>
          <p:sp>
            <p:nvSpPr>
              <p:cNvPr id="99" name="TextBox 98"/>
              <p:cNvSpPr txBox="1"/>
              <p:nvPr/>
            </p:nvSpPr>
            <p:spPr>
              <a:xfrm>
                <a:off x="5488347" y="3657514"/>
                <a:ext cx="732979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1</a:t>
                </a:r>
              </a:p>
            </p:txBody>
          </p:sp>
          <p:sp>
            <p:nvSpPr>
              <p:cNvPr id="100" name="TextBox 99"/>
              <p:cNvSpPr txBox="1"/>
              <p:nvPr/>
            </p:nvSpPr>
            <p:spPr>
              <a:xfrm>
                <a:off x="4416132" y="3545885"/>
                <a:ext cx="742856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1</a:t>
                </a:r>
              </a:p>
            </p:txBody>
          </p:sp>
        </p:grpSp>
        <p:grpSp>
          <p:nvGrpSpPr>
            <p:cNvPr id="77" name="Group 76"/>
            <p:cNvGrpSpPr/>
            <p:nvPr/>
          </p:nvGrpSpPr>
          <p:grpSpPr>
            <a:xfrm>
              <a:off x="6202229" y="1690007"/>
              <a:ext cx="2902360" cy="4370545"/>
              <a:chOff x="6202229" y="1849502"/>
              <a:chExt cx="2902360" cy="4370545"/>
            </a:xfrm>
          </p:grpSpPr>
          <p:grpSp>
            <p:nvGrpSpPr>
              <p:cNvPr id="78" name="Group 77"/>
              <p:cNvGrpSpPr/>
              <p:nvPr/>
            </p:nvGrpSpPr>
            <p:grpSpPr>
              <a:xfrm>
                <a:off x="6202229" y="1849502"/>
                <a:ext cx="2869620" cy="4370545"/>
                <a:chOff x="6202229" y="1849502"/>
                <a:chExt cx="2869620" cy="4370545"/>
              </a:xfrm>
            </p:grpSpPr>
            <p:grpSp>
              <p:nvGrpSpPr>
                <p:cNvPr id="85" name="Group 84"/>
                <p:cNvGrpSpPr/>
                <p:nvPr/>
              </p:nvGrpSpPr>
              <p:grpSpPr>
                <a:xfrm>
                  <a:off x="6202229" y="2045729"/>
                  <a:ext cx="2869620" cy="4174318"/>
                  <a:chOff x="6202229" y="2045729"/>
                  <a:chExt cx="2869620" cy="4174318"/>
                </a:xfrm>
              </p:grpSpPr>
              <p:pic>
                <p:nvPicPr>
                  <p:cNvPr id="92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6202229" y="2045729"/>
                    <a:ext cx="2869620" cy="4068000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93" name="Rectangle 92"/>
                  <p:cNvSpPr/>
                  <p:nvPr/>
                </p:nvSpPr>
                <p:spPr>
                  <a:xfrm>
                    <a:off x="6655981" y="5667162"/>
                    <a:ext cx="2286000" cy="55288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sp>
              <p:nvSpPr>
                <p:cNvPr id="86" name="TextBox 85"/>
                <p:cNvSpPr txBox="1"/>
                <p:nvPr/>
              </p:nvSpPr>
              <p:spPr>
                <a:xfrm>
                  <a:off x="6725759" y="5607570"/>
                  <a:ext cx="1073222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/>
                    <a:t>Heavy fraction (2)</a:t>
                  </a: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7868092" y="5625467"/>
                  <a:ext cx="1135026" cy="430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/>
                    <a:t>Heavy fraction (3)</a:t>
                  </a: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6753005" y="1849503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7299249" y="1849502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7848160" y="1853488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8383771" y="1853488"/>
                  <a:ext cx="515679" cy="3455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0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3</a:t>
                  </a:r>
                  <a:r>
                    <a:rPr lang="en-GB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</p:grpSp>
          <p:sp>
            <p:nvSpPr>
              <p:cNvPr id="79" name="TextBox 78"/>
              <p:cNvSpPr txBox="1"/>
              <p:nvPr/>
            </p:nvSpPr>
            <p:spPr>
              <a:xfrm>
                <a:off x="7236436" y="2241513"/>
                <a:ext cx="757348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366</a:t>
                </a:r>
              </a:p>
            </p:txBody>
          </p:sp>
          <p:sp>
            <p:nvSpPr>
              <p:cNvPr id="80" name="TextBox 79"/>
              <p:cNvSpPr txBox="1"/>
              <p:nvPr/>
            </p:nvSpPr>
            <p:spPr>
              <a:xfrm>
                <a:off x="7236436" y="3209954"/>
                <a:ext cx="696272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278</a:t>
                </a: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7221445" y="4800309"/>
                <a:ext cx="747722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133</a:t>
                </a:r>
              </a:p>
            </p:txBody>
          </p:sp>
          <p:sp>
            <p:nvSpPr>
              <p:cNvPr id="82" name="TextBox 81"/>
              <p:cNvSpPr txBox="1"/>
              <p:nvPr/>
            </p:nvSpPr>
            <p:spPr>
              <a:xfrm>
                <a:off x="8298016" y="2192036"/>
                <a:ext cx="749216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366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8296342" y="2819356"/>
                <a:ext cx="738582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345</a:t>
                </a: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8298018" y="3340946"/>
                <a:ext cx="806571" cy="28078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F 278</a:t>
                </a:r>
              </a:p>
            </p:txBody>
          </p:sp>
        </p:grpSp>
      </p:grpSp>
      <p:sp>
        <p:nvSpPr>
          <p:cNvPr id="133" name="TextBox 132"/>
          <p:cNvSpPr txBox="1"/>
          <p:nvPr/>
        </p:nvSpPr>
        <p:spPr>
          <a:xfrm>
            <a:off x="203545" y="3225359"/>
            <a:ext cx="1476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Organic soil</a:t>
            </a:r>
          </a:p>
        </p:txBody>
      </p:sp>
      <p:grpSp>
        <p:nvGrpSpPr>
          <p:cNvPr id="134" name="Group 133"/>
          <p:cNvGrpSpPr/>
          <p:nvPr/>
        </p:nvGrpSpPr>
        <p:grpSpPr>
          <a:xfrm>
            <a:off x="-26387" y="6845252"/>
            <a:ext cx="6840000" cy="3204000"/>
            <a:chOff x="151403" y="1735821"/>
            <a:chExt cx="8997112" cy="4704892"/>
          </a:xfrm>
        </p:grpSpPr>
        <p:grpSp>
          <p:nvGrpSpPr>
            <p:cNvPr id="135" name="Group 134"/>
            <p:cNvGrpSpPr/>
            <p:nvPr/>
          </p:nvGrpSpPr>
          <p:grpSpPr>
            <a:xfrm>
              <a:off x="151403" y="1735821"/>
              <a:ext cx="8997112" cy="4704892"/>
              <a:chOff x="151403" y="1735821"/>
              <a:chExt cx="8997112" cy="4704892"/>
            </a:xfrm>
          </p:grpSpPr>
          <p:grpSp>
            <p:nvGrpSpPr>
              <p:cNvPr id="138" name="Group 137"/>
              <p:cNvGrpSpPr/>
              <p:nvPr/>
            </p:nvGrpSpPr>
            <p:grpSpPr>
              <a:xfrm>
                <a:off x="151403" y="1738006"/>
                <a:ext cx="2963937" cy="4288697"/>
                <a:chOff x="151403" y="1876235"/>
                <a:chExt cx="2963937" cy="4288697"/>
              </a:xfrm>
            </p:grpSpPr>
            <p:grpSp>
              <p:nvGrpSpPr>
                <p:cNvPr id="176" name="Group 175"/>
                <p:cNvGrpSpPr/>
                <p:nvPr/>
              </p:nvGrpSpPr>
              <p:grpSpPr>
                <a:xfrm>
                  <a:off x="151403" y="1876235"/>
                  <a:ext cx="2963937" cy="4288697"/>
                  <a:chOff x="151403" y="1876235"/>
                  <a:chExt cx="2963937" cy="4288697"/>
                </a:xfrm>
              </p:grpSpPr>
              <p:grpSp>
                <p:nvGrpSpPr>
                  <p:cNvPr id="180" name="Group 179"/>
                  <p:cNvGrpSpPr/>
                  <p:nvPr/>
                </p:nvGrpSpPr>
                <p:grpSpPr>
                  <a:xfrm>
                    <a:off x="151403" y="1945757"/>
                    <a:ext cx="2963937" cy="4219175"/>
                    <a:chOff x="151403" y="1945757"/>
                    <a:chExt cx="2963937" cy="4219175"/>
                  </a:xfrm>
                </p:grpSpPr>
                <p:pic>
                  <p:nvPicPr>
                    <p:cNvPr id="184" name="Picture 2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51403" y="1945757"/>
                      <a:ext cx="2963937" cy="414068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85" name="Rectangle 184"/>
                    <p:cNvSpPr/>
                    <p:nvPr/>
                  </p:nvSpPr>
                  <p:spPr>
                    <a:xfrm>
                      <a:off x="829329" y="5369446"/>
                      <a:ext cx="2146443" cy="79548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1115094" y="1876235"/>
                    <a:ext cx="515679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>
                    <a:off x="2022841" y="1876237"/>
                    <a:ext cx="515678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971864" y="5369446"/>
                    <a:ext cx="1861374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5)</a:t>
                    </a:r>
                  </a:p>
                </p:txBody>
              </p:sp>
            </p:grpSp>
            <p:sp>
              <p:nvSpPr>
                <p:cNvPr id="177" name="TextBox 176"/>
                <p:cNvSpPr txBox="1"/>
                <p:nvPr/>
              </p:nvSpPr>
              <p:spPr>
                <a:xfrm>
                  <a:off x="2001575" y="2417928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4</a:t>
                  </a:r>
                </a:p>
              </p:txBody>
            </p:sp>
            <p:sp>
              <p:nvSpPr>
                <p:cNvPr id="178" name="TextBox 177"/>
                <p:cNvSpPr txBox="1"/>
                <p:nvPr/>
              </p:nvSpPr>
              <p:spPr>
                <a:xfrm>
                  <a:off x="2001575" y="3612320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2</a:t>
                  </a:r>
                </a:p>
              </p:txBody>
            </p:sp>
            <p:sp>
              <p:nvSpPr>
                <p:cNvPr id="179" name="TextBox 178"/>
                <p:cNvSpPr txBox="1"/>
                <p:nvPr/>
              </p:nvSpPr>
              <p:spPr>
                <a:xfrm>
                  <a:off x="2001574" y="4913036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78</a:t>
                  </a:r>
                </a:p>
              </p:txBody>
            </p:sp>
          </p:grpSp>
          <p:grpSp>
            <p:nvGrpSpPr>
              <p:cNvPr id="139" name="Group 138"/>
              <p:cNvGrpSpPr/>
              <p:nvPr/>
            </p:nvGrpSpPr>
            <p:grpSpPr>
              <a:xfrm>
                <a:off x="3203074" y="1735821"/>
                <a:ext cx="2795889" cy="4497231"/>
                <a:chOff x="3203074" y="1874050"/>
                <a:chExt cx="2795889" cy="4497231"/>
              </a:xfrm>
            </p:grpSpPr>
            <p:grpSp>
              <p:nvGrpSpPr>
                <p:cNvPr id="161" name="Group 160"/>
                <p:cNvGrpSpPr/>
                <p:nvPr/>
              </p:nvGrpSpPr>
              <p:grpSpPr>
                <a:xfrm>
                  <a:off x="3203074" y="1874050"/>
                  <a:ext cx="2795889" cy="4497231"/>
                  <a:chOff x="3203074" y="1874050"/>
                  <a:chExt cx="2795889" cy="4497231"/>
                </a:xfrm>
              </p:grpSpPr>
              <p:grpSp>
                <p:nvGrpSpPr>
                  <p:cNvPr id="163" name="Group 162"/>
                  <p:cNvGrpSpPr/>
                  <p:nvPr/>
                </p:nvGrpSpPr>
                <p:grpSpPr>
                  <a:xfrm>
                    <a:off x="3203074" y="1874050"/>
                    <a:ext cx="2795889" cy="4497231"/>
                    <a:chOff x="3203074" y="1874050"/>
                    <a:chExt cx="2795889" cy="4497231"/>
                  </a:xfrm>
                </p:grpSpPr>
                <p:grpSp>
                  <p:nvGrpSpPr>
                    <p:cNvPr id="171" name="Group 170"/>
                    <p:cNvGrpSpPr/>
                    <p:nvPr/>
                  </p:nvGrpSpPr>
                  <p:grpSpPr>
                    <a:xfrm>
                      <a:off x="3203074" y="1945757"/>
                      <a:ext cx="2795889" cy="4425524"/>
                      <a:chOff x="3203074" y="1945757"/>
                      <a:chExt cx="2795889" cy="4425524"/>
                    </a:xfrm>
                  </p:grpSpPr>
                  <p:pic>
                    <p:nvPicPr>
                      <p:cNvPr id="174" name="Picture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3074" y="1945757"/>
                        <a:ext cx="2795889" cy="42524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  <p:sp>
                    <p:nvSpPr>
                      <p:cNvPr id="175" name="Rectangle 174"/>
                      <p:cNvSpPr/>
                      <p:nvPr/>
                    </p:nvSpPr>
                    <p:spPr>
                      <a:xfrm>
                        <a:off x="3852520" y="5575795"/>
                        <a:ext cx="2146443" cy="795486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  <a:ln>
                        <a:noFill/>
                      </a:ln>
                      <a:effectLst/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/>
                      </a:p>
                    </p:txBody>
                  </p:sp>
                </p:grpSp>
                <p:sp>
                  <p:nvSpPr>
                    <p:cNvPr id="172" name="TextBox 171"/>
                    <p:cNvSpPr txBox="1"/>
                    <p:nvPr/>
                  </p:nvSpPr>
                  <p:spPr>
                    <a:xfrm>
                      <a:off x="4148912" y="1874050"/>
                      <a:ext cx="515679" cy="378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  <p:sp>
                  <p:nvSpPr>
                    <p:cNvPr id="173" name="TextBox 172"/>
                    <p:cNvSpPr txBox="1"/>
                    <p:nvPr/>
                  </p:nvSpPr>
                  <p:spPr>
                    <a:xfrm>
                      <a:off x="5056660" y="1874052"/>
                      <a:ext cx="515678" cy="37857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b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r>
                        <a:rPr lang="en-GB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</a:p>
                  </p:txBody>
                </p:sp>
              </p:grpSp>
              <p:sp>
                <p:nvSpPr>
                  <p:cNvPr id="164" name="TextBox 163"/>
                  <p:cNvSpPr txBox="1"/>
                  <p:nvPr/>
                </p:nvSpPr>
                <p:spPr>
                  <a:xfrm>
                    <a:off x="4909300" y="5028915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82</a:t>
                    </a:r>
                  </a:p>
                </p:txBody>
              </p:sp>
              <p:sp>
                <p:nvSpPr>
                  <p:cNvPr id="165" name="TextBox 164"/>
                  <p:cNvSpPr txBox="1"/>
                  <p:nvPr/>
                </p:nvSpPr>
                <p:spPr>
                  <a:xfrm>
                    <a:off x="4904475" y="5144491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80</a:t>
                    </a:r>
                  </a:p>
                </p:txBody>
              </p:sp>
              <p:sp>
                <p:nvSpPr>
                  <p:cNvPr id="166" name="TextBox 165"/>
                  <p:cNvSpPr txBox="1"/>
                  <p:nvPr/>
                </p:nvSpPr>
                <p:spPr>
                  <a:xfrm>
                    <a:off x="4925741" y="4351976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131</a:t>
                    </a:r>
                  </a:p>
                </p:txBody>
              </p:sp>
              <p:sp>
                <p:nvSpPr>
                  <p:cNvPr id="167" name="TextBox 166"/>
                  <p:cNvSpPr txBox="1"/>
                  <p:nvPr/>
                </p:nvSpPr>
                <p:spPr>
                  <a:xfrm>
                    <a:off x="4909298" y="3612318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203</a:t>
                    </a:r>
                  </a:p>
                </p:txBody>
              </p:sp>
              <p:sp>
                <p:nvSpPr>
                  <p:cNvPr id="168" name="TextBox 167"/>
                  <p:cNvSpPr txBox="1"/>
                  <p:nvPr/>
                </p:nvSpPr>
                <p:spPr>
                  <a:xfrm>
                    <a:off x="4903855" y="2654309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437</a:t>
                    </a:r>
                  </a:p>
                </p:txBody>
              </p:sp>
              <p:sp>
                <p:nvSpPr>
                  <p:cNvPr id="169" name="TextBox 168"/>
                  <p:cNvSpPr txBox="1"/>
                  <p:nvPr/>
                </p:nvSpPr>
                <p:spPr>
                  <a:xfrm>
                    <a:off x="4904474" y="2471093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438</a:t>
                    </a:r>
                  </a:p>
                </p:txBody>
              </p:sp>
              <p:sp>
                <p:nvSpPr>
                  <p:cNvPr id="170" name="TextBox 169"/>
                  <p:cNvSpPr txBox="1"/>
                  <p:nvPr/>
                </p:nvSpPr>
                <p:spPr>
                  <a:xfrm>
                    <a:off x="4909298" y="2117888"/>
                    <a:ext cx="810398" cy="2937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RF 666</a:t>
                    </a:r>
                  </a:p>
                </p:txBody>
              </p:sp>
            </p:grpSp>
            <p:sp>
              <p:nvSpPr>
                <p:cNvPr id="162" name="TextBox 161"/>
                <p:cNvSpPr txBox="1"/>
                <p:nvPr/>
              </p:nvSpPr>
              <p:spPr>
                <a:xfrm>
                  <a:off x="3874764" y="5521846"/>
                  <a:ext cx="1861374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1100" dirty="0"/>
                    <a:t>Heavy fraction (6)</a:t>
                  </a:r>
                </a:p>
              </p:txBody>
            </p:sp>
          </p:grpSp>
          <p:grpSp>
            <p:nvGrpSpPr>
              <p:cNvPr id="140" name="Group 139"/>
              <p:cNvGrpSpPr/>
              <p:nvPr/>
            </p:nvGrpSpPr>
            <p:grpSpPr>
              <a:xfrm>
                <a:off x="6195123" y="1859202"/>
                <a:ext cx="2953392" cy="4581511"/>
                <a:chOff x="6042723" y="1845031"/>
                <a:chExt cx="2953392" cy="4581511"/>
              </a:xfrm>
            </p:grpSpPr>
            <p:grpSp>
              <p:nvGrpSpPr>
                <p:cNvPr id="143" name="Group 142"/>
                <p:cNvGrpSpPr/>
                <p:nvPr/>
              </p:nvGrpSpPr>
              <p:grpSpPr>
                <a:xfrm>
                  <a:off x="6042723" y="1845031"/>
                  <a:ext cx="2953392" cy="4581511"/>
                  <a:chOff x="6042723" y="1845031"/>
                  <a:chExt cx="2953392" cy="4581511"/>
                </a:xfrm>
              </p:grpSpPr>
              <p:grpSp>
                <p:nvGrpSpPr>
                  <p:cNvPr id="152" name="Group 151"/>
                  <p:cNvGrpSpPr/>
                  <p:nvPr/>
                </p:nvGrpSpPr>
                <p:grpSpPr>
                  <a:xfrm>
                    <a:off x="6042723" y="1970892"/>
                    <a:ext cx="2953392" cy="4455650"/>
                    <a:chOff x="6042723" y="1970892"/>
                    <a:chExt cx="2953392" cy="4455650"/>
                  </a:xfrm>
                </p:grpSpPr>
                <p:pic>
                  <p:nvPicPr>
                    <p:cNvPr id="159" name="Picture 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1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6042723" y="1970892"/>
                      <a:ext cx="2953392" cy="4425524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sp>
                  <p:nvSpPr>
                    <p:cNvPr id="160" name="Rectangle 159"/>
                    <p:cNvSpPr/>
                    <p:nvPr/>
                  </p:nvSpPr>
                  <p:spPr>
                    <a:xfrm>
                      <a:off x="6588632" y="5631056"/>
                      <a:ext cx="2283569" cy="79548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noFill/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</p:grpSp>
              <p:sp>
                <p:nvSpPr>
                  <p:cNvPr id="153" name="TextBox 152"/>
                  <p:cNvSpPr txBox="1"/>
                  <p:nvPr/>
                </p:nvSpPr>
                <p:spPr>
                  <a:xfrm>
                    <a:off x="6611672" y="1845033"/>
                    <a:ext cx="515679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54" name="TextBox 153"/>
                  <p:cNvSpPr txBox="1"/>
                  <p:nvPr/>
                </p:nvSpPr>
                <p:spPr>
                  <a:xfrm>
                    <a:off x="7182839" y="1845031"/>
                    <a:ext cx="515678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55" name="TextBox 154"/>
                  <p:cNvSpPr txBox="1"/>
                  <p:nvPr/>
                </p:nvSpPr>
                <p:spPr>
                  <a:xfrm>
                    <a:off x="7730962" y="1845033"/>
                    <a:ext cx="515679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56" name="TextBox 155"/>
                  <p:cNvSpPr txBox="1"/>
                  <p:nvPr/>
                </p:nvSpPr>
                <p:spPr>
                  <a:xfrm>
                    <a:off x="8302128" y="1845031"/>
                    <a:ext cx="515678" cy="3785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000" b="1" baseline="30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3</a:t>
                    </a:r>
                    <a:r>
                      <a:rPr lang="en-GB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157" name="TextBox 156"/>
                  <p:cNvSpPr txBox="1"/>
                  <p:nvPr/>
                </p:nvSpPr>
                <p:spPr>
                  <a:xfrm>
                    <a:off x="6588732" y="5507673"/>
                    <a:ext cx="1141684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4)</a:t>
                    </a:r>
                  </a:p>
                </p:txBody>
              </p:sp>
              <p:sp>
                <p:nvSpPr>
                  <p:cNvPr id="158" name="TextBox 157"/>
                  <p:cNvSpPr txBox="1"/>
                  <p:nvPr/>
                </p:nvSpPr>
                <p:spPr>
                  <a:xfrm>
                    <a:off x="7698517" y="5507673"/>
                    <a:ext cx="1141684" cy="43088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GB" sz="1100" dirty="0"/>
                      <a:t>Heavy fraction (5)</a:t>
                    </a:r>
                  </a:p>
                </p:txBody>
              </p:sp>
            </p:grpSp>
            <p:sp>
              <p:nvSpPr>
                <p:cNvPr id="144" name="TextBox 143"/>
                <p:cNvSpPr txBox="1"/>
                <p:nvPr/>
              </p:nvSpPr>
              <p:spPr>
                <a:xfrm>
                  <a:off x="7104617" y="5057412"/>
                  <a:ext cx="666170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78</a:t>
                  </a: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7024846" y="4538884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82</a:t>
                  </a: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7024846" y="3591051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169</a:t>
                  </a: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7035480" y="3116130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177</a:t>
                  </a: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8189254" y="5083206"/>
                  <a:ext cx="699312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78</a:t>
                  </a: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8137565" y="3467940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177</a:t>
                  </a: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8138998" y="3074391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202</a:t>
                  </a: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8137564" y="2825271"/>
                  <a:ext cx="810397" cy="29376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F 211</a:t>
                  </a:r>
                </a:p>
              </p:txBody>
            </p:sp>
          </p:grpSp>
          <p:sp>
            <p:nvSpPr>
              <p:cNvPr id="141" name="Rectangle 140"/>
              <p:cNvSpPr/>
              <p:nvPr/>
            </p:nvSpPr>
            <p:spPr>
              <a:xfrm>
                <a:off x="3203074" y="1738007"/>
                <a:ext cx="649446" cy="381004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2" name="Rectangle 141"/>
              <p:cNvSpPr/>
              <p:nvPr/>
            </p:nvSpPr>
            <p:spPr>
              <a:xfrm>
                <a:off x="179883" y="1898442"/>
                <a:ext cx="649446" cy="381004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pic>
          <p:nvPicPr>
            <p:cNvPr id="136" name="Picture 4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9" t="634" r="83842" b="2271"/>
            <a:stretch/>
          </p:blipFill>
          <p:spPr bwMode="auto">
            <a:xfrm>
              <a:off x="439208" y="1928209"/>
              <a:ext cx="390121" cy="398602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37" name="Picture 4"/>
            <p:cNvPicPr>
              <a:picLocks noChangeAspect="1" noChangeArrowheads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49" t="634" r="83842" b="2271"/>
            <a:stretch/>
          </p:blipFill>
          <p:spPr bwMode="auto">
            <a:xfrm>
              <a:off x="3462399" y="1897876"/>
              <a:ext cx="390121" cy="426742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186" name="TextBox 185"/>
          <p:cNvSpPr txBox="1"/>
          <p:nvPr/>
        </p:nvSpPr>
        <p:spPr>
          <a:xfrm>
            <a:off x="215304" y="6589789"/>
            <a:ext cx="1476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Degraded leaves</a:t>
            </a:r>
          </a:p>
        </p:txBody>
      </p:sp>
      <p:sp>
        <p:nvSpPr>
          <p:cNvPr id="187" name="TextBox 186"/>
          <p:cNvSpPr txBox="1"/>
          <p:nvPr/>
        </p:nvSpPr>
        <p:spPr>
          <a:xfrm>
            <a:off x="21840" y="73275"/>
            <a:ext cx="35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88" name="TextBox 187"/>
          <p:cNvSpPr txBox="1"/>
          <p:nvPr/>
        </p:nvSpPr>
        <p:spPr>
          <a:xfrm>
            <a:off x="28664" y="3191055"/>
            <a:ext cx="35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90" name="TextBox 189"/>
          <p:cNvSpPr txBox="1"/>
          <p:nvPr/>
        </p:nvSpPr>
        <p:spPr>
          <a:xfrm>
            <a:off x="28664" y="6559942"/>
            <a:ext cx="3511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340643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-162" y="-23920"/>
            <a:ext cx="6858162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Palatino Linotype" panose="02040502050505030304" pitchFamily="18" charset="0"/>
              </a:rPr>
              <a:t>Supplementary Figure S4: Relative distribution and phylogenetic affiliation of OTUs detected by bacterial 16S rRNA high-throughput amplicon sequencing of samples before SIP experiments (T0) and fractionated DNA from [</a:t>
            </a:r>
            <a:r>
              <a:rPr lang="en-GB" sz="1000" b="1" baseline="30000" dirty="0">
                <a:latin typeface="Palatino Linotype" panose="02040502050505030304" pitchFamily="18" charset="0"/>
              </a:rPr>
              <a:t>13</a:t>
            </a:r>
            <a:r>
              <a:rPr lang="en-GB" sz="1000" b="1" dirty="0">
                <a:latin typeface="Palatino Linotype" panose="02040502050505030304" pitchFamily="18" charset="0"/>
              </a:rPr>
              <a:t>C]-CH</a:t>
            </a:r>
            <a:r>
              <a:rPr lang="en-GB" sz="1000" b="1" baseline="-25000" dirty="0">
                <a:latin typeface="Palatino Linotype" panose="02040502050505030304" pitchFamily="18" charset="0"/>
              </a:rPr>
              <a:t>3</a:t>
            </a:r>
            <a:r>
              <a:rPr lang="en-GB" sz="1000" b="1" dirty="0">
                <a:latin typeface="Palatino Linotype" panose="02040502050505030304" pitchFamily="18" charset="0"/>
              </a:rPr>
              <a:t>Cl and [</a:t>
            </a:r>
            <a:r>
              <a:rPr lang="en-GB" sz="1000" b="1" baseline="30000" dirty="0">
                <a:latin typeface="Palatino Linotype" panose="02040502050505030304" pitchFamily="18" charset="0"/>
              </a:rPr>
              <a:t>12</a:t>
            </a:r>
            <a:r>
              <a:rPr lang="en-GB" sz="1000" b="1" dirty="0">
                <a:latin typeface="Palatino Linotype" panose="02040502050505030304" pitchFamily="18" charset="0"/>
              </a:rPr>
              <a:t>C]-CH</a:t>
            </a:r>
            <a:r>
              <a:rPr lang="en-GB" sz="1000" b="1" baseline="-25000" dirty="0">
                <a:latin typeface="Palatino Linotype" panose="02040502050505030304" pitchFamily="18" charset="0"/>
              </a:rPr>
              <a:t>3</a:t>
            </a:r>
            <a:r>
              <a:rPr lang="en-GB" sz="1000" b="1" dirty="0">
                <a:latin typeface="Palatino Linotype" panose="02040502050505030304" pitchFamily="18" charset="0"/>
              </a:rPr>
              <a:t>Cl SIP incubations of mineral and organic soil samples and degraded leave samples from </a:t>
            </a:r>
            <a:r>
              <a:rPr lang="en-GB" sz="1000" b="1" dirty="0" err="1">
                <a:latin typeface="Palatino Linotype" panose="02040502050505030304" pitchFamily="18" charset="0"/>
              </a:rPr>
              <a:t>Steigerwald</a:t>
            </a:r>
            <a:r>
              <a:rPr lang="en-GB" sz="1000" b="1" dirty="0">
                <a:latin typeface="Palatino Linotype" panose="02040502050505030304" pitchFamily="18" charset="0"/>
              </a:rPr>
              <a:t> after incorporation of 100 </a:t>
            </a:r>
            <a:r>
              <a:rPr lang="en-GB" sz="1000" b="1" dirty="0" err="1">
                <a:latin typeface="Palatino Linotype" panose="02040502050505030304" pitchFamily="18" charset="0"/>
              </a:rPr>
              <a:t>μmol</a:t>
            </a:r>
            <a:r>
              <a:rPr lang="en-GB" sz="1000" b="1" dirty="0">
                <a:latin typeface="Palatino Linotype" panose="02040502050505030304" pitchFamily="18" charset="0"/>
              </a:rPr>
              <a:t> C g</a:t>
            </a:r>
            <a:r>
              <a:rPr lang="en-GB" sz="1000" b="1" baseline="30000" dirty="0">
                <a:latin typeface="Palatino Linotype" panose="02040502050505030304" pitchFamily="18" charset="0"/>
              </a:rPr>
              <a:t>-1</a:t>
            </a:r>
            <a:r>
              <a:rPr lang="en-GB" sz="1000" b="1" dirty="0">
                <a:latin typeface="Palatino Linotype" panose="02040502050505030304" pitchFamily="18" charset="0"/>
              </a:rPr>
              <a:t> sample. </a:t>
            </a:r>
            <a:r>
              <a:rPr lang="en-GB" sz="1000" dirty="0">
                <a:latin typeface="Palatino Linotype" panose="02040502050505030304" pitchFamily="18" charset="0"/>
              </a:rPr>
              <a:t>Each column represents relative abundance of microbial taxa detected in a sample. </a:t>
            </a:r>
            <a:endParaRPr lang="en-US" sz="1000" dirty="0">
              <a:latin typeface="Palatino Linotype" panose="02040502050505030304" pitchFamily="18" charset="0"/>
            </a:endParaRPr>
          </a:p>
        </p:txBody>
      </p:sp>
      <p:grpSp>
        <p:nvGrpSpPr>
          <p:cNvPr id="90" name="Group 89"/>
          <p:cNvGrpSpPr/>
          <p:nvPr/>
        </p:nvGrpSpPr>
        <p:grpSpPr>
          <a:xfrm>
            <a:off x="43849" y="759779"/>
            <a:ext cx="6814151" cy="9161773"/>
            <a:chOff x="43849" y="615763"/>
            <a:chExt cx="6814151" cy="9161773"/>
          </a:xfrm>
        </p:grpSpPr>
        <p:grpSp>
          <p:nvGrpSpPr>
            <p:cNvPr id="78" name="Group 77"/>
            <p:cNvGrpSpPr/>
            <p:nvPr/>
          </p:nvGrpSpPr>
          <p:grpSpPr>
            <a:xfrm>
              <a:off x="43849" y="615763"/>
              <a:ext cx="6814151" cy="9161773"/>
              <a:chOff x="43849" y="615763"/>
              <a:chExt cx="6814151" cy="9161773"/>
            </a:xfrm>
          </p:grpSpPr>
          <p:grpSp>
            <p:nvGrpSpPr>
              <p:cNvPr id="68" name="Group 67"/>
              <p:cNvGrpSpPr/>
              <p:nvPr/>
            </p:nvGrpSpPr>
            <p:grpSpPr>
              <a:xfrm>
                <a:off x="43849" y="615763"/>
                <a:ext cx="6814151" cy="9161773"/>
                <a:chOff x="43849" y="345409"/>
                <a:chExt cx="6814151" cy="9161773"/>
              </a:xfrm>
            </p:grpSpPr>
            <p:grpSp>
              <p:nvGrpSpPr>
                <p:cNvPr id="35" name="Group 34"/>
                <p:cNvGrpSpPr/>
                <p:nvPr/>
              </p:nvGrpSpPr>
              <p:grpSpPr>
                <a:xfrm>
                  <a:off x="61708" y="345409"/>
                  <a:ext cx="6796292" cy="5947693"/>
                  <a:chOff x="61708" y="345409"/>
                  <a:chExt cx="6796292" cy="5947693"/>
                </a:xfrm>
              </p:grpSpPr>
              <p:grpSp>
                <p:nvGrpSpPr>
                  <p:cNvPr id="33" name="Group 32"/>
                  <p:cNvGrpSpPr/>
                  <p:nvPr/>
                </p:nvGrpSpPr>
                <p:grpSpPr>
                  <a:xfrm>
                    <a:off x="61708" y="345409"/>
                    <a:ext cx="6796292" cy="5947693"/>
                    <a:chOff x="61708" y="345409"/>
                    <a:chExt cx="6796292" cy="5947693"/>
                  </a:xfrm>
                </p:grpSpPr>
                <p:cxnSp>
                  <p:nvCxnSpPr>
                    <p:cNvPr id="29" name="Straight Connector 28"/>
                    <p:cNvCxnSpPr/>
                    <p:nvPr/>
                  </p:nvCxnSpPr>
                  <p:spPr>
                    <a:xfrm>
                      <a:off x="2492896" y="632520"/>
                      <a:ext cx="1836000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23" name="Group 22"/>
                    <p:cNvGrpSpPr/>
                    <p:nvPr/>
                  </p:nvGrpSpPr>
                  <p:grpSpPr>
                    <a:xfrm>
                      <a:off x="61708" y="345409"/>
                      <a:ext cx="6796292" cy="5947693"/>
                      <a:chOff x="61708" y="345409"/>
                      <a:chExt cx="6796292" cy="5947693"/>
                    </a:xfrm>
                  </p:grpSpPr>
                  <p:cxnSp>
                    <p:nvCxnSpPr>
                      <p:cNvPr id="5" name="Straight Connector 4"/>
                      <p:cNvCxnSpPr/>
                      <p:nvPr/>
                    </p:nvCxnSpPr>
                    <p:spPr>
                      <a:xfrm>
                        <a:off x="440742" y="632520"/>
                        <a:ext cx="1980000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grpSp>
                    <p:nvGrpSpPr>
                      <p:cNvPr id="17" name="Group 16"/>
                      <p:cNvGrpSpPr/>
                      <p:nvPr/>
                    </p:nvGrpSpPr>
                    <p:grpSpPr>
                      <a:xfrm>
                        <a:off x="61708" y="345409"/>
                        <a:ext cx="6796292" cy="5947693"/>
                        <a:chOff x="61708" y="345409"/>
                        <a:chExt cx="6796292" cy="5947693"/>
                      </a:xfrm>
                    </p:grpSpPr>
                    <p:grpSp>
                      <p:nvGrpSpPr>
                        <p:cNvPr id="16" name="Group 15"/>
                        <p:cNvGrpSpPr/>
                        <p:nvPr/>
                      </p:nvGrpSpPr>
                      <p:grpSpPr>
                        <a:xfrm>
                          <a:off x="61708" y="947632"/>
                          <a:ext cx="6796292" cy="5345470"/>
                          <a:chOff x="61708" y="947632"/>
                          <a:chExt cx="6796292" cy="5345470"/>
                        </a:xfrm>
                      </p:grpSpPr>
                      <p:pic>
                        <p:nvPicPr>
                          <p:cNvPr id="2" name="Picture 1"/>
                          <p:cNvPicPr>
                            <a:picLocks noChangeAspect="1"/>
                          </p:cNvPicPr>
                          <p:nvPr/>
                        </p:nvPicPr>
                        <p:blipFill rotWithShape="1">
                          <a:blip r:embed="rId3"/>
                          <a:srcRect l="759" t="1270" b="39920"/>
                          <a:stretch/>
                        </p:blipFill>
                        <p:spPr>
                          <a:xfrm>
                            <a:off x="61708" y="947632"/>
                            <a:ext cx="6796292" cy="5345470"/>
                          </a:xfrm>
                          <a:prstGeom prst="rect">
                            <a:avLst/>
                          </a:prstGeom>
                        </p:spPr>
                      </p:pic>
                      <p:cxnSp>
                        <p:nvCxnSpPr>
                          <p:cNvPr id="6" name="Straight Connector 5"/>
                          <p:cNvCxnSpPr/>
                          <p:nvPr/>
                        </p:nvCxnSpPr>
                        <p:spPr>
                          <a:xfrm>
                            <a:off x="404664" y="992560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7" name="Straight Connector 6"/>
                          <p:cNvCxnSpPr/>
                          <p:nvPr/>
                        </p:nvCxnSpPr>
                        <p:spPr>
                          <a:xfrm>
                            <a:off x="1124744" y="992560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8" name="Straight Connector 7"/>
                          <p:cNvCxnSpPr/>
                          <p:nvPr/>
                        </p:nvCxnSpPr>
                        <p:spPr>
                          <a:xfrm>
                            <a:off x="1844824" y="992560"/>
                            <a:ext cx="612000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9" name="Straight Connector 8"/>
                          <p:cNvCxnSpPr/>
                          <p:nvPr/>
                        </p:nvCxnSpPr>
                        <p:spPr>
                          <a:xfrm>
                            <a:off x="2492896" y="992560"/>
                            <a:ext cx="432000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0" name="Straight Connector 9"/>
                          <p:cNvCxnSpPr/>
                          <p:nvPr/>
                        </p:nvCxnSpPr>
                        <p:spPr>
                          <a:xfrm>
                            <a:off x="2996952" y="992560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1" name="Straight Connector 10"/>
                          <p:cNvCxnSpPr/>
                          <p:nvPr/>
                        </p:nvCxnSpPr>
                        <p:spPr>
                          <a:xfrm>
                            <a:off x="3717032" y="992560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2" name="Straight Connector 11"/>
                          <p:cNvCxnSpPr/>
                          <p:nvPr/>
                        </p:nvCxnSpPr>
                        <p:spPr>
                          <a:xfrm>
                            <a:off x="4437112" y="993298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3" name="Straight Connector 12"/>
                          <p:cNvCxnSpPr/>
                          <p:nvPr/>
                        </p:nvCxnSpPr>
                        <p:spPr>
                          <a:xfrm>
                            <a:off x="5157192" y="992560"/>
                            <a:ext cx="612000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15" name="Straight Connector 14"/>
                          <p:cNvCxnSpPr/>
                          <p:nvPr/>
                        </p:nvCxnSpPr>
                        <p:spPr>
                          <a:xfrm>
                            <a:off x="5805264" y="992560"/>
                            <a:ext cx="648072" cy="0"/>
                          </a:xfrm>
                          <a:prstGeom prst="line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18" name="TextBox 17"/>
                        <p:cNvSpPr txBox="1"/>
                        <p:nvPr/>
                      </p:nvSpPr>
                      <p:spPr>
                        <a:xfrm>
                          <a:off x="404664" y="730950"/>
                          <a:ext cx="64807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T0</a:t>
                          </a:r>
                        </a:p>
                      </p:txBody>
                    </p:sp>
                    <p:sp>
                      <p:nvSpPr>
                        <p:cNvPr id="19" name="TextBox 18"/>
                        <p:cNvSpPr txBox="1"/>
                        <p:nvPr/>
                      </p:nvSpPr>
                      <p:spPr>
                        <a:xfrm>
                          <a:off x="1052736" y="730950"/>
                          <a:ext cx="72003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Heavy</a:t>
                          </a:r>
                        </a:p>
                      </p:txBody>
                    </p:sp>
                    <p:sp>
                      <p:nvSpPr>
                        <p:cNvPr id="20" name="TextBox 19"/>
                        <p:cNvSpPr txBox="1"/>
                        <p:nvPr/>
                      </p:nvSpPr>
                      <p:spPr>
                        <a:xfrm>
                          <a:off x="1772768" y="730950"/>
                          <a:ext cx="68405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Light</a:t>
                          </a:r>
                        </a:p>
                      </p:txBody>
                    </p:sp>
                    <p:sp>
                      <p:nvSpPr>
                        <p:cNvPr id="21" name="TextBox 20"/>
                        <p:cNvSpPr txBox="1"/>
                        <p:nvPr/>
                      </p:nvSpPr>
                      <p:spPr>
                        <a:xfrm>
                          <a:off x="2492896" y="732512"/>
                          <a:ext cx="50405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T0</a:t>
                          </a:r>
                        </a:p>
                      </p:txBody>
                    </p:sp>
                    <p:sp>
                      <p:nvSpPr>
                        <p:cNvPr id="22" name="TextBox 21"/>
                        <p:cNvSpPr txBox="1"/>
                        <p:nvPr/>
                      </p:nvSpPr>
                      <p:spPr>
                        <a:xfrm>
                          <a:off x="2924896" y="730950"/>
                          <a:ext cx="738118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Heavy</a:t>
                          </a:r>
                        </a:p>
                      </p:txBody>
                    </p:sp>
                    <p:sp>
                      <p:nvSpPr>
                        <p:cNvPr id="24" name="TextBox 23"/>
                        <p:cNvSpPr txBox="1"/>
                        <p:nvPr/>
                      </p:nvSpPr>
                      <p:spPr>
                        <a:xfrm>
                          <a:off x="3681052" y="730950"/>
                          <a:ext cx="68405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Light</a:t>
                          </a:r>
                        </a:p>
                      </p:txBody>
                    </p:sp>
                    <p:sp>
                      <p:nvSpPr>
                        <p:cNvPr id="25" name="TextBox 24"/>
                        <p:cNvSpPr txBox="1"/>
                        <p:nvPr/>
                      </p:nvSpPr>
                      <p:spPr>
                        <a:xfrm>
                          <a:off x="4509120" y="727479"/>
                          <a:ext cx="504056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T0</a:t>
                          </a:r>
                        </a:p>
                      </p:txBody>
                    </p:sp>
                    <p:sp>
                      <p:nvSpPr>
                        <p:cNvPr id="26" name="TextBox 25"/>
                        <p:cNvSpPr txBox="1"/>
                        <p:nvPr/>
                      </p:nvSpPr>
                      <p:spPr>
                        <a:xfrm>
                          <a:off x="5049204" y="732512"/>
                          <a:ext cx="75606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Heavy</a:t>
                          </a:r>
                        </a:p>
                      </p:txBody>
                    </p:sp>
                    <p:sp>
                      <p:nvSpPr>
                        <p:cNvPr id="27" name="TextBox 26"/>
                        <p:cNvSpPr txBox="1"/>
                        <p:nvPr/>
                      </p:nvSpPr>
                      <p:spPr>
                        <a:xfrm>
                          <a:off x="5768284" y="727479"/>
                          <a:ext cx="68405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 baseline="300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13</a:t>
                          </a:r>
                          <a:r>
                            <a:rPr lang="en-US" sz="900" dirty="0">
                              <a:latin typeface="Arial" charset="0"/>
                              <a:ea typeface="Arial" charset="0"/>
                              <a:cs typeface="Arial" charset="0"/>
                            </a:rPr>
                            <a:t>C Light</a:t>
                          </a:r>
                        </a:p>
                      </p:txBody>
                    </p:sp>
                    <p:sp>
                      <p:nvSpPr>
                        <p:cNvPr id="28" name="TextBox 27"/>
                        <p:cNvSpPr txBox="1"/>
                        <p:nvPr/>
                      </p:nvSpPr>
                      <p:spPr>
                        <a:xfrm>
                          <a:off x="6453336" y="716800"/>
                          <a:ext cx="323622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US" sz="900">
                              <a:latin typeface="Arial" charset="0"/>
                              <a:ea typeface="Arial" charset="0"/>
                              <a:cs typeface="Arial" charset="0"/>
                            </a:rPr>
                            <a:t>K</a:t>
                          </a:r>
                          <a:endParaRPr lang="en-US" sz="900" dirty="0">
                            <a:latin typeface="Arial" charset="0"/>
                            <a:ea typeface="Arial" charset="0"/>
                            <a:cs typeface="Arial" charset="0"/>
                          </a:endParaRPr>
                        </a:p>
                      </p:txBody>
                    </p:sp>
                    <p:cxnSp>
                      <p:nvCxnSpPr>
                        <p:cNvPr id="30" name="Straight Connector 29"/>
                        <p:cNvCxnSpPr/>
                        <p:nvPr/>
                      </p:nvCxnSpPr>
                      <p:spPr>
                        <a:xfrm>
                          <a:off x="4437112" y="632520"/>
                          <a:ext cx="1980000" cy="0"/>
                        </a:xfrm>
                        <a:prstGeom prst="line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4" name="TextBox 13"/>
                        <p:cNvSpPr txBox="1"/>
                        <p:nvPr/>
                      </p:nvSpPr>
                      <p:spPr>
                        <a:xfrm>
                          <a:off x="476672" y="345412"/>
                          <a:ext cx="1944070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4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Degraded leaves</a:t>
                          </a:r>
                        </a:p>
                      </p:txBody>
                    </p:sp>
                    <p:sp>
                      <p:nvSpPr>
                        <p:cNvPr id="31" name="TextBox 30"/>
                        <p:cNvSpPr txBox="1"/>
                        <p:nvPr/>
                      </p:nvSpPr>
                      <p:spPr>
                        <a:xfrm>
                          <a:off x="2439451" y="345411"/>
                          <a:ext cx="1944070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4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Organic soil</a:t>
                          </a:r>
                        </a:p>
                      </p:txBody>
                    </p:sp>
                    <p:sp>
                      <p:nvSpPr>
                        <p:cNvPr id="32" name="TextBox 31"/>
                        <p:cNvSpPr txBox="1"/>
                        <p:nvPr/>
                      </p:nvSpPr>
                      <p:spPr>
                        <a:xfrm>
                          <a:off x="4455175" y="345409"/>
                          <a:ext cx="1944070" cy="307777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algn="ctr"/>
                          <a:r>
                            <a:rPr lang="en-GB" sz="14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Mineral soil</a:t>
                          </a:r>
                        </a:p>
                      </p:txBody>
                    </p:sp>
                  </p:grpSp>
                </p:grpSp>
              </p:grpSp>
              <p:sp>
                <p:nvSpPr>
                  <p:cNvPr id="34" name="Rectangle 33"/>
                  <p:cNvSpPr/>
                  <p:nvPr/>
                </p:nvSpPr>
                <p:spPr>
                  <a:xfrm>
                    <a:off x="133462" y="5933062"/>
                    <a:ext cx="6552728" cy="36004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pic>
              <p:nvPicPr>
                <p:cNvPr id="58" name="Picture 57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759" t="61265" r="924"/>
                <a:stretch/>
              </p:blipFill>
              <p:spPr>
                <a:xfrm>
                  <a:off x="43849" y="5986427"/>
                  <a:ext cx="6733109" cy="3520755"/>
                </a:xfrm>
                <a:prstGeom prst="rect">
                  <a:avLst/>
                </a:prstGeom>
              </p:spPr>
            </p:pic>
          </p:grpSp>
          <p:sp>
            <p:nvSpPr>
              <p:cNvPr id="69" name="TextBox 68"/>
              <p:cNvSpPr txBox="1"/>
              <p:nvPr/>
            </p:nvSpPr>
            <p:spPr>
              <a:xfrm>
                <a:off x="1006672" y="4527201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1239520" y="3985352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1484325" y="3986494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>
                <a:off x="2906632" y="3986494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>
                <a:off x="3151711" y="4210975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>
                <a:off x="3383892" y="3969580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5" name="TextBox 74"/>
              <p:cNvSpPr txBox="1"/>
              <p:nvPr/>
            </p:nvSpPr>
            <p:spPr>
              <a:xfrm>
                <a:off x="5031139" y="4146209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5507463" y="3810256"/>
                <a:ext cx="338554" cy="1224136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obacteria</a:t>
                </a:r>
              </a:p>
            </p:txBody>
          </p:sp>
          <p:sp>
            <p:nvSpPr>
              <p:cNvPr id="77" name="TextBox 76"/>
              <p:cNvSpPr txBox="1"/>
              <p:nvPr/>
            </p:nvSpPr>
            <p:spPr>
              <a:xfrm>
                <a:off x="5271970" y="4635708"/>
                <a:ext cx="338554" cy="560902"/>
              </a:xfrm>
              <a:prstGeom prst="rect">
                <a:avLst/>
              </a:prstGeom>
              <a:noFill/>
            </p:spPr>
            <p:txBody>
              <a:bodyPr vert="vert270" wrap="square" rtlCol="0">
                <a:spAutoFit/>
              </a:bodyPr>
              <a:lstStyle/>
              <a:p>
                <a:r>
                  <a:rPr lang="en-GB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</a:p>
            </p:txBody>
          </p:sp>
        </p:grpSp>
        <p:sp>
          <p:nvSpPr>
            <p:cNvPr id="79" name="TextBox 78"/>
            <p:cNvSpPr txBox="1"/>
            <p:nvPr/>
          </p:nvSpPr>
          <p:spPr>
            <a:xfrm>
              <a:off x="1268780" y="3462777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508761" y="3003706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923679" y="2768055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159026" y="3810256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398522" y="3339666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5529408" y="3644500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5286600" y="4597420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5056664" y="4352341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036844" y="4538825"/>
              <a:ext cx="338554" cy="246221"/>
            </a:xfrm>
            <a:prstGeom prst="rect">
              <a:avLst/>
            </a:prstGeom>
            <a:noFill/>
          </p:spPr>
          <p:txBody>
            <a:bodyPr vert="horz" wrap="square" rtlCol="0">
              <a:spAutoFit/>
            </a:bodyPr>
            <a:lstStyle/>
            <a:p>
              <a:r>
                <a:rPr lang="en-GB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Th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" name="Rounded Rectangle 87"/>
          <p:cNvSpPr/>
          <p:nvPr/>
        </p:nvSpPr>
        <p:spPr>
          <a:xfrm>
            <a:off x="1906680" y="7167861"/>
            <a:ext cx="1188000" cy="72008"/>
          </a:xfrm>
          <a:prstGeom prst="roundRect">
            <a:avLst/>
          </a:prstGeom>
          <a:solidFill>
            <a:schemeClr val="bg2">
              <a:lumMod val="25000"/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ounded Rectangle 95"/>
          <p:cNvSpPr/>
          <p:nvPr/>
        </p:nvSpPr>
        <p:spPr>
          <a:xfrm>
            <a:off x="1906680" y="7093811"/>
            <a:ext cx="1188000" cy="72008"/>
          </a:xfrm>
          <a:prstGeom prst="roundRect">
            <a:avLst/>
          </a:prstGeom>
          <a:solidFill>
            <a:schemeClr val="accent3">
              <a:alpha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6697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5400000">
            <a:off x="2634128" y="-2654690"/>
            <a:ext cx="738664" cy="597977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 dirty="0">
                <a:latin typeface="Palatino Linotype" panose="02040502050505030304" pitchFamily="18" charset="0"/>
              </a:rPr>
              <a:t>Supplementary Figure S5: </a:t>
            </a:r>
            <a:r>
              <a:rPr lang="en-GB" sz="1200" b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Average nucleotide identity (ANI) analysis of </a:t>
            </a:r>
            <a:r>
              <a:rPr lang="en-GB" sz="1200" b="1" i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“</a:t>
            </a:r>
            <a:r>
              <a:rPr lang="en-GB" sz="1200" b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Degraded leaves bin 11</a:t>
            </a:r>
            <a:r>
              <a:rPr lang="en-GB" sz="1200" b="1" i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” </a:t>
            </a:r>
            <a:r>
              <a:rPr lang="en-GB" sz="1200" b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and the closely related </a:t>
            </a:r>
            <a:r>
              <a:rPr lang="en-GB" sz="1200" b="1" i="1" dirty="0" err="1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Granulicella</a:t>
            </a:r>
            <a:r>
              <a:rPr lang="en-GB" sz="1200" b="1" i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 b="1" i="1" dirty="0" err="1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mallensis</a:t>
            </a:r>
            <a:r>
              <a:rPr lang="en-GB" sz="1200" b="1" i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200" b="1" dirty="0">
                <a:latin typeface="Palatino Linotype" panose="02040502050505030304" pitchFamily="18" charset="0"/>
                <a:ea typeface="MS Mincho" panose="02020609040205080304" pitchFamily="49" charset="-128"/>
                <a:cs typeface="Arial" panose="020B0604020202020204" pitchFamily="34" charset="0"/>
              </a:rPr>
              <a:t>and AAI analysis between those two species.</a:t>
            </a:r>
            <a:endParaRPr lang="en-US" sz="1200" b="1" dirty="0">
              <a:latin typeface="Palatino Linotype" panose="0204050205050503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60648" y="704528"/>
            <a:ext cx="640871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ANI) </a:t>
            </a:r>
            <a:r>
              <a:rPr lang="en-GB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Granulicella</a:t>
            </a:r>
            <a:r>
              <a:rPr lang="en-GB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GB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mallensis</a:t>
            </a:r>
            <a:endParaRPr lang="en-GB" sz="14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r>
              <a:rPr lang="en-GB" sz="1400" b="1" dirty="0">
                <a:latin typeface="Palatino Linotype" panose="02040502050505030304" pitchFamily="18" charset="0"/>
              </a:rPr>
              <a:t>	One-way ANI 1:</a:t>
            </a:r>
            <a:r>
              <a:rPr lang="en-GB" sz="1400" dirty="0">
                <a:latin typeface="Palatino Linotype" panose="02040502050505030304" pitchFamily="18" charset="0"/>
              </a:rPr>
              <a:t> 87.79% (SD: 3.62%), from 12749 fragments.</a:t>
            </a:r>
            <a:br>
              <a:rPr lang="en-GB" sz="1400" dirty="0">
                <a:latin typeface="Palatino Linotype" panose="02040502050505030304" pitchFamily="18" charset="0"/>
              </a:rPr>
            </a:br>
            <a:r>
              <a:rPr lang="en-GB" sz="1400" dirty="0">
                <a:latin typeface="Palatino Linotype" panose="02040502050505030304" pitchFamily="18" charset="0"/>
              </a:rPr>
              <a:t>	</a:t>
            </a:r>
            <a:r>
              <a:rPr lang="en-GB" sz="1400" b="1" dirty="0">
                <a:latin typeface="Palatino Linotype" panose="02040502050505030304" pitchFamily="18" charset="0"/>
              </a:rPr>
              <a:t>One-way ANI 2:</a:t>
            </a:r>
            <a:r>
              <a:rPr lang="en-GB" sz="1400" dirty="0">
                <a:latin typeface="Palatino Linotype" panose="02040502050505030304" pitchFamily="18" charset="0"/>
              </a:rPr>
              <a:t> 87.75% (SD: 3.63%), from 13196 fragments.</a:t>
            </a:r>
            <a:br>
              <a:rPr lang="en-GB" sz="1400" dirty="0">
                <a:latin typeface="Palatino Linotype" panose="02040502050505030304" pitchFamily="18" charset="0"/>
              </a:rPr>
            </a:br>
            <a:r>
              <a:rPr lang="en-GB" sz="1400" dirty="0">
                <a:latin typeface="Palatino Linotype" panose="02040502050505030304" pitchFamily="18" charset="0"/>
              </a:rPr>
              <a:t>	</a:t>
            </a:r>
            <a:r>
              <a:rPr lang="en-GB" sz="1400" b="1" dirty="0">
                <a:latin typeface="Palatino Linotype" panose="02040502050505030304" pitchFamily="18" charset="0"/>
              </a:rPr>
              <a:t>Two-way ANI:</a:t>
            </a:r>
            <a:r>
              <a:rPr lang="en-GB" sz="1400" dirty="0">
                <a:latin typeface="Palatino Linotype" panose="02040502050505030304" pitchFamily="18" charset="0"/>
              </a:rPr>
              <a:t> 87.93% (SD: 3.48%), from 10220 fragments.</a:t>
            </a:r>
          </a:p>
        </p:txBody>
      </p:sp>
      <p:pic>
        <p:nvPicPr>
          <p:cNvPr id="6" name="Picture 3" descr="d:\Benutzer\kroeber\Desktop\2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6" y="1658635"/>
            <a:ext cx="3834615" cy="3009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6"/>
          <p:cNvSpPr/>
          <p:nvPr/>
        </p:nvSpPr>
        <p:spPr>
          <a:xfrm>
            <a:off x="440668" y="5169024"/>
            <a:ext cx="6048672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AAI) </a:t>
            </a:r>
            <a:r>
              <a:rPr lang="en-GB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Granulicella</a:t>
            </a:r>
            <a:r>
              <a:rPr lang="en-GB" sz="14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GB" sz="14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mallensis</a:t>
            </a:r>
            <a:endParaRPr lang="en-GB" sz="1400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r>
              <a:rPr lang="en-GB" sz="1400" b="1" dirty="0">
                <a:latin typeface="Palatino Linotype" panose="02040502050505030304" pitchFamily="18" charset="0"/>
              </a:rPr>
              <a:t>	One-way AAI 1:</a:t>
            </a:r>
            <a:r>
              <a:rPr lang="en-GB" sz="1400" dirty="0">
                <a:latin typeface="Palatino Linotype" panose="02040502050505030304" pitchFamily="18" charset="0"/>
              </a:rPr>
              <a:t> 79.08% (SD: 24.58%), from 3589 proteins.</a:t>
            </a:r>
            <a:br>
              <a:rPr lang="en-GB" sz="1400" dirty="0">
                <a:latin typeface="Palatino Linotype" panose="02040502050505030304" pitchFamily="18" charset="0"/>
              </a:rPr>
            </a:br>
            <a:r>
              <a:rPr lang="en-GB" sz="1400" dirty="0">
                <a:latin typeface="Palatino Linotype" panose="02040502050505030304" pitchFamily="18" charset="0"/>
              </a:rPr>
              <a:t>	</a:t>
            </a:r>
            <a:r>
              <a:rPr lang="en-GB" sz="1400" b="1" dirty="0">
                <a:latin typeface="Palatino Linotype" panose="02040502050505030304" pitchFamily="18" charset="0"/>
              </a:rPr>
              <a:t>One-way AAI 2:</a:t>
            </a:r>
            <a:r>
              <a:rPr lang="en-GB" sz="1400" dirty="0">
                <a:latin typeface="Palatino Linotype" panose="02040502050505030304" pitchFamily="18" charset="0"/>
              </a:rPr>
              <a:t> 67.29% (SD: 29.42%), from 4767 proteins.</a:t>
            </a:r>
            <a:br>
              <a:rPr lang="en-GB" sz="1400" dirty="0">
                <a:latin typeface="Palatino Linotype" panose="02040502050505030304" pitchFamily="18" charset="0"/>
              </a:rPr>
            </a:br>
            <a:r>
              <a:rPr lang="en-GB" sz="1400" dirty="0">
                <a:latin typeface="Palatino Linotype" panose="02040502050505030304" pitchFamily="18" charset="0"/>
              </a:rPr>
              <a:t>	</a:t>
            </a:r>
            <a:r>
              <a:rPr lang="en-GB" sz="1400" b="1" dirty="0">
                <a:latin typeface="Palatino Linotype" panose="02040502050505030304" pitchFamily="18" charset="0"/>
              </a:rPr>
              <a:t>Two-way AAI:</a:t>
            </a:r>
            <a:r>
              <a:rPr lang="en-GB" sz="1400" dirty="0">
                <a:latin typeface="Palatino Linotype" panose="02040502050505030304" pitchFamily="18" charset="0"/>
              </a:rPr>
              <a:t> 90.47% (SD: 12.65%), from 2731 proteins.</a:t>
            </a:r>
            <a:endParaRPr lang="en-GB" sz="14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pic>
        <p:nvPicPr>
          <p:cNvPr id="8" name="Picture 2" descr="d:\Benutzer\kroeber\Desktop\1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775" y="6228183"/>
            <a:ext cx="3834615" cy="3009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979794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 rot="16200000">
            <a:off x="-1459169" y="1488242"/>
            <a:ext cx="10165442" cy="6869823"/>
            <a:chOff x="-87560" y="15561"/>
            <a:chExt cx="10165442" cy="6869823"/>
          </a:xfrm>
        </p:grpSpPr>
        <p:sp>
          <p:nvSpPr>
            <p:cNvPr id="5" name="Rounded Rectangle 4"/>
            <p:cNvSpPr/>
            <p:nvPr/>
          </p:nvSpPr>
          <p:spPr>
            <a:xfrm>
              <a:off x="5378303" y="3763197"/>
              <a:ext cx="1635224" cy="754814"/>
            </a:xfrm>
            <a:prstGeom prst="roundRect">
              <a:avLst/>
            </a:prstGeom>
            <a:solidFill>
              <a:schemeClr val="accent5">
                <a:lumMod val="20000"/>
                <a:lumOff val="80000"/>
                <a:alpha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-87560" y="15561"/>
              <a:ext cx="10001734" cy="6869823"/>
              <a:chOff x="-87560" y="0"/>
              <a:chExt cx="10001734" cy="6869823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-87560" y="18420"/>
                <a:ext cx="10001734" cy="6851403"/>
                <a:chOff x="-87560" y="-38027"/>
                <a:chExt cx="10001734" cy="6851403"/>
              </a:xfrm>
            </p:grpSpPr>
            <p:sp>
              <p:nvSpPr>
                <p:cNvPr id="17" name="Rounded Rectangle 16"/>
                <p:cNvSpPr/>
                <p:nvPr/>
              </p:nvSpPr>
              <p:spPr>
                <a:xfrm>
                  <a:off x="2315185" y="376468"/>
                  <a:ext cx="5678105" cy="3386729"/>
                </a:xfrm>
                <a:prstGeom prst="roundRect">
                  <a:avLst>
                    <a:gd name="adj" fmla="val 15542"/>
                  </a:avLst>
                </a:prstGeom>
                <a:solidFill>
                  <a:schemeClr val="accent5">
                    <a:lumMod val="20000"/>
                    <a:lumOff val="80000"/>
                    <a:alpha val="5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xmlns="" id="{927885E9-4A53-844A-A71B-16C6AF183441}"/>
                    </a:ext>
                  </a:extLst>
                </p:cNvPr>
                <p:cNvSpPr txBox="1"/>
                <p:nvPr/>
              </p:nvSpPr>
              <p:spPr>
                <a:xfrm>
                  <a:off x="4032776" y="389912"/>
                  <a:ext cx="2339102" cy="200055"/>
                </a:xfrm>
                <a:prstGeom prst="rect">
                  <a:avLst/>
                </a:prstGeom>
                <a:noFill/>
              </p:spPr>
              <p:txBody>
                <a:bodyPr wrap="none" tIns="0" bIns="0" rtlCol="0">
                  <a:spAutoFit/>
                </a:bodyPr>
                <a:lstStyle/>
                <a:p>
                  <a:r>
                    <a:rPr lang="en-US" sz="13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entral carbon metabolism</a:t>
                  </a:r>
                </a:p>
              </p:txBody>
            </p:sp>
            <p:grpSp>
              <p:nvGrpSpPr>
                <p:cNvPr id="19" name="Group 18"/>
                <p:cNvGrpSpPr/>
                <p:nvPr/>
              </p:nvGrpSpPr>
              <p:grpSpPr>
                <a:xfrm>
                  <a:off x="-87560" y="-38027"/>
                  <a:ext cx="10001734" cy="6851403"/>
                  <a:chOff x="-87560" y="-26204"/>
                  <a:chExt cx="10001734" cy="6851403"/>
                </a:xfrm>
              </p:grpSpPr>
              <p:grpSp>
                <p:nvGrpSpPr>
                  <p:cNvPr id="20" name="Group 19"/>
                  <p:cNvGrpSpPr/>
                  <p:nvPr/>
                </p:nvGrpSpPr>
                <p:grpSpPr>
                  <a:xfrm>
                    <a:off x="2669867" y="4850764"/>
                    <a:ext cx="1835573" cy="1974435"/>
                    <a:chOff x="2669867" y="4850764"/>
                    <a:chExt cx="1835573" cy="1974435"/>
                  </a:xfrm>
                </p:grpSpPr>
                <p:sp>
                  <p:nvSpPr>
                    <p:cNvPr id="196" name="Rounded Rectangle 195"/>
                    <p:cNvSpPr/>
                    <p:nvPr/>
                  </p:nvSpPr>
                  <p:spPr>
                    <a:xfrm>
                      <a:off x="2669867" y="4850764"/>
                      <a:ext cx="1835573" cy="1746588"/>
                    </a:xfrm>
                    <a:prstGeom prst="roundRect">
                      <a:avLst/>
                    </a:prstGeom>
                    <a:solidFill>
                      <a:schemeClr val="tx1">
                        <a:lumMod val="50000"/>
                        <a:lumOff val="50000"/>
                        <a:alpha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sp>
                  <p:nvSpPr>
                    <p:cNvPr id="197" name="TextBox 196">
                      <a:extLst>
                        <a:ext uri="{FF2B5EF4-FFF2-40B4-BE49-F238E27FC236}">
                          <a16:creationId xmlns:a16="http://schemas.microsoft.com/office/drawing/2014/main" xmlns="" id="{927885E9-4A53-844A-A71B-16C6AF1834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754101" y="4879590"/>
                      <a:ext cx="1697400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tIns="0" bIns="0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-Factors</a:t>
                      </a:r>
                    </a:p>
                    <a:p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98" name="Rectangle 197">
                      <a:extLst>
                        <a:ext uri="{FF2B5EF4-FFF2-40B4-BE49-F238E27FC236}">
                          <a16:creationId xmlns:a16="http://schemas.microsoft.com/office/drawing/2014/main" xmlns="" id="{E51710F5-39EB-F440-A7EA-C387B786D21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2695601" y="5070873"/>
                      <a:ext cx="1755900" cy="1754326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balamin biosynthesis</a:t>
                      </a:r>
                    </a:p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late biosynthesis</a:t>
                      </a:r>
                    </a:p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ybdenum cofactor biosynthesis</a:t>
                      </a:r>
                    </a:p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me and Siroheme</a:t>
                      </a:r>
                    </a:p>
                    <a:p>
                      <a:endParaRPr lang="en-US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171450" indent="-171450">
                        <a:buFont typeface="Arial" panose="020B0604020202020204" pitchFamily="34" charset="0"/>
                        <a:buChar char="•"/>
                      </a:pP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aquinone and Phylloquinone </a:t>
                      </a:r>
                    </a:p>
                    <a:p>
                      <a:endPara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21" name="Group 20"/>
                  <p:cNvGrpSpPr/>
                  <p:nvPr/>
                </p:nvGrpSpPr>
                <p:grpSpPr>
                  <a:xfrm>
                    <a:off x="-87560" y="-26204"/>
                    <a:ext cx="10001734" cy="6623555"/>
                    <a:chOff x="-87560" y="-26204"/>
                    <a:chExt cx="10001734" cy="6623555"/>
                  </a:xfrm>
                </p:grpSpPr>
                <p:sp>
                  <p:nvSpPr>
                    <p:cNvPr id="22" name="Rounded Rectangle 21"/>
                    <p:cNvSpPr/>
                    <p:nvPr/>
                  </p:nvSpPr>
                  <p:spPr>
                    <a:xfrm>
                      <a:off x="4136600" y="4021164"/>
                      <a:ext cx="1835573" cy="547215"/>
                    </a:xfrm>
                    <a:prstGeom prst="roundRect">
                      <a:avLst/>
                    </a:prstGeom>
                    <a:solidFill>
                      <a:schemeClr val="bg1">
                        <a:lumMod val="85000"/>
                        <a:alpha val="50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/>
                    </a:p>
                  </p:txBody>
                </p:sp>
                <p:grpSp>
                  <p:nvGrpSpPr>
                    <p:cNvPr id="23" name="Group 22"/>
                    <p:cNvGrpSpPr/>
                    <p:nvPr/>
                  </p:nvGrpSpPr>
                  <p:grpSpPr>
                    <a:xfrm>
                      <a:off x="-87560" y="-26204"/>
                      <a:ext cx="10001734" cy="6623555"/>
                      <a:chOff x="-87560" y="-26204"/>
                      <a:chExt cx="10001734" cy="6623555"/>
                    </a:xfrm>
                  </p:grpSpPr>
                  <p:sp>
                    <p:nvSpPr>
                      <p:cNvPr id="29" name="Rounded Rectangle 28"/>
                      <p:cNvSpPr/>
                      <p:nvPr/>
                    </p:nvSpPr>
                    <p:spPr>
                      <a:xfrm>
                        <a:off x="8021802" y="-26204"/>
                        <a:ext cx="1892372" cy="3093973"/>
                      </a:xfrm>
                      <a:prstGeom prst="roundRect">
                        <a:avLst/>
                      </a:prstGeom>
                      <a:solidFill>
                        <a:schemeClr val="accent6">
                          <a:lumMod val="40000"/>
                          <a:lumOff val="60000"/>
                          <a:alpha val="50000"/>
                        </a:schemeClr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GB"/>
                      </a:p>
                    </p:txBody>
                  </p:sp>
                  <p:grpSp>
                    <p:nvGrpSpPr>
                      <p:cNvPr id="30" name="Group 29"/>
                      <p:cNvGrpSpPr/>
                      <p:nvPr/>
                    </p:nvGrpSpPr>
                    <p:grpSpPr>
                      <a:xfrm>
                        <a:off x="-87560" y="140987"/>
                        <a:ext cx="10001734" cy="6456364"/>
                        <a:chOff x="-87560" y="140987"/>
                        <a:chExt cx="10001734" cy="6456364"/>
                      </a:xfrm>
                    </p:grpSpPr>
                    <p:grpSp>
                      <p:nvGrpSpPr>
                        <p:cNvPr id="31" name="Group 30"/>
                        <p:cNvGrpSpPr/>
                        <p:nvPr/>
                      </p:nvGrpSpPr>
                      <p:grpSpPr>
                        <a:xfrm>
                          <a:off x="-87560" y="140987"/>
                          <a:ext cx="9911861" cy="6456364"/>
                          <a:chOff x="-87560" y="140987"/>
                          <a:chExt cx="9911861" cy="6456364"/>
                        </a:xfrm>
                      </p:grpSpPr>
                      <p:grpSp>
                        <p:nvGrpSpPr>
                          <p:cNvPr id="51" name="Group 50"/>
                          <p:cNvGrpSpPr/>
                          <p:nvPr/>
                        </p:nvGrpSpPr>
                        <p:grpSpPr>
                          <a:xfrm>
                            <a:off x="-87560" y="140987"/>
                            <a:ext cx="9911861" cy="6456364"/>
                            <a:chOff x="-87560" y="140987"/>
                            <a:chExt cx="9911861" cy="6456364"/>
                          </a:xfrm>
                        </p:grpSpPr>
                        <p:grpSp>
                          <p:nvGrpSpPr>
                            <p:cNvPr id="56" name="Group 55"/>
                            <p:cNvGrpSpPr/>
                            <p:nvPr/>
                          </p:nvGrpSpPr>
                          <p:grpSpPr>
                            <a:xfrm>
                              <a:off x="-87560" y="140987"/>
                              <a:ext cx="9911861" cy="6456364"/>
                              <a:chOff x="-87560" y="140987"/>
                              <a:chExt cx="9911861" cy="6456364"/>
                            </a:xfrm>
                          </p:grpSpPr>
                          <p:grpSp>
                            <p:nvGrpSpPr>
                              <p:cNvPr id="63" name="Group 62"/>
                              <p:cNvGrpSpPr/>
                              <p:nvPr/>
                            </p:nvGrpSpPr>
                            <p:grpSpPr>
                              <a:xfrm>
                                <a:off x="-87560" y="140987"/>
                                <a:ext cx="9911861" cy="6456364"/>
                                <a:chOff x="-87560" y="44624"/>
                                <a:chExt cx="9911861" cy="6456364"/>
                              </a:xfrm>
                            </p:grpSpPr>
                            <p:sp>
                              <p:nvSpPr>
                                <p:cNvPr id="66" name="TextBox 65"/>
                                <p:cNvSpPr txBox="1"/>
                                <p:nvPr/>
                              </p:nvSpPr>
                              <p:spPr>
                                <a:xfrm>
                                  <a:off x="2412571" y="687537"/>
                                  <a:ext cx="630401" cy="24622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Maltose</a:t>
                                  </a:r>
                                </a:p>
                              </p:txBody>
                            </p:sp>
                            <p:sp>
                              <p:nvSpPr>
                                <p:cNvPr id="67" name="TextBox 66"/>
                                <p:cNvSpPr txBox="1"/>
                                <p:nvPr/>
                              </p:nvSpPr>
                              <p:spPr>
                                <a:xfrm>
                                  <a:off x="3197114" y="697721"/>
                                  <a:ext cx="762785" cy="225851"/>
                                </a:xfrm>
                                <a:prstGeom prst="rect">
                                  <a:avLst/>
                                </a:prstGeom>
                                <a:noFill/>
                              </p:spPr>
                              <p:txBody>
                                <a:bodyPr wrap="square" rtlCol="0">
                                  <a:spAutoFit/>
                                </a:bodyPr>
                                <a:lstStyle/>
                                <a:p>
                                  <a:pPr algn="ctr"/>
                                  <a:r>
                                    <a:rPr lang="en-GB" sz="1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rPr>
                                    <a:t>Trehalose</a:t>
                                  </a:r>
                                </a:p>
                              </p:txBody>
                            </p:sp>
                            <p:cxnSp>
                              <p:nvCxnSpPr>
                                <p:cNvPr id="68" name="Straight Arrow Connector 67">
                                  <a:extLst>
                                    <a:ext uri="{FF2B5EF4-FFF2-40B4-BE49-F238E27FC236}">
                                      <a16:creationId xmlns:a16="http://schemas.microsoft.com/office/drawing/2014/main" xmlns="" id="{122EA4EC-1949-8C46-9213-36FBA8C4E38D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16200000">
                                  <a:off x="3101985" y="705895"/>
                                  <a:ext cx="0" cy="229340"/>
                                </a:xfrm>
                                <a:prstGeom prst="straightConnector1">
                                  <a:avLst/>
                                </a:prstGeom>
                                <a:ln w="1270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cxnSp>
                              <p:nvCxnSpPr>
                                <p:cNvPr id="69" name="Straight Arrow Connector 68">
                                  <a:extLst>
                                    <a:ext uri="{FF2B5EF4-FFF2-40B4-BE49-F238E27FC236}">
                                      <a16:creationId xmlns:a16="http://schemas.microsoft.com/office/drawing/2014/main" xmlns="" id="{122EA4EC-1949-8C46-9213-36FBA8C4E38D}"/>
                                    </a:ext>
                                  </a:extLst>
                                </p:cNvPr>
                                <p:cNvCxnSpPr>
                                  <a:cxnSpLocks/>
                                </p:cNvCxnSpPr>
                                <p:nvPr/>
                              </p:nvCxnSpPr>
                              <p:spPr>
                                <a:xfrm rot="16200000">
                                  <a:off x="4036897" y="705895"/>
                                  <a:ext cx="0" cy="229340"/>
                                </a:xfrm>
                                <a:prstGeom prst="straightConnector1">
                                  <a:avLst/>
                                </a:prstGeom>
                                <a:ln w="12700">
                                  <a:solidFill>
                                    <a:schemeClr val="tx1"/>
                                  </a:solidFill>
                                  <a:tailEnd type="triangle"/>
                                </a:ln>
                              </p:spPr>
                              <p:style>
                                <a:lnRef idx="1">
                                  <a:schemeClr val="accent1"/>
                                </a:lnRef>
                                <a:fillRef idx="0">
                                  <a:schemeClr val="accent1"/>
                                </a:fillRef>
                                <a:effectRef idx="0">
                                  <a:schemeClr val="accent1"/>
                                </a:effectRef>
                                <a:fontRef idx="minor">
                                  <a:schemeClr val="tx1"/>
                                </a:fontRef>
                              </p:style>
                            </p:cxnSp>
                            <p:grpSp>
                              <p:nvGrpSpPr>
                                <p:cNvPr id="70" name="Group 69"/>
                                <p:cNvGrpSpPr/>
                                <p:nvPr/>
                              </p:nvGrpSpPr>
                              <p:grpSpPr>
                                <a:xfrm>
                                  <a:off x="-87560" y="44624"/>
                                  <a:ext cx="9911861" cy="6456364"/>
                                  <a:chOff x="-70268" y="44624"/>
                                  <a:chExt cx="9911861" cy="6456364"/>
                                </a:xfrm>
                              </p:grpSpPr>
                              <p:grpSp>
                                <p:nvGrpSpPr>
                                  <p:cNvPr id="71" name="Group 70"/>
                                  <p:cNvGrpSpPr/>
                                  <p:nvPr/>
                                </p:nvGrpSpPr>
                                <p:grpSpPr>
                                  <a:xfrm>
                                    <a:off x="-70268" y="44624"/>
                                    <a:ext cx="9911861" cy="6456364"/>
                                    <a:chOff x="-134325" y="44624"/>
                                    <a:chExt cx="9911861" cy="6456364"/>
                                  </a:xfrm>
                                </p:grpSpPr>
                                <p:sp>
                                  <p:nvSpPr>
                                    <p:cNvPr id="75" name="TextBox 74"/>
                                    <p:cNvSpPr txBox="1"/>
                                    <p:nvPr/>
                                  </p:nvSpPr>
                                  <p:spPr>
                                    <a:xfrm>
                                      <a:off x="5391065" y="3740681"/>
                                      <a:ext cx="643741" cy="400110"/>
                                    </a:xfrm>
                                    <a:prstGeom prst="rect">
                                      <a:avLst/>
                                    </a:prstGeom>
                                    <a:noFill/>
                                  </p:spPr>
                                  <p:txBody>
                                    <a:bodyPr wrap="square" rtlCol="0">
                                      <a:spAutoFit/>
                                    </a:bodyPr>
                                    <a:lstStyle/>
                                    <a:p>
                                      <a:pPr algn="ctr"/>
                                      <a:r>
                                        <a:rPr lang="en-GB" sz="1000" dirty="0"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  <a:cs typeface="Arial" panose="020B0604020202020204" pitchFamily="34" charset="0"/>
                                        </a:rPr>
                                        <a:t>CO</a:t>
                                      </a:r>
                                      <a:r>
                                        <a:rPr lang="en-GB" sz="1000" baseline="-25000" dirty="0"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  <a:cs typeface="Arial" panose="020B0604020202020204" pitchFamily="34" charset="0"/>
                                        </a:rPr>
                                        <a:t>2, </a:t>
                                      </a:r>
                                      <a:r>
                                        <a:rPr lang="en-GB" sz="1000" dirty="0"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  <a:cs typeface="Arial" panose="020B0604020202020204" pitchFamily="34" charset="0"/>
                                        </a:rPr>
                                        <a:t>NH</a:t>
                                      </a:r>
                                      <a:r>
                                        <a:rPr lang="en-GB" sz="1000" baseline="-25000" dirty="0">
                                          <a:solidFill>
                                            <a:srgbClr val="000000"/>
                                          </a:solidFill>
                                          <a:effectLst/>
                                          <a:latin typeface="Arial" panose="020B0604020202020204" pitchFamily="34" charset="0"/>
                                          <a:cs typeface="Arial" panose="020B0604020202020204" pitchFamily="34" charset="0"/>
                                        </a:rPr>
                                        <a:t>3</a:t>
                                      </a:r>
                                      <a:endParaRPr lang="en-GB" sz="1000" dirty="0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endParaRPr>
                                    </a:p>
                                  </p:txBody>
                                </p:sp>
                                <p:cxnSp>
                                  <p:nvCxnSpPr>
                                    <p:cNvPr id="76" name="Straight Arrow Connector 75">
                                      <a:extLst>
                                        <a:ext uri="{FF2B5EF4-FFF2-40B4-BE49-F238E27FC236}">
                                          <a16:creationId xmlns:a16="http://schemas.microsoft.com/office/drawing/2014/main" xmlns="" id="{122EA4EC-1949-8C46-9213-36FBA8C4E38D}"/>
                                        </a:ext>
                                      </a:extLst>
                                    </p:cNvPr>
                                    <p:cNvCxnSpPr>
                                      <a:cxnSpLocks/>
                                    </p:cNvCxnSpPr>
                                    <p:nvPr/>
                                  </p:nvCxnSpPr>
                                  <p:spPr>
                                    <a:xfrm rot="16200000">
                                      <a:off x="3963680" y="2903741"/>
                                      <a:ext cx="0" cy="1116000"/>
                                    </a:xfrm>
                                    <a:prstGeom prst="straightConnector1">
                                      <a:avLst/>
                                    </a:prstGeom>
                                    <a:ln w="12700">
                                      <a:solidFill>
                                        <a:schemeClr val="tx1"/>
                                      </a:solidFill>
                                      <a:tailEnd type="triangle"/>
                                    </a:ln>
                                  </p:spPr>
                                  <p:style>
                                    <a:lnRef idx="1">
                                      <a:schemeClr val="accent1"/>
                                    </a:lnRef>
                                    <a:fillRef idx="0">
                                      <a:schemeClr val="accent1"/>
                                    </a:fillRef>
                                    <a:effectRef idx="0">
                                      <a:schemeClr val="accent1"/>
                                    </a:effectRef>
                                    <a:fontRef idx="minor">
                                      <a:schemeClr val="tx1"/>
                                    </a:fontRef>
                                  </p:style>
                                </p:cxnSp>
                                <p:grpSp>
                                  <p:nvGrpSpPr>
                                    <p:cNvPr id="77" name="Group 76"/>
                                    <p:cNvGrpSpPr/>
                                    <p:nvPr/>
                                  </p:nvGrpSpPr>
                                  <p:grpSpPr>
                                    <a:xfrm>
                                      <a:off x="-134325" y="44624"/>
                                      <a:ext cx="9911861" cy="6456364"/>
                                      <a:chOff x="-102263" y="44624"/>
                                      <a:chExt cx="9911861" cy="6456364"/>
                                    </a:xfrm>
                                  </p:grpSpPr>
                                  <p:grpSp>
                                    <p:nvGrpSpPr>
                                      <p:cNvPr id="78" name="Group 77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2337995" y="528517"/>
                                        <a:ext cx="5732870" cy="4604320"/>
                                        <a:chOff x="2337995" y="528517"/>
                                        <a:chExt cx="5732870" cy="4604320"/>
                                      </a:xfrm>
                                    </p:grpSpPr>
                                    <p:grpSp>
                                      <p:nvGrpSpPr>
                                        <p:cNvPr id="133" name="Group 132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2337995" y="528517"/>
                                          <a:ext cx="5732870" cy="2340763"/>
                                          <a:chOff x="2337995" y="528517"/>
                                          <a:chExt cx="5732870" cy="2340763"/>
                                        </a:xfrm>
                                      </p:grpSpPr>
                                      <p:grpSp>
                                        <p:nvGrpSpPr>
                                          <p:cNvPr id="150" name="Group 149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2337995" y="528517"/>
                                            <a:ext cx="5686722" cy="2340763"/>
                                            <a:chOff x="1763192" y="636026"/>
                                            <a:chExt cx="5686722" cy="2340763"/>
                                          </a:xfrm>
                                        </p:grpSpPr>
                                        <p:grpSp>
                                          <p:nvGrpSpPr>
                                            <p:cNvPr id="153" name="Group 152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1763192" y="636026"/>
                                              <a:ext cx="5686722" cy="2340763"/>
                                              <a:chOff x="1828147" y="636026"/>
                                              <a:chExt cx="5686722" cy="2340763"/>
                                            </a:xfrm>
                                          </p:grpSpPr>
                                          <p:grpSp>
                                            <p:nvGrpSpPr>
                                              <p:cNvPr id="157" name="Group 156"/>
                                              <p:cNvGrpSpPr/>
                                              <p:nvPr/>
                                            </p:nvGrpSpPr>
                                            <p:grpSpPr>
                                              <a:xfrm>
                                                <a:off x="1828147" y="636026"/>
                                                <a:ext cx="5686722" cy="2340763"/>
                                                <a:chOff x="1631906" y="585521"/>
                                                <a:chExt cx="5686722" cy="2340763"/>
                                              </a:xfrm>
                                            </p:grpSpPr>
                                            <p:grpSp>
                                              <p:nvGrpSpPr>
                                                <p:cNvPr id="159" name="Group 158"/>
                                                <p:cNvGrpSpPr/>
                                                <p:nvPr/>
                                              </p:nvGrpSpPr>
                                              <p:grpSpPr>
                                                <a:xfrm>
                                                  <a:off x="1631906" y="585521"/>
                                                  <a:ext cx="4618843" cy="2340763"/>
                                                  <a:chOff x="2135962" y="441505"/>
                                                  <a:chExt cx="4618843" cy="2340763"/>
                                                </a:xfrm>
                                              </p:grpSpPr>
                                              <p:grpSp>
                                                <p:nvGrpSpPr>
                                                  <p:cNvPr id="164" name="Group 163"/>
                                                  <p:cNvGrpSpPr/>
                                                  <p:nvPr/>
                                                </p:nvGrpSpPr>
                                                <p:grpSpPr>
                                                  <a:xfrm>
                                                    <a:off x="2135962" y="441505"/>
                                                    <a:ext cx="4618843" cy="2340763"/>
                                                    <a:chOff x="2124832" y="441505"/>
                                                    <a:chExt cx="4618843" cy="2340763"/>
                                                  </a:xfrm>
                                                </p:grpSpPr>
                                                <p:grpSp>
                                                  <p:nvGrpSpPr>
                                                    <p:cNvPr id="167" name="Group 166"/>
                                                    <p:cNvGrpSpPr/>
                                                    <p:nvPr/>
                                                  </p:nvGrpSpPr>
                                                  <p:grpSpPr>
                                                    <a:xfrm>
                                                      <a:off x="2124832" y="441505"/>
                                                      <a:ext cx="4618843" cy="2340763"/>
                                                      <a:chOff x="2124832" y="528705"/>
                                                      <a:chExt cx="4618843" cy="2340763"/>
                                                    </a:xfrm>
                                                  </p:grpSpPr>
                                                  <p:grpSp>
                                                    <p:nvGrpSpPr>
                                                      <p:cNvPr id="169" name="Group 168"/>
                                                      <p:cNvGrpSpPr/>
                                                      <p:nvPr/>
                                                    </p:nvGrpSpPr>
                                                    <p:grpSpPr>
                                                      <a:xfrm>
                                                        <a:off x="3568600" y="1106376"/>
                                                        <a:ext cx="3175075" cy="1763092"/>
                                                        <a:chOff x="3568600" y="853657"/>
                                                        <a:chExt cx="3175075" cy="1763092"/>
                                                      </a:xfrm>
                                                    </p:grpSpPr>
                                                    <p:grpSp>
                                                      <p:nvGrpSpPr>
                                                        <p:cNvPr id="173" name="Group 172"/>
                                                        <p:cNvGrpSpPr/>
                                                        <p:nvPr/>
                                                      </p:nvGrpSpPr>
                                                      <p:grpSpPr>
                                                        <a:xfrm>
                                                          <a:off x="3687988" y="1362416"/>
                                                          <a:ext cx="3055687" cy="1254333"/>
                                                          <a:chOff x="3687988" y="888557"/>
                                                          <a:chExt cx="3055687" cy="1254333"/>
                                                        </a:xfrm>
                                                      </p:grpSpPr>
                                                      <p:grpSp>
                                                        <p:nvGrpSpPr>
                                                          <p:cNvPr id="177" name="Group 176"/>
                                                          <p:cNvGrpSpPr/>
                                                          <p:nvPr/>
                                                        </p:nvGrpSpPr>
                                                        <p:grpSpPr>
                                                          <a:xfrm>
                                                            <a:off x="3791930" y="888557"/>
                                                            <a:ext cx="2951745" cy="1254333"/>
                                                            <a:chOff x="4052900" y="888557"/>
                                                            <a:chExt cx="2951745" cy="1254333"/>
                                                          </a:xfrm>
                                                        </p:grpSpPr>
                                                        <p:sp>
                                                          <p:nvSpPr>
                                                            <p:cNvPr id="179" name="TextBox 178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4151387" y="888557"/>
                                                              <a:ext cx="726599" cy="246221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en-GB" sz="1000" dirty="0">
                                                                  <a:latin typeface="Arial" panose="020B0604020202020204" pitchFamily="34" charset="0"/>
                                                                  <a:cs typeface="Arial" panose="020B0604020202020204" pitchFamily="34" charset="0"/>
                                                                </a:rPr>
                                                                <a:t>Pyruvate</a:t>
                                                              </a:r>
                                                              <a:endParaRPr lang="en-GB" sz="1000" baseline="30000" dirty="0">
                                                                <a:latin typeface="Arial" panose="020B0604020202020204" pitchFamily="34" charset="0"/>
                                                                <a:cs typeface="Arial" panose="020B0604020202020204" pitchFamily="34" charset="0"/>
                                                              </a:endParaRPr>
                                                            </a:p>
                                                          </p:txBody>
                                                        </p:sp>
                                                        <p:sp>
                                                          <p:nvSpPr>
                                                            <p:cNvPr id="180" name="TextBox 179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4052900" y="1424524"/>
                                                              <a:ext cx="923571" cy="246221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en-GB" sz="1000" dirty="0">
                                                                  <a:latin typeface="Arial" panose="020B0604020202020204" pitchFamily="34" charset="0"/>
                                                                  <a:cs typeface="Arial" panose="020B0604020202020204" pitchFamily="34" charset="0"/>
                                                                </a:rPr>
                                                                <a:t>Acetyl-CoA</a:t>
                                                              </a:r>
                                                              <a:endParaRPr lang="en-GB" sz="1000" baseline="30000" dirty="0">
                                                                <a:latin typeface="Arial" panose="020B0604020202020204" pitchFamily="34" charset="0"/>
                                                                <a:cs typeface="Arial" panose="020B0604020202020204" pitchFamily="34" charset="0"/>
                                                              </a:endParaRPr>
                                                            </a:p>
                                                          </p:txBody>
                                                        </p:sp>
                                                        <p:cxnSp>
                                                          <p:nvCxnSpPr>
                                                            <p:cNvPr id="181" name="Straight Arrow Connector 180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5F2A7D59-96EB-2D47-A0DA-7B57F918B72D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4439419" y="1134778"/>
                                                              <a:ext cx="0" cy="236801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/>
                                                              <a:tailEnd type="non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82" name="Straight Arrow Connector 181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122EA4EC-1949-8C46-9213-36FBA8C4E38D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4572796" y="1147001"/>
                                                              <a:ext cx="0" cy="229340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tailEnd type="triangl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sp>
                                                          <p:nvSpPr>
                                                            <p:cNvPr id="183" name="TextBox 182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5205003" y="1178303"/>
                                                              <a:ext cx="923571" cy="246221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en-GB" sz="1000" dirty="0">
                                                                  <a:latin typeface="Arial" panose="020B0604020202020204" pitchFamily="34" charset="0"/>
                                                                  <a:cs typeface="Arial" panose="020B0604020202020204" pitchFamily="34" charset="0"/>
                                                                </a:rPr>
                                                                <a:t>Acetyl-P</a:t>
                                                              </a:r>
                                                              <a:endParaRPr lang="en-GB" sz="1000" baseline="30000" dirty="0">
                                                                <a:latin typeface="Arial" panose="020B0604020202020204" pitchFamily="34" charset="0"/>
                                                                <a:cs typeface="Arial" panose="020B0604020202020204" pitchFamily="34" charset="0"/>
                                                              </a:endParaRPr>
                                                            </a:p>
                                                          </p:txBody>
                                                        </p:sp>
                                                        <p:sp>
                                                          <p:nvSpPr>
                                                            <p:cNvPr id="184" name="Right Brace 183"/>
                                                            <p:cNvSpPr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4931697" y="1011666"/>
                                                              <a:ext cx="155794" cy="562003"/>
                                                            </a:xfrm>
                                                            <a:prstGeom prst="rightBrace">
                                                              <a:avLst>
                                                                <a:gd name="adj1" fmla="val 74454"/>
                                                                <a:gd name="adj2" fmla="val 50372"/>
                                                              </a:avLst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none" w="sm" len="med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  <p:txBody>
                                                            <a:bodyPr rtlCol="0" anchor="ctr"/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endParaRPr lang="en-GB"/>
                                                            </a:p>
                                                          </p:txBody>
                                                        </p:sp>
                                                        <p:cxnSp>
                                                          <p:nvCxnSpPr>
                                                            <p:cNvPr id="185" name="Straight Arrow Connector 184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122EA4EC-1949-8C46-9213-36FBA8C4E38D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 rot="16200000">
                                                              <a:off x="5248423" y="1186743"/>
                                                              <a:ext cx="0" cy="229340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tailEnd type="triangl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sp>
                                                          <p:nvSpPr>
                                                            <p:cNvPr id="186" name="TextBox 185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6081074" y="1170485"/>
                                                              <a:ext cx="923571" cy="246221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en-GB" sz="1000" dirty="0">
                                                                  <a:latin typeface="Arial" panose="020B0604020202020204" pitchFamily="34" charset="0"/>
                                                                  <a:cs typeface="Arial" panose="020B0604020202020204" pitchFamily="34" charset="0"/>
                                                                </a:rPr>
                                                                <a:t>Acetate</a:t>
                                                              </a:r>
                                                              <a:endParaRPr lang="en-GB" sz="1000" baseline="30000" dirty="0">
                                                                <a:latin typeface="Arial" panose="020B0604020202020204" pitchFamily="34" charset="0"/>
                                                                <a:cs typeface="Arial" panose="020B0604020202020204" pitchFamily="34" charset="0"/>
                                                              </a:endParaRPr>
                                                            </a:p>
                                                          </p:txBody>
                                                        </p:sp>
                                                        <p:cxnSp>
                                                          <p:nvCxnSpPr>
                                                            <p:cNvPr id="187" name="Straight Arrow Connector 186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122EA4EC-1949-8C46-9213-36FBA8C4E38D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 rot="16200000">
                                                              <a:off x="6104824" y="1182024"/>
                                                              <a:ext cx="0" cy="229340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tailEnd type="triangl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88" name="Straight Arrow Connector 187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D1700605-9024-8348-81FB-068D4CA932EA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6495359" y="1393108"/>
                                                              <a:ext cx="0" cy="422913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/>
                                                              <a:tailEnd type="non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89" name="Straight Connector 188"/>
                                                            <p:cNvCxnSpPr/>
                                                            <p:nvPr/>
                                                          </p:nvCxnSpPr>
                                                          <p:spPr>
                                                            <a:xfrm flipV="1">
                                                              <a:off x="4520680" y="1816021"/>
                                                              <a:ext cx="1980000" cy="1"/>
                                                            </a:xfrm>
                                                            <a:prstGeom prst="line">
                                                              <a:avLst/>
                                                            </a:prstGeom>
                                                            <a:ln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90" name="Straight Connector 189"/>
                                                            <p:cNvCxnSpPr/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4514686" y="1670745"/>
                                                              <a:ext cx="0" cy="137325"/>
                                                            </a:xfrm>
                                                            <a:prstGeom prst="line">
                                                              <a:avLst/>
                                                            </a:prstGeom>
                                                            <a:ln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 w="med" len="med"/>
                                                              <a:tailEnd type="none" w="med" len="med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sp>
                                                          <p:nvSpPr>
                                                            <p:cNvPr id="191" name="TextBox 190"/>
                                                            <p:cNvSpPr txBox="1"/>
                                                            <p:nvPr/>
                                                          </p:nvSpPr>
                                                          <p:spPr>
                                                            <a:xfrm>
                                                              <a:off x="5182025" y="1896669"/>
                                                              <a:ext cx="965446" cy="246221"/>
                                                            </a:xfrm>
                                                            <a:prstGeom prst="rect">
                                                              <a:avLst/>
                                                            </a:prstGeom>
                                                            <a:noFill/>
                                                          </p:spPr>
                                                          <p:txBody>
                                                            <a:bodyPr wrap="square" rtlCol="0">
                                                              <a:spAutoFit/>
                                                            </a:bodyPr>
                                                            <a:lstStyle/>
                                                            <a:p>
                                                              <a:pPr algn="ctr"/>
                                                              <a:r>
                                                                <a:rPr lang="en-GB" sz="1000" dirty="0">
                                                                  <a:latin typeface="Arial" panose="020B0604020202020204" pitchFamily="34" charset="0"/>
                                                                  <a:cs typeface="Arial" panose="020B0604020202020204" pitchFamily="34" charset="0"/>
                                                                </a:rPr>
                                                                <a:t>Acetaldehyde</a:t>
                                                              </a:r>
                                                              <a:endParaRPr lang="en-GB" sz="1000" baseline="30000" dirty="0">
                                                                <a:latin typeface="Arial" panose="020B0604020202020204" pitchFamily="34" charset="0"/>
                                                                <a:cs typeface="Arial" panose="020B0604020202020204" pitchFamily="34" charset="0"/>
                                                              </a:endParaRPr>
                                                            </a:p>
                                                          </p:txBody>
                                                        </p:sp>
                                                        <p:cxnSp>
                                                          <p:nvCxnSpPr>
                                                            <p:cNvPr id="192" name="Straight Connector 191"/>
                                                            <p:cNvCxnSpPr/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4403794" y="1663585"/>
                                                              <a:ext cx="0" cy="360000"/>
                                                            </a:xfrm>
                                                            <a:prstGeom prst="line">
                                                              <a:avLst/>
                                                            </a:prstGeom>
                                                            <a:ln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 w="med" len="med"/>
                                                              <a:tailEnd type="none" w="med" len="med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93" name="Straight Arrow Connector 192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122EA4EC-1949-8C46-9213-36FBA8C4E38D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4407717" y="2027731"/>
                                                              <a:ext cx="792000" cy="0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tailEnd type="triangl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94" name="Straight Arrow Connector 193">
                                                              <a:extLst>
                                                                <a:ext uri="{FF2B5EF4-FFF2-40B4-BE49-F238E27FC236}">
                                                                  <a16:creationId xmlns:a16="http://schemas.microsoft.com/office/drawing/2014/main" xmlns="" id="{D1700605-9024-8348-81FB-068D4CA932EA}"/>
                                                                </a:ext>
                                                              </a:extLst>
                                                            </p:cNvPr>
                                                            <p:cNvCxnSpPr>
                                                              <a:cxnSpLocks/>
                                                            </p:cNvCxnSpPr>
                                                            <p:nvPr/>
                                                          </p:nvCxnSpPr>
                                                          <p:spPr>
                                                            <a:xfrm>
                                                              <a:off x="6647759" y="1383454"/>
                                                              <a:ext cx="0" cy="648000"/>
                                                            </a:xfrm>
                                                            <a:prstGeom prst="straightConnector1">
                                                              <a:avLst/>
                                                            </a:prstGeom>
                                                            <a:ln w="12700"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/>
                                                              <a:tailEnd type="none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  <p:cxnSp>
                                                          <p:nvCxnSpPr>
                                                            <p:cNvPr id="195" name="Straight Connector 194"/>
                                                            <p:cNvCxnSpPr/>
                                                            <p:nvPr/>
                                                          </p:nvCxnSpPr>
                                                          <p:spPr>
                                                            <a:xfrm flipV="1">
                                                              <a:off x="6125557" y="2025230"/>
                                                              <a:ext cx="522202" cy="2"/>
                                                            </a:xfrm>
                                                            <a:prstGeom prst="line">
                                                              <a:avLst/>
                                                            </a:prstGeom>
                                                            <a:ln>
                                                              <a:solidFill>
                                                                <a:schemeClr val="tx1"/>
                                                              </a:solidFill>
                                                              <a:headEnd type="triangle" w="med" len="med"/>
                                                              <a:tailEnd type="none" w="med" len="med"/>
                                                            </a:ln>
                                                          </p:spPr>
                                                          <p:style>
                                                            <a:lnRef idx="1">
                                                              <a:schemeClr val="accent1"/>
                                                            </a:lnRef>
                                                            <a:fillRef idx="0">
                                                              <a:schemeClr val="accent1"/>
                                                            </a:fillRef>
                                                            <a:effectRef idx="0">
                                                              <a:schemeClr val="accent1"/>
                                                            </a:effectRef>
                                                            <a:fontRef idx="minor">
                                                              <a:schemeClr val="tx1"/>
                                                            </a:fontRef>
                                                          </p:style>
                                                        </p:cxnSp>
                                                      </p:grpSp>
                                                      <p:cxnSp>
                                                        <p:nvCxnSpPr>
                                                          <p:cNvPr id="178" name="Straight Arrow Connector 177">
                                                            <a:extLst>
                                                              <a:ext uri="{FF2B5EF4-FFF2-40B4-BE49-F238E27FC236}">
                                                                <a16:creationId xmlns:a16="http://schemas.microsoft.com/office/drawing/2014/main" xmlns="" id="{122EA4EC-1949-8C46-9213-36FBA8C4E38D}"/>
                                                              </a:ext>
                                                            </a:extLst>
                                                          </p:cNvPr>
                                                          <p:cNvCxnSpPr>
                                                            <a:cxnSpLocks/>
                                                          </p:cNvCxnSpPr>
                                                          <p:nvPr/>
                                                        </p:nvCxnSpPr>
                                                        <p:spPr>
                                                          <a:xfrm rot="16200000">
                                                            <a:off x="3802658" y="873246"/>
                                                            <a:ext cx="0" cy="229340"/>
                                                          </a:xfrm>
                                                          <a:prstGeom prst="straightConnector1">
                                                            <a:avLst/>
                                                          </a:prstGeom>
                                                          <a:ln w="12700">
                                                            <a:solidFill>
                                                              <a:schemeClr val="tx1"/>
                                                            </a:solidFill>
                                                            <a:tailEnd type="triangle"/>
                                                          </a:ln>
                                                        </p:spPr>
                                                        <p:style>
                                                          <a:lnRef idx="1">
                                                            <a:schemeClr val="accent1"/>
                                                          </a:lnRef>
                                                          <a:fillRef idx="0">
                                                            <a:schemeClr val="accent1"/>
                                                          </a:fillRef>
                                                          <a:effectRef idx="0">
                                                            <a:schemeClr val="accent1"/>
                                                          </a:effectRef>
                                                          <a:fontRef idx="minor">
                                                            <a:schemeClr val="tx1"/>
                                                          </a:fontRef>
                                                        </p:style>
                                                      </p:cxnSp>
                                                    </p:grpSp>
                                                    <p:cxnSp>
                                                      <p:nvCxnSpPr>
                                                        <p:cNvPr id="174" name="Straight Arrow Connector 173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xmlns="" id="{5F2A7D59-96EB-2D47-A0DA-7B57F918B72D}"/>
                                                            </a:ext>
                                                          </a:extLst>
                                                        </p:cNvPr>
                                                        <p:cNvCxnSpPr>
                                                          <a:cxnSpLocks/>
                                                        </p:cNvCxnSpPr>
                                                        <p:nvPr/>
                                                      </p:nvCxnSpPr>
                                                      <p:spPr>
                                                        <a:xfrm>
                                                          <a:off x="4197472" y="1099805"/>
                                                          <a:ext cx="0" cy="236801"/>
                                                        </a:xfrm>
                                                        <a:prstGeom prst="straightConnector1">
                                                          <a:avLst/>
                                                        </a:prstGeom>
                                                        <a:ln w="12700">
                                                          <a:solidFill>
                                                            <a:schemeClr val="tx1"/>
                                                          </a:solidFill>
                                                          <a:headEnd type="triangle"/>
                                                          <a:tailEnd type="none"/>
                                                        </a:ln>
                                                      </p:spPr>
                                                      <p:style>
                                                        <a:lnRef idx="1">
                                                          <a:schemeClr val="accent1"/>
                                                        </a:lnRef>
                                                        <a:fillRef idx="0">
                                                          <a:schemeClr val="accent1"/>
                                                        </a:fillRef>
                                                        <a:effectRef idx="0">
                                                          <a:schemeClr val="accent1"/>
                                                        </a:effectRef>
                                                        <a:fontRef idx="minor">
                                                          <a:schemeClr val="tx1"/>
                                                        </a:fontRef>
                                                      </p:style>
                                                    </p:cxnSp>
                                                    <p:cxnSp>
                                                      <p:nvCxnSpPr>
                                                        <p:cNvPr id="175" name="Straight Arrow Connector 174">
                                                          <a:extLst>
                                                            <a:ext uri="{FF2B5EF4-FFF2-40B4-BE49-F238E27FC236}">
                                                              <a16:creationId xmlns:a16="http://schemas.microsoft.com/office/drawing/2014/main" xmlns="" id="{122EA4EC-1949-8C46-9213-36FBA8C4E38D}"/>
                                                            </a:ext>
                                                          </a:extLst>
                                                        </p:cNvPr>
                                                        <p:cNvCxnSpPr>
                                                          <a:cxnSpLocks/>
                                                        </p:cNvCxnSpPr>
                                                        <p:nvPr/>
                                                      </p:nvCxnSpPr>
                                                      <p:spPr>
                                                        <a:xfrm>
                                                          <a:off x="4330849" y="1112028"/>
                                                          <a:ext cx="0" cy="229340"/>
                                                        </a:xfrm>
                                                        <a:prstGeom prst="straightConnector1">
                                                          <a:avLst/>
                                                        </a:prstGeom>
                                                        <a:ln w="12700">
                                                          <a:solidFill>
                                                            <a:schemeClr val="tx1"/>
                                                          </a:solidFill>
                                                          <a:tailEnd type="triangle"/>
                                                        </a:ln>
                                                      </p:spPr>
                                                      <p:style>
                                                        <a:lnRef idx="1">
                                                          <a:schemeClr val="accent1"/>
                                                        </a:lnRef>
                                                        <a:fillRef idx="0">
                                                          <a:schemeClr val="accent1"/>
                                                        </a:fillRef>
                                                        <a:effectRef idx="0">
                                                          <a:schemeClr val="accent1"/>
                                                        </a:effectRef>
                                                        <a:fontRef idx="minor">
                                                          <a:schemeClr val="tx1"/>
                                                        </a:fontRef>
                                                      </p:style>
                                                    </p:cxnSp>
                                                    <p:sp>
                                                      <p:nvSpPr>
                                                        <p:cNvPr id="176" name="TextBox 175"/>
                                                        <p:cNvSpPr txBox="1"/>
                                                        <p:nvPr/>
                                                      </p:nvSpPr>
                                                      <p:spPr>
                                                        <a:xfrm>
                                                          <a:off x="3568600" y="853657"/>
                                                          <a:ext cx="1486451" cy="246221"/>
                                                        </a:xfrm>
                                                        <a:prstGeom prst="rect">
                                                          <a:avLst/>
                                                        </a:prstGeom>
                                                        <a:noFill/>
                                                      </p:spPr>
                                                      <p:txBody>
                                                        <a:bodyPr wrap="square" rtlCol="0">
                                                          <a:spAutoFit/>
                                                        </a:bodyPr>
                                                        <a:lstStyle/>
                                                        <a:p>
                                                          <a:pPr algn="ctr"/>
                                                          <a:r>
                                                            <a:rPr lang="en-GB" sz="1000" dirty="0">
                                                              <a:latin typeface="Arial" panose="020B0604020202020204" pitchFamily="34" charset="0"/>
                                                              <a:cs typeface="Arial" panose="020B0604020202020204" pitchFamily="34" charset="0"/>
                                                            </a:rPr>
                                                            <a:t>Phosphoenolpyruvate</a:t>
                                                          </a:r>
                                                          <a:endParaRPr lang="en-GB" sz="1000" baseline="30000" dirty="0">
                                                            <a:latin typeface="Arial" panose="020B0604020202020204" pitchFamily="34" charset="0"/>
                                                            <a:cs typeface="Arial" panose="020B0604020202020204" pitchFamily="34" charset="0"/>
                                                          </a:endParaRPr>
                                                        </a:p>
                                                      </p:txBody>
                                                    </p:sp>
                                                  </p:grpSp>
                                                  <p:sp>
                                                    <p:nvSpPr>
                                                      <p:cNvPr id="170" name="TextBox 169"/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3763262" y="528705"/>
                                                        <a:ext cx="1015266" cy="400110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squar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pPr algn="ctr"/>
                                                        <a:r>
                                                          <a:rPr lang="en-GB" sz="1000" b="1" dirty="0">
                                                            <a:latin typeface="Arial" panose="020B0604020202020204" pitchFamily="34" charset="0"/>
                                                            <a:cs typeface="Arial" panose="020B0604020202020204" pitchFamily="34" charset="0"/>
                                                          </a:rPr>
                                                          <a:t>Glycolysis</a:t>
                                                        </a:r>
                                                      </a:p>
                                                      <a:p>
                                                        <a:pPr algn="ctr"/>
                                                        <a:r>
                                                          <a:rPr lang="en-GB" sz="1000" b="1" dirty="0">
                                                            <a:latin typeface="Arial" panose="020B0604020202020204" pitchFamily="34" charset="0"/>
                                                            <a:cs typeface="Arial" panose="020B0604020202020204" pitchFamily="34" charset="0"/>
                                                          </a:rPr>
                                                          <a:t>Glucose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  <p:cxnSp>
                                                    <p:nvCxnSpPr>
                                                      <p:cNvPr id="171" name="Straight Arrow Connector 170">
                                                        <a:extLst>
                                                          <a:ext uri="{FF2B5EF4-FFF2-40B4-BE49-F238E27FC236}">
                                                            <a16:creationId xmlns:a16="http://schemas.microsoft.com/office/drawing/2014/main" xmlns="" id="{122EA4EC-1949-8C46-9213-36FBA8C4E38D}"/>
                                                          </a:ext>
                                                        </a:extLst>
                                                      </p:cNvPr>
                                                      <p:cNvCxnSpPr>
                                                        <a:cxnSpLocks/>
                                                      </p:cNvCxnSpPr>
                                                      <p:nvPr/>
                                                    </p:nvCxnSpPr>
                                                    <p:spPr>
                                                      <a:xfrm>
                                                        <a:off x="4270895" y="920948"/>
                                                        <a:ext cx="0" cy="229340"/>
                                                      </a:xfrm>
                                                      <a:prstGeom prst="straightConnector1">
                                                        <a:avLst/>
                                                      </a:prstGeom>
                                                      <a:ln w="12700">
                                                        <a:solidFill>
                                                          <a:schemeClr val="tx1"/>
                                                        </a:solidFill>
                                                        <a:tailEnd type="triangle"/>
                                                      </a:ln>
                                                    </p:spPr>
                                                    <p:style>
                                                      <a:lnRef idx="1">
                                                        <a:schemeClr val="accent1"/>
                                                      </a:lnRef>
                                                      <a:fillRef idx="0">
                                                        <a:schemeClr val="accent1"/>
                                                      </a:fillRef>
                                                      <a:effectRef idx="0">
                                                        <a:schemeClr val="accent1"/>
                                                      </a:effectRef>
                                                      <a:fontRef idx="minor">
                                                        <a:schemeClr val="tx1"/>
                                                      </a:fontRef>
                                                    </p:style>
                                                  </p:cxnSp>
                                                  <p:sp>
                                                    <p:nvSpPr>
                                                      <p:cNvPr id="172" name="TextBox 171"/>
                                                      <p:cNvSpPr txBox="1"/>
                                                      <p:nvPr/>
                                                    </p:nvSpPr>
                                                    <p:spPr>
                                                      <a:xfrm>
                                                        <a:off x="2124832" y="1104581"/>
                                                        <a:ext cx="1384419" cy="246221"/>
                                                      </a:xfrm>
                                                      <a:prstGeom prst="rect">
                                                        <a:avLst/>
                                                      </a:prstGeom>
                                                      <a:noFill/>
                                                    </p:spPr>
                                                    <p:txBody>
                                                      <a:bodyPr wrap="square" rtlCol="0">
                                                        <a:spAutoFit/>
                                                      </a:bodyPr>
                                                      <a:lstStyle/>
                                                      <a:p>
                                                        <a:pPr algn="ctr"/>
                                                        <a:r>
                                                          <a:rPr lang="en-GB" sz="1000" b="1" dirty="0">
                                                            <a:latin typeface="Arial" panose="020B0604020202020204" pitchFamily="34" charset="0"/>
                                                            <a:cs typeface="Arial" panose="020B0604020202020204" pitchFamily="34" charset="0"/>
                                                          </a:rPr>
                                                          <a:t>Gluconeogenesis</a:t>
                                                        </a:r>
                                                      </a:p>
                                                    </p:txBody>
                                                  </p:sp>
                                                </p:grpSp>
                                                <p:sp>
                                                  <p:nvSpPr>
                                                    <p:cNvPr id="168" name="TextBox 167"/>
                                                    <p:cNvSpPr txBox="1"/>
                                                    <p:nvPr/>
                                                  </p:nvSpPr>
                                                  <p:spPr>
                                                    <a:xfrm>
                                                      <a:off x="2366671" y="1439116"/>
                                                      <a:ext cx="1345875" cy="400110"/>
                                                    </a:xfrm>
                                                    <a:prstGeom prst="rect">
                                                      <a:avLst/>
                                                    </a:prstGeom>
                                                    <a:noFill/>
                                                  </p:spPr>
                                                  <p:txBody>
                                                    <a:bodyPr wrap="square" rtlCol="0">
                                                      <a:spAutoFit/>
                                                    </a:bodyPr>
                                                    <a:lstStyle/>
                                                    <a:p>
                                                      <a:pPr algn="ctr"/>
                                                      <a:r>
                                                        <a:rPr lang="en-GB" sz="1000" b="1" dirty="0">
                                                          <a:latin typeface="Arial" panose="020B0604020202020204" pitchFamily="34" charset="0"/>
                                                          <a:cs typeface="Arial" panose="020B0604020202020204" pitchFamily="34" charset="0"/>
                                                        </a:rPr>
                                                        <a:t>Entner-Doudoroff pathway</a:t>
                                                      </a:r>
                                                      <a:endParaRPr lang="en-GB" sz="1000" b="1" baseline="30000" dirty="0">
                                                        <a:latin typeface="Arial" panose="020B0604020202020204" pitchFamily="34" charset="0"/>
                                                        <a:cs typeface="Arial" panose="020B0604020202020204" pitchFamily="34" charset="0"/>
                                                      </a:endParaRPr>
                                                    </a:p>
                                                  </p:txBody>
                                                </p:sp>
                                              </p:grpSp>
                                              <p:cxnSp>
                                                <p:nvCxnSpPr>
                                                  <p:cNvPr id="165" name="Straight Arrow Connector 164">
                                                    <a:extLst>
                                                      <a:ext uri="{FF2B5EF4-FFF2-40B4-BE49-F238E27FC236}">
                                                        <a16:creationId xmlns:a16="http://schemas.microsoft.com/office/drawing/2014/main" xmlns="" id="{122EA4EC-1949-8C46-9213-36FBA8C4E38D}"/>
                                                      </a:ext>
                                                    </a:extLst>
                                                  </p:cNvPr>
                                                  <p:cNvCxnSpPr>
                                                    <a:cxnSpLocks/>
                                                  </p:cNvCxnSpPr>
                                                  <p:nvPr/>
                                                </p:nvCxnSpPr>
                                                <p:spPr>
                                                  <a:xfrm rot="16200000">
                                                    <a:off x="4738506" y="597090"/>
                                                    <a:ext cx="0" cy="229340"/>
                                                  </a:xfrm>
                                                  <a:prstGeom prst="straightConnector1">
                                                    <a:avLst/>
                                                  </a:prstGeom>
                                                  <a:ln w="12700">
                                                    <a:solidFill>
                                                      <a:schemeClr val="tx1"/>
                                                    </a:solidFill>
                                                    <a:prstDash val="sysDash"/>
                                                    <a:tailEnd type="triangle"/>
                                                  </a:ln>
                                                </p:spPr>
                                                <p:style>
                                                  <a:lnRef idx="1">
                                                    <a:schemeClr val="accent1"/>
                                                  </a:lnRef>
                                                  <a:fillRef idx="0">
                                                    <a:schemeClr val="accent1"/>
                                                  </a:fillRef>
                                                  <a:effectRef idx="0">
                                                    <a:schemeClr val="accent1"/>
                                                  </a:effectRef>
                                                  <a:fontRef idx="minor">
                                                    <a:schemeClr val="tx1"/>
                                                  </a:fontRef>
                                                </p:style>
                                              </p:cxnSp>
                                              <p:sp>
                                                <p:nvSpPr>
                                                  <p:cNvPr id="166" name="TextBox 165"/>
                                                  <p:cNvSpPr txBox="1"/>
                                                  <p:nvPr/>
                                                </p:nvSpPr>
                                                <p:spPr>
                                                  <a:xfrm>
                                                    <a:off x="4827121" y="600525"/>
                                                    <a:ext cx="922969" cy="246221"/>
                                                  </a:xfrm>
                                                  <a:prstGeom prst="rect">
                                                    <a:avLst/>
                                                  </a:prstGeom>
                                                  <a:noFill/>
                                                </p:spPr>
                                                <p:txBody>
                                                  <a:bodyPr wrap="square" rtlCol="0">
                                                    <a:spAutoFit/>
                                                  </a:bodyPr>
                                                  <a:lstStyle/>
                                                  <a:p>
                                                    <a:pPr algn="ctr"/>
                                                    <a:r>
                                                      <a:rPr lang="en-GB" sz="1000" dirty="0">
                                                        <a:latin typeface="Arial" panose="020B0604020202020204" pitchFamily="34" charset="0"/>
                                                        <a:cs typeface="Arial" panose="020B0604020202020204" pitchFamily="34" charset="0"/>
                                                      </a:rPr>
                                                      <a:t>Ribulose-5P</a:t>
                                                    </a:r>
                                                  </a:p>
                                                </p:txBody>
                                              </p:sp>
                                            </p:grpSp>
                                            <p:sp>
                                              <p:nvSpPr>
                                                <p:cNvPr id="160" name="TextBox 159"/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5366729" y="747445"/>
                                                  <a:ext cx="922969" cy="246221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pPr algn="ctr"/>
                                                  <a:r>
                                                    <a:rPr lang="en-GB" sz="1000" dirty="0">
                                                      <a:latin typeface="Arial" panose="020B0604020202020204" pitchFamily="34" charset="0"/>
                                                      <a:cs typeface="Arial" panose="020B0604020202020204" pitchFamily="34" charset="0"/>
                                                    </a:rPr>
                                                    <a:t>Xylulose-5P</a:t>
                                                  </a:r>
                                                </a:p>
                                              </p:txBody>
                                            </p:sp>
                                            <p:cxnSp>
                                              <p:nvCxnSpPr>
                                                <p:cNvPr id="161" name="Straight Arrow Connector 160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xmlns="" id="{122EA4EC-1949-8C46-9213-36FBA8C4E38D}"/>
                                                    </a:ext>
                                                  </a:extLst>
                                                </p:cNvPr>
                                                <p:cNvCxnSpPr>
                                                  <a:cxnSpLocks/>
                                                </p:cNvCxnSpPr>
                                                <p:nvPr/>
                                              </p:nvCxnSpPr>
                                              <p:spPr>
                                                <a:xfrm rot="16200000">
                                                  <a:off x="5298753" y="741651"/>
                                                  <a:ext cx="0" cy="252000"/>
                                                </a:xfrm>
                                                <a:prstGeom prst="straightConnector1">
                                                  <a:avLst/>
                                                </a:prstGeom>
                                                <a:ln w="12700">
                                                  <a:solidFill>
                                                    <a:schemeClr val="tx1"/>
                                                  </a:solidFill>
                                                  <a:headEnd type="triangle"/>
                                                  <a:tailEnd type="triangle"/>
                                                </a:ln>
                                              </p:spPr>
                                              <p:style>
                                                <a:lnRef idx="1">
                                                  <a:schemeClr val="accent1"/>
                                                </a:lnRef>
                                                <a:fillRef idx="0">
                                                  <a:schemeClr val="accent1"/>
                                                </a:fillRef>
                                                <a:effectRef idx="0">
                                                  <a:schemeClr val="accent1"/>
                                                </a:effectRef>
                                                <a:fontRef idx="minor">
                                                  <a:schemeClr val="tx1"/>
                                                </a:fontRef>
                                              </p:style>
                                            </p:cxnSp>
                                            <p:sp>
                                              <p:nvSpPr>
                                                <p:cNvPr id="162" name="TextBox 161"/>
                                                <p:cNvSpPr txBox="1"/>
                                                <p:nvPr/>
                                              </p:nvSpPr>
                                              <p:spPr>
                                                <a:xfrm>
                                                  <a:off x="6395659" y="744540"/>
                                                  <a:ext cx="922969" cy="246221"/>
                                                </a:xfrm>
                                                <a:prstGeom prst="rect">
                                                  <a:avLst/>
                                                </a:prstGeom>
                                                <a:noFill/>
                                              </p:spPr>
                                              <p:txBody>
                                                <a:bodyPr wrap="square" rtlCol="0">
                                                  <a:spAutoFit/>
                                                </a:bodyPr>
                                                <a:lstStyle/>
                                                <a:p>
                                                  <a:pPr algn="ctr"/>
                                                  <a:r>
                                                    <a:rPr lang="en-GB" sz="1000" dirty="0">
                                                      <a:latin typeface="Arial" panose="020B0604020202020204" pitchFamily="34" charset="0"/>
                                                      <a:cs typeface="Arial" panose="020B0604020202020204" pitchFamily="34" charset="0"/>
                                                    </a:rPr>
                                                    <a:t>Fructose-6P</a:t>
                                                  </a:r>
                                                </a:p>
                                              </p:txBody>
                                            </p:sp>
                                            <p:cxnSp>
                                              <p:nvCxnSpPr>
                                                <p:cNvPr id="163" name="Straight Arrow Connector 162">
                                                  <a:extLst>
                                                    <a:ext uri="{FF2B5EF4-FFF2-40B4-BE49-F238E27FC236}">
                                                      <a16:creationId xmlns:a16="http://schemas.microsoft.com/office/drawing/2014/main" xmlns="" id="{122EA4EC-1949-8C46-9213-36FBA8C4E38D}"/>
                                                    </a:ext>
                                                  </a:extLst>
                                                </p:cNvPr>
                                                <p:cNvCxnSpPr>
                                                  <a:cxnSpLocks/>
                                                </p:cNvCxnSpPr>
                                                <p:nvPr/>
                                              </p:nvCxnSpPr>
                                              <p:spPr>
                                                <a:xfrm rot="16200000">
                                                  <a:off x="6330183" y="741651"/>
                                                  <a:ext cx="0" cy="252000"/>
                                                </a:xfrm>
                                                <a:prstGeom prst="straightConnector1">
                                                  <a:avLst/>
                                                </a:prstGeom>
                                                <a:ln w="12700">
                                                  <a:solidFill>
                                                    <a:schemeClr val="tx1"/>
                                                  </a:solidFill>
                                                  <a:headEnd type="triangle"/>
                                                  <a:tailEnd type="triangle"/>
                                                </a:ln>
                                              </p:spPr>
                                              <p:style>
                                                <a:lnRef idx="1">
                                                  <a:schemeClr val="accent1"/>
                                                </a:lnRef>
                                                <a:fillRef idx="0">
                                                  <a:schemeClr val="accent1"/>
                                                </a:fillRef>
                                                <a:effectRef idx="0">
                                                  <a:schemeClr val="accent1"/>
                                                </a:effectRef>
                                                <a:fontRef idx="minor">
                                                  <a:schemeClr val="tx1"/>
                                                </a:fontRef>
                                              </p:style>
                                            </p:cxnSp>
                                          </p:grpSp>
                                          <p:cxnSp>
                                            <p:nvCxnSpPr>
                                              <p:cNvPr id="158" name="Straight Arrow Connector 157">
                                                <a:extLst>
                                                  <a:ext uri="{FF2B5EF4-FFF2-40B4-BE49-F238E27FC236}">
                                                    <a16:creationId xmlns:a16="http://schemas.microsoft.com/office/drawing/2014/main" xmlns="" id="{122EA4EC-1949-8C46-9213-36FBA8C4E38D}"/>
                                                  </a:ext>
                                                </a:extLst>
                                              </p:cNvPr>
                                              <p:cNvCxnSpPr>
                                                <a:cxnSpLocks/>
                                              </p:cNvCxnSpPr>
                                              <p:nvPr/>
                                            </p:nvCxnSpPr>
                                            <p:spPr>
                                              <a:xfrm rot="16200000">
                                                <a:off x="3265303" y="1209012"/>
                                                <a:ext cx="0" cy="252000"/>
                                              </a:xfrm>
                                              <a:prstGeom prst="straightConnector1">
                                                <a:avLst/>
                                              </a:prstGeom>
                                              <a:ln w="12700">
                                                <a:solidFill>
                                                  <a:schemeClr val="tx1"/>
                                                </a:solidFill>
                                                <a:headEnd type="triangle" w="med" len="med"/>
                                                <a:tailEnd type="none" w="med" len="med"/>
                                              </a:ln>
                                            </p:spPr>
                                            <p:style>
                                              <a:lnRef idx="1">
                                                <a:schemeClr val="accent1"/>
                                              </a:lnRef>
                                              <a:fillRef idx="0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tx1"/>
                                              </a:fontRef>
                                            </p:style>
                                          </p:cxnSp>
                                        </p:grpSp>
                                        <p:sp>
                                          <p:nvSpPr>
                                            <p:cNvPr id="154" name="TextBox 153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4844245" y="1222086"/>
                                              <a:ext cx="1015266" cy="22585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Oxaloacetate</a:t>
                                              </a:r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55" name="Straight Arrow Connector 15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122EA4EC-1949-8C46-9213-36FBA8C4E38D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</p:cNvCxnSpPr>
                                            <p:nvPr/>
                                          </p:nvCxnSpPr>
                                          <p:spPr>
                                            <a:xfrm flipV="1">
                                              <a:off x="4079379" y="1472068"/>
                                              <a:ext cx="764866" cy="281706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2700">
                                              <a:solidFill>
                                                <a:schemeClr val="tx1"/>
                                              </a:solidFill>
                                              <a:tailEnd type="triangle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cxnSp>
                                          <p:nvCxnSpPr>
                                            <p:cNvPr id="156" name="Straight Arrow Connector 15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122EA4EC-1949-8C46-9213-36FBA8C4E38D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</p:cNvCxnSpPr>
                                            <p:nvPr/>
                                          </p:nvCxnSpPr>
                                          <p:spPr>
                                            <a:xfrm rot="16200000">
                                              <a:off x="4754119" y="1217205"/>
                                              <a:ext cx="0" cy="25200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2700">
                                              <a:solidFill>
                                                <a:schemeClr val="tx1"/>
                                              </a:solidFill>
                                              <a:headEnd type="triangle"/>
                                              <a:tailEnd type="triangle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</p:grpSp>
                                      <p:sp>
                                        <p:nvSpPr>
                                          <p:cNvPr id="151" name="TextBox 150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7055599" y="1275227"/>
                                            <a:ext cx="1015266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Chitobiose</a:t>
                                            </a:r>
                                          </a:p>
                                        </p:txBody>
                                      </p:sp>
                                      <p:cxnSp>
                                        <p:nvCxnSpPr>
                                          <p:cNvPr id="152" name="Straight Arrow Connector 15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D1700605-9024-8348-81FB-068D4CA932EA}"/>
                                              </a:ext>
                                            </a:extLst>
                                          </p:cNvPr>
                                          <p:cNvCxnSpPr>
                                            <a:cxnSpLocks/>
                                          </p:cNvCxnSpPr>
                                          <p:nvPr/>
                                        </p:nvCxnSpPr>
                                        <p:spPr>
                                          <a:xfrm>
                                            <a:off x="7563232" y="899779"/>
                                            <a:ext cx="0" cy="396000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2700">
                                            <a:solidFill>
                                              <a:schemeClr val="tx1"/>
                                            </a:solidFill>
                                            <a:prstDash val="sysDash"/>
                                            <a:headEnd type="triangle"/>
                                            <a:tailEnd type="none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</p:grpSp>
                                    <p:grpSp>
                                      <p:nvGrpSpPr>
                                        <p:cNvPr id="134" name="Group 133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4444698" y="2036537"/>
                                          <a:ext cx="2505097" cy="3096300"/>
                                          <a:chOff x="4444698" y="1933568"/>
                                          <a:chExt cx="2505097" cy="3096300"/>
                                        </a:xfrm>
                                      </p:grpSpPr>
                                      <p:grpSp>
                                        <p:nvGrpSpPr>
                                          <p:cNvPr id="135" name="Group 134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5834789" y="2970103"/>
                                            <a:ext cx="1115006" cy="1019382"/>
                                            <a:chOff x="5834789" y="2970103"/>
                                            <a:chExt cx="1115006" cy="1019382"/>
                                          </a:xfrm>
                                        </p:grpSpPr>
                                        <p:sp>
                                          <p:nvSpPr>
                                            <p:cNvPr id="143" name="Rectangle 142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57A4C844-EC5C-1743-8133-BEDEE352937B}"/>
                                                </a:ext>
                                              </a:extLst>
                                            </p:cNvPr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5834789" y="2970103"/>
                                              <a:ext cx="730588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</p:spPr>
                                          <p:txBody>
                                            <a:bodyPr wrap="square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solidFill>
                                                    <a:srgbClr val="000000"/>
                                                  </a:solidFill>
                                                  <a:effectLst/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CH</a:t>
                                              </a:r>
                                              <a:r>
                                                <a:rPr lang="en-GB" sz="1000" baseline="-25000" dirty="0">
                                                  <a:solidFill>
                                                    <a:srgbClr val="000000"/>
                                                  </a:solidFill>
                                                  <a:effectLst/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3</a:t>
                                              </a:r>
                                              <a:r>
                                                <a:rPr lang="en-GB" sz="1000" dirty="0">
                                                  <a:solidFill>
                                                    <a:srgbClr val="000000"/>
                                                  </a:solidFill>
                                                  <a:effectLst/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-H</a:t>
                                              </a:r>
                                              <a:r>
                                                <a:rPr lang="en-GB" sz="1000" baseline="-25000" dirty="0">
                                                  <a:solidFill>
                                                    <a:srgbClr val="000000"/>
                                                  </a:solidFill>
                                                  <a:effectLst/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4</a:t>
                                              </a:r>
                                              <a:r>
                                                <a:rPr lang="en-GB" sz="1000" dirty="0">
                                                  <a:solidFill>
                                                    <a:srgbClr val="000000"/>
                                                  </a:solidFill>
                                                  <a:effectLst/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F</a:t>
                                              </a:r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44" name="Straight Arrow Connector 143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122EA4EC-1949-8C46-9213-36FBA8C4E38D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</p:cNvCxnSpPr>
                                            <p:nvPr/>
                                          </p:nvCxnSpPr>
                                          <p:spPr>
                                            <a:xfrm>
                                              <a:off x="6200083" y="3221662"/>
                                              <a:ext cx="0" cy="22934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2700">
                                              <a:solidFill>
                                                <a:schemeClr val="tx1"/>
                                              </a:solidFill>
                                              <a:tailEnd type="triangle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cxnSp>
                                          <p:nvCxnSpPr>
                                            <p:cNvPr id="145" name="Straight Arrow Connector 144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122EA4EC-1949-8C46-9213-36FBA8C4E38D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</p:cNvCxnSpPr>
                                            <p:nvPr/>
                                          </p:nvCxnSpPr>
                                          <p:spPr>
                                            <a:xfrm>
                                              <a:off x="6201391" y="3497066"/>
                                              <a:ext cx="0" cy="22934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2700">
                                              <a:solidFill>
                                                <a:schemeClr val="tx1"/>
                                              </a:solidFill>
                                              <a:tailEnd type="triangle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cxnSp>
                                          <p:nvCxnSpPr>
                                            <p:cNvPr id="146" name="Straight Arrow Connector 145">
                                              <a:extLst>
                                                <a:ext uri="{FF2B5EF4-FFF2-40B4-BE49-F238E27FC236}">
                                                  <a16:creationId xmlns:a16="http://schemas.microsoft.com/office/drawing/2014/main" xmlns="" id="{122EA4EC-1949-8C46-9213-36FBA8C4E38D}"/>
                                                </a:ext>
                                              </a:extLst>
                                            </p:cNvPr>
                                            <p:cNvCxnSpPr>
                                              <a:cxnSpLocks/>
                                            </p:cNvCxnSpPr>
                                            <p:nvPr/>
                                          </p:nvCxnSpPr>
                                          <p:spPr>
                                            <a:xfrm>
                                              <a:off x="6201391" y="3760145"/>
                                              <a:ext cx="0" cy="229340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2700">
                                              <a:solidFill>
                                                <a:schemeClr val="tx1"/>
                                              </a:solidFill>
                                              <a:tailEnd type="triangle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47" name="TextBox 146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211530" y="3203342"/>
                                              <a:ext cx="473938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etF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48" name="TextBox 147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211530" y="3434971"/>
                                              <a:ext cx="473938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folD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49" name="TextBox 148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6211529" y="3735952"/>
                                              <a:ext cx="738266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fhs</a:t>
                                              </a:r>
                                              <a:r>
                                                <a:rPr lang="en-GB" sz="1000" i="1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/</a:t>
                                              </a:r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purU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136" name="Rectangle 135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57A4C844-EC5C-1743-8133-BEDEE352937B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5834789" y="3998303"/>
                                            <a:ext cx="730588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  <p:txBody>
                                          <a:bodyPr wrap="square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solidFill>
                                                  <a:srgbClr val="000000"/>
                                                </a:solidFill>
                                                <a:effectLst/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HCOOH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7" name="Rectangle 136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57A4C844-EC5C-1743-8133-BEDEE352937B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6138131" y="4806031"/>
                                            <a:ext cx="453638" cy="223837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  <p:txBody>
                                          <a:bodyPr wrap="square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solidFill>
                                                  <a:srgbClr val="000000"/>
                                                </a:solidFill>
                                                <a:effectLst/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CO</a:t>
                                            </a:r>
                                            <a:r>
                                              <a:rPr lang="en-GB" sz="1000" baseline="-25000" dirty="0">
                                                <a:solidFill>
                                                  <a:srgbClr val="000000"/>
                                                </a:solidFill>
                                                <a:effectLst/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2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8" name="TextBox 137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4506261" y="3243740"/>
                                            <a:ext cx="643741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Glycine</a:t>
                                            </a:r>
                                          </a:p>
                                        </p:txBody>
                                      </p:sp>
                                      <p:cxnSp>
                                        <p:nvCxnSpPr>
                                          <p:cNvPr id="139" name="Straight Arrow Connector 138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122EA4EC-1949-8C46-9213-36FBA8C4E38D}"/>
                                              </a:ext>
                                            </a:extLst>
                                          </p:cNvPr>
                                          <p:cNvCxnSpPr>
                                            <a:cxnSpLocks/>
                                          </p:cNvCxnSpPr>
                                          <p:nvPr/>
                                        </p:nvCxnSpPr>
                                        <p:spPr>
                                          <a:xfrm>
                                            <a:off x="5126239" y="3446163"/>
                                            <a:ext cx="1008000" cy="0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2700">
                                            <a:solidFill>
                                              <a:schemeClr val="tx1"/>
                                            </a:solidFill>
                                            <a:tailEnd type="triangle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140" name="Arc 139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A875784D-D5DF-2A4E-92B4-3C2B0005761A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 rot="3192432">
                                            <a:off x="4789379" y="2090043"/>
                                            <a:ext cx="1727902" cy="1414951"/>
                                          </a:xfrm>
                                          <a:prstGeom prst="arc">
                                            <a:avLst>
                                              <a:gd name="adj1" fmla="val 3833629"/>
                                              <a:gd name="adj2" fmla="val 5571108"/>
                                            </a:avLst>
                                          </a:prstGeom>
                                          <a:ln w="12700">
                                            <a:solidFill>
                                              <a:schemeClr val="tx1"/>
                                            </a:solidFill>
                                            <a:headEnd type="triangle" w="med" len="med"/>
                                            <a:tailEnd type="none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US" dirty="0"/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41" name="TextBox 140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4713354" y="2970841"/>
                                            <a:ext cx="643741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THF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42" name="Arc 141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A875784D-D5DF-2A4E-92B4-3C2B0005761A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 rot="11997022">
                                            <a:off x="4444698" y="3256295"/>
                                            <a:ext cx="1305187" cy="793851"/>
                                          </a:xfrm>
                                          <a:prstGeom prst="arc">
                                            <a:avLst>
                                              <a:gd name="adj1" fmla="val 8070337"/>
                                              <a:gd name="adj2" fmla="val 9742080"/>
                                            </a:avLst>
                                          </a:prstGeom>
                                          <a:ln w="12700">
                                            <a:solidFill>
                                              <a:schemeClr val="tx1"/>
                                            </a:solidFill>
                                            <a:headEnd type="none" w="med" len="med"/>
                                            <a:tailEnd type="triangle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US" dirty="0"/>
                                          </a:p>
                                        </p:txBody>
                                      </p:sp>
                                    </p:grpSp>
                                  </p:grpSp>
                                  <p:grpSp>
                                    <p:nvGrpSpPr>
                                      <p:cNvPr id="79" name="Group 78"/>
                                      <p:cNvGrpSpPr/>
                                      <p:nvPr/>
                                    </p:nvGrpSpPr>
                                    <p:grpSpPr>
                                      <a:xfrm>
                                        <a:off x="-102263" y="44624"/>
                                        <a:ext cx="9911861" cy="6456364"/>
                                        <a:chOff x="-102263" y="44624"/>
                                        <a:chExt cx="9911861" cy="6456364"/>
                                      </a:xfrm>
                                    </p:grpSpPr>
                                    <p:grpSp>
                                      <p:nvGrpSpPr>
                                        <p:cNvPr id="80" name="Group 79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277834" y="3989447"/>
                                          <a:ext cx="2236834" cy="2511541"/>
                                          <a:chOff x="277834" y="3989447"/>
                                          <a:chExt cx="2236834" cy="2511541"/>
                                        </a:xfrm>
                                      </p:grpSpPr>
                                      <p:sp>
                                        <p:nvSpPr>
                                          <p:cNvPr id="130" name="Rounded Rectangle 129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277834" y="3989447"/>
                                            <a:ext cx="2232248" cy="2511541"/>
                                          </a:xfrm>
                                          <a:prstGeom prst="roundRect">
                                            <a:avLst/>
                                          </a:prstGeom>
                                          <a:solidFill>
                                            <a:schemeClr val="accent4">
                                              <a:lumMod val="40000"/>
                                              <a:lumOff val="60000"/>
                                              <a:alpha val="50000"/>
                                            </a:schemeClr>
                                          </a:solidFill>
                                          <a:ln>
                                            <a:noFill/>
                                          </a:ln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1" name="Rectangle 13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E51710F5-39EB-F440-A7EA-C387B786D21B}"/>
                                              </a:ext>
                                            </a:extLst>
                                          </p:cNvPr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294328" y="4660724"/>
                                            <a:ext cx="2220340" cy="1815882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  <p:txBody>
                                          <a:bodyPr wrap="square">
                                            <a:spAutoFit/>
                                          </a:bodyPr>
                                          <a:lstStyle/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smotic stress response (Aquaporin/ Glycine betaine)</a:t>
                                            </a:r>
                                          </a:p>
                                          <a:p>
                                            <a:pPr marL="171450" indent="-171450"/>
                                            <a:endParaRPr lang="en-US" sz="8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Superoxide dismutase (Manganese)</a:t>
                                            </a: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endParaRPr lang="en-US" sz="8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Peroxidase, catalase</a:t>
                                            </a: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endParaRPr lang="en-US" sz="8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Cold shock/ Heat shock</a:t>
                                            </a: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endParaRPr lang="en-US" sz="8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pPr marL="171450" indent="-171450">
                                              <a:buFont typeface="Arial" panose="020B0604020202020204" pitchFamily="34" charset="0"/>
                                              <a:buChar char="•"/>
                                            </a:pPr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Periplasmatic stress response</a:t>
                                            </a:r>
                                          </a:p>
                                          <a:p>
                                            <a:endParaRPr lang="en-US" sz="10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132" name="Rectangle 131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464472" y="4000991"/>
                                            <a:ext cx="1256562" cy="292388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  <p:txBody>
                                          <a:bodyPr wrap="none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en-US" sz="1300" b="1" dirty="0"/>
                                              <a:t>Stress response</a:t>
                                            </a:r>
                                            <a:endParaRPr lang="en-GB" sz="1300" dirty="0"/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81" name="Group 80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-102263" y="44624"/>
                                          <a:ext cx="9843496" cy="4608512"/>
                                          <a:chOff x="-102263" y="44624"/>
                                          <a:chExt cx="9843496" cy="4608512"/>
                                        </a:xfrm>
                                      </p:grpSpPr>
                                      <p:grpSp>
                                        <p:nvGrpSpPr>
                                          <p:cNvPr id="99" name="Group 98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16262" y="44624"/>
                                            <a:ext cx="9724971" cy="4608512"/>
                                            <a:chOff x="16262" y="44624"/>
                                            <a:chExt cx="9724971" cy="4608512"/>
                                          </a:xfrm>
                                        </p:grpSpPr>
                                        <p:sp>
                                          <p:nvSpPr>
                                            <p:cNvPr id="128" name="Rounded Rectangle 127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16262" y="380310"/>
                                              <a:ext cx="2257702" cy="3434204"/>
                                            </a:xfrm>
                                            <a:prstGeom prst="roundRect">
                                              <a:avLst/>
                                            </a:prstGeom>
                                            <a:solidFill>
                                              <a:schemeClr val="accent3">
                                                <a:lumMod val="40000"/>
                                                <a:lumOff val="60000"/>
                                                <a:alpha val="50000"/>
                                              </a:schemeClr>
                                            </a:solidFill>
                                            <a:ln>
                                              <a:noFill/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29" name="Oval 128"/>
                                            <p:cNvSpPr/>
                                            <p:nvPr/>
                                          </p:nvSpPr>
                                          <p:spPr>
                                            <a:xfrm>
                                              <a:off x="690161" y="44624"/>
                                              <a:ext cx="9051072" cy="4608512"/>
                                            </a:xfrm>
                                            <a:prstGeom prst="ellipse">
                                              <a:avLst/>
                                            </a:prstGeom>
                                            <a:noFill/>
                                            <a:ln w="244475">
                                              <a:solidFill>
                                                <a:schemeClr val="tx2">
                                                  <a:lumMod val="20000"/>
                                                  <a:lumOff val="80000"/>
                                                </a:schemeClr>
                                              </a:solidFill>
                                            </a:ln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00" name="Group 99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36785" y="2730442"/>
                                            <a:ext cx="2251919" cy="637869"/>
                                            <a:chOff x="165557" y="2703050"/>
                                            <a:chExt cx="2251919" cy="637869"/>
                                          </a:xfrm>
                                        </p:grpSpPr>
                                        <p:sp>
                                          <p:nvSpPr>
                                            <p:cNvPr id="124" name="Rounded Rectangle 123"/>
                                            <p:cNvSpPr/>
                                            <p:nvPr/>
                                          </p:nvSpPr>
                                          <p:spPr>
                                            <a:xfrm rot="3522337">
                                              <a:off x="828238" y="2879186"/>
                                              <a:ext cx="355848" cy="258038"/>
                                            </a:xfrm>
                                            <a:prstGeom prst="roundRect">
                                              <a:avLst/>
                                            </a:prstGeom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25" name="Straight Arrow Connector 124"/>
                                            <p:cNvCxnSpPr/>
                                            <p:nvPr/>
                                          </p:nvCxnSpPr>
                                          <p:spPr>
                                            <a:xfrm flipV="1">
                                              <a:off x="737926" y="2842063"/>
                                              <a:ext cx="546260" cy="332284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9050">
                                              <a:solidFill>
                                                <a:schemeClr val="tx1"/>
                                              </a:solidFill>
                                              <a:headEnd type="none" w="med" len="med"/>
                                              <a:tailEnd type="triangle" w="med" len="med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26" name="TextBox 125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172958" y="2703050"/>
                                              <a:ext cx="1244518" cy="348813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g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/ Co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/ Ni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</a:p>
                                            <a:p>
                                              <a:pPr algn="ctr"/>
                                              <a:endParaRPr lang="en-GB" sz="1000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27" name="TextBox 126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65557" y="3094698"/>
                                              <a:ext cx="707749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gtE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01" name="Group 100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399895" y="3058481"/>
                                            <a:ext cx="1650305" cy="729220"/>
                                            <a:chOff x="560471" y="3062893"/>
                                            <a:chExt cx="1650305" cy="729220"/>
                                          </a:xfrm>
                                        </p:grpSpPr>
                                        <p:sp>
                                          <p:nvSpPr>
                                            <p:cNvPr id="120" name="Rounded Rectangle 119"/>
                                            <p:cNvSpPr/>
                                            <p:nvPr/>
                                          </p:nvSpPr>
                                          <p:spPr>
                                            <a:xfrm rot="2779005">
                                              <a:off x="1198551" y="3301034"/>
                                              <a:ext cx="355848" cy="258038"/>
                                            </a:xfrm>
                                            <a:prstGeom prst="roundRect">
                                              <a:avLst/>
                                            </a:prstGeom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21" name="Straight Arrow Connector 120"/>
                                            <p:cNvCxnSpPr/>
                                            <p:nvPr/>
                                          </p:nvCxnSpPr>
                                          <p:spPr>
                                            <a:xfrm flipV="1">
                                              <a:off x="1181000" y="3219129"/>
                                              <a:ext cx="424378" cy="421849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9050">
                                              <a:solidFill>
                                                <a:schemeClr val="tx1"/>
                                              </a:solidFill>
                                              <a:headEnd type="none" w="med" len="med"/>
                                              <a:tailEnd type="triangle" w="med" len="med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22" name="TextBox 121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560471" y="3545892"/>
                                              <a:ext cx="707749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wtpA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23" name="TextBox 122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503027" y="3062893"/>
                                              <a:ext cx="707749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WO</a:t>
                                              </a:r>
                                              <a:r>
                                                <a:rPr lang="en-GB" sz="1000" baseline="-25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4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-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02" name="Group 101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-98415" y="2348880"/>
                                            <a:ext cx="1651137" cy="374979"/>
                                            <a:chOff x="12000" y="2325637"/>
                                            <a:chExt cx="1651137" cy="374979"/>
                                          </a:xfrm>
                                        </p:grpSpPr>
                                        <p:sp>
                                          <p:nvSpPr>
                                            <p:cNvPr id="116" name="TextBox 115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78220" y="2363237"/>
                                              <a:ext cx="584917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g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17" name="Rounded Rectangle 116"/>
                                            <p:cNvSpPr/>
                                            <p:nvPr/>
                                          </p:nvSpPr>
                                          <p:spPr>
                                            <a:xfrm rot="4991675">
                                              <a:off x="636114" y="2358458"/>
                                              <a:ext cx="355848" cy="290206"/>
                                            </a:xfrm>
                                            <a:prstGeom prst="roundRect">
                                              <a:avLst/>
                                            </a:prstGeom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18" name="Straight Arrow Connector 117"/>
                                            <p:cNvCxnSpPr/>
                                            <p:nvPr/>
                                          </p:nvCxnSpPr>
                                          <p:spPr>
                                            <a:xfrm flipV="1">
                                              <a:off x="514525" y="2472296"/>
                                              <a:ext cx="624000" cy="67182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9050">
                                              <a:solidFill>
                                                <a:schemeClr val="tx1"/>
                                              </a:solidFill>
                                              <a:headEnd type="none" w="med" len="med"/>
                                              <a:tailEnd type="triangle" w="med" len="med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19" name="TextBox 118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2000" y="2454395"/>
                                              <a:ext cx="584917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gtC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03" name="Group 102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-102263" y="1873589"/>
                                            <a:ext cx="2003109" cy="375809"/>
                                            <a:chOff x="10607" y="1814393"/>
                                            <a:chExt cx="2003109" cy="375809"/>
                                          </a:xfrm>
                                        </p:grpSpPr>
                                        <p:sp>
                                          <p:nvSpPr>
                                            <p:cNvPr id="112" name="Oval 111"/>
                                            <p:cNvSpPr/>
                                            <p:nvPr/>
                                          </p:nvSpPr>
                                          <p:spPr>
                                            <a:xfrm rot="419904">
                                              <a:off x="638301" y="1889176"/>
                                              <a:ext cx="443073" cy="216024"/>
                                            </a:xfrm>
                                            <a:prstGeom prst="ellipse">
                                              <a:avLst/>
                                            </a:prstGeom>
                                          </p:spPr>
                                          <p:style>
                                            <a:lnRef idx="2">
                                              <a:schemeClr val="accent1">
                                                <a:shade val="50000"/>
                                              </a:schemeClr>
                                            </a:lnRef>
                                            <a:fillRef idx="1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lt1"/>
                                            </a:fontRef>
                                          </p:style>
                                          <p:txBody>
                                            <a:bodyPr rtlCol="0" anchor="ctr"/>
                                            <a:lstStyle/>
                                            <a:p>
                                              <a:pPr algn="ctr"/>
                                              <a:endParaRPr lang="en-GB"/>
                                            </a:p>
                                          </p:txBody>
                                        </p:sp>
                                        <p:cxnSp>
                                          <p:nvCxnSpPr>
                                            <p:cNvPr id="113" name="Straight Arrow Connector 112"/>
                                            <p:cNvCxnSpPr/>
                                            <p:nvPr/>
                                          </p:nvCxnSpPr>
                                          <p:spPr>
                                            <a:xfrm flipH="1" flipV="1">
                                              <a:off x="504207" y="1927978"/>
                                              <a:ext cx="666474" cy="129588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9050">
                                              <a:solidFill>
                                                <a:schemeClr val="tx1"/>
                                              </a:solidFill>
                                              <a:headEnd type="none" w="med" len="med"/>
                                              <a:tailEnd type="triangle" w="med" len="med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14" name="TextBox 113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119838" y="1943981"/>
                                              <a:ext cx="893878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Mg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/ Co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 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15" name="TextBox 114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0607" y="1814393"/>
                                              <a:ext cx="584917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i="1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corC</a:t>
                                              </a:r>
                                              <a:endParaRPr lang="en-GB" sz="1000" i="1" baseline="30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endParaRPr>
                                            </a:p>
                                          </p:txBody>
                                        </p:sp>
                                      </p:grpSp>
                                      <p:grpSp>
                                        <p:nvGrpSpPr>
                                          <p:cNvPr id="104" name="Group 103"/>
                                          <p:cNvGrpSpPr/>
                                          <p:nvPr/>
                                        </p:nvGrpSpPr>
                                        <p:grpSpPr>
                                          <a:xfrm>
                                            <a:off x="98462" y="1172899"/>
                                            <a:ext cx="1614621" cy="718751"/>
                                            <a:chOff x="282891" y="1145507"/>
                                            <a:chExt cx="1614621" cy="718751"/>
                                          </a:xfrm>
                                        </p:grpSpPr>
                                        <p:grpSp>
                                          <p:nvGrpSpPr>
                                            <p:cNvPr id="106" name="Group 105"/>
                                            <p:cNvGrpSpPr/>
                                            <p:nvPr/>
                                          </p:nvGrpSpPr>
                                          <p:grpSpPr>
                                            <a:xfrm>
                                              <a:off x="956365" y="1433816"/>
                                              <a:ext cx="331626" cy="355848"/>
                                              <a:chOff x="787673" y="1721847"/>
                                              <a:chExt cx="306117" cy="355848"/>
                                            </a:xfrm>
                                          </p:grpSpPr>
                                          <p:sp>
                                            <p:nvSpPr>
                                              <p:cNvPr id="110" name="Rounded Rectangle 109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 rot="7287779">
                                                <a:off x="826825" y="1810729"/>
                                                <a:ext cx="355848" cy="178083"/>
                                              </a:xfrm>
                                              <a:prstGeom prst="roundRect">
                                                <a:avLst/>
                                              </a:prstGeom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/>
                                              <a:p>
                                                <a:pPr algn="ctr"/>
                                                <a:endParaRPr lang="en-GB"/>
                                              </a:p>
                                            </p:txBody>
                                          </p:sp>
                                          <p:sp>
                                            <p:nvSpPr>
                                              <p:cNvPr id="111" name="Rounded Rectangle 110"/>
                                              <p:cNvSpPr/>
                                              <p:nvPr/>
                                            </p:nvSpPr>
                                            <p:spPr>
                                              <a:xfrm rot="7287779">
                                                <a:off x="840556" y="1703085"/>
                                                <a:ext cx="179951" cy="285717"/>
                                              </a:xfrm>
                                              <a:prstGeom prst="roundRect">
                                                <a:avLst/>
                                              </a:prstGeom>
                                            </p:spPr>
                                            <p:style>
                                              <a:lnRef idx="2">
                                                <a:schemeClr val="accent1">
                                                  <a:shade val="50000"/>
                                                </a:schemeClr>
                                              </a:lnRef>
                                              <a:fillRef idx="1">
                                                <a:schemeClr val="accent1"/>
                                              </a:fillRef>
                                              <a:effectRef idx="0">
                                                <a:schemeClr val="accent1"/>
                                              </a:effectRef>
                                              <a:fontRef idx="minor">
                                                <a:schemeClr val="lt1"/>
                                              </a:fontRef>
                                            </p:style>
                                            <p:txBody>
                                              <a:bodyPr rtlCol="0" anchor="ctr"/>
                                              <a:lstStyle/>
                                              <a:p>
                                                <a:pPr algn="ctr"/>
                                                <a:endParaRPr lang="en-GB"/>
                                              </a:p>
                                            </p:txBody>
                                          </p:sp>
                                        </p:grpSp>
                                        <p:cxnSp>
                                          <p:nvCxnSpPr>
                                            <p:cNvPr id="107" name="Straight Arrow Connector 106"/>
                                            <p:cNvCxnSpPr/>
                                            <p:nvPr/>
                                          </p:nvCxnSpPr>
                                          <p:spPr>
                                            <a:xfrm>
                                              <a:off x="878716" y="1423024"/>
                                              <a:ext cx="514469" cy="291004"/>
                                            </a:xfrm>
                                            <a:prstGeom prst="straightConnector1">
                                              <a:avLst/>
                                            </a:prstGeom>
                                            <a:ln w="19050">
                                              <a:solidFill>
                                                <a:schemeClr val="tx1"/>
                                              </a:solidFill>
                                              <a:headEnd type="none" w="med" len="med"/>
                                              <a:tailEnd type="triangle" w="med" len="med"/>
                                            </a:ln>
                                          </p:spPr>
                                          <p:style>
                                            <a:lnRef idx="1">
                                              <a:schemeClr val="accent1"/>
                                            </a:lnRef>
                                            <a:fillRef idx="0">
                                              <a:schemeClr val="accent1"/>
                                            </a:fillRef>
                                            <a:effectRef idx="0">
                                              <a:schemeClr val="accent1"/>
                                            </a:effectRef>
                                            <a:fontRef idx="minor">
                                              <a:schemeClr val="tx1"/>
                                            </a:fontRef>
                                          </p:style>
                                        </p:cxnSp>
                                        <p:sp>
                                          <p:nvSpPr>
                                            <p:cNvPr id="108" name="TextBox 107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282891" y="1145507"/>
                                              <a:ext cx="661735" cy="553998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 err="1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TonB</a:t>
                                              </a:r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 system</a:t>
                                              </a:r>
                                            </a:p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EfeU</a:t>
                                              </a:r>
                                            </a:p>
                                          </p:txBody>
                                        </p:sp>
                                        <p:sp>
                                          <p:nvSpPr>
                                            <p:cNvPr id="109" name="TextBox 108"/>
                                            <p:cNvSpPr txBox="1"/>
                                            <p:nvPr/>
                                          </p:nvSpPr>
                                          <p:spPr>
                                            <a:xfrm>
                                              <a:off x="1312596" y="1618037"/>
                                              <a:ext cx="584916" cy="246221"/>
                                            </a:xfrm>
                                            <a:prstGeom prst="rect">
                                              <a:avLst/>
                                            </a:prstGeom>
                                            <a:noFill/>
                                          </p:spPr>
                                          <p:txBody>
                                            <a:bodyPr wrap="square" rtlCol="0">
                                              <a:spAutoFit/>
                                            </a:bodyPr>
                                            <a:lstStyle/>
                                            <a:p>
                                              <a:pPr algn="ctr"/>
                                              <a:r>
                                                <a:rPr lang="en-GB" sz="1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Fe</a:t>
                                              </a:r>
                                              <a:r>
                                                <a:rPr lang="en-GB" sz="1000" baseline="30000" dirty="0">
                                                  <a:latin typeface="Arial" panose="020B0604020202020204" pitchFamily="34" charset="0"/>
                                                  <a:cs typeface="Arial" panose="020B0604020202020204" pitchFamily="34" charset="0"/>
                                                </a:rPr>
                                                <a:t>2+</a:t>
                                              </a:r>
                                            </a:p>
                                          </p:txBody>
                                        </p:sp>
                                      </p:grpSp>
                                      <p:sp>
                                        <p:nvSpPr>
                                          <p:cNvPr id="105" name="Rectangle 104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228350" y="381797"/>
                                            <a:ext cx="1051635" cy="292388"/>
                                          </a:xfrm>
                                          <a:prstGeom prst="rect">
                                            <a:avLst/>
                                          </a:prstGeom>
                                        </p:spPr>
                                        <p:txBody>
                                          <a:bodyPr wrap="none">
                                            <a:spAutoFit/>
                                          </a:bodyPr>
                                          <a:lstStyle/>
                                          <a:p>
                                            <a:r>
                                              <a:rPr lang="en-US" sz="1300" b="1" dirty="0"/>
                                              <a:t>Transporters</a:t>
                                            </a:r>
                                            <a:endParaRPr lang="en-GB" sz="1300" dirty="0"/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82" name="Group 81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7251989" y="3666834"/>
                                          <a:ext cx="1391297" cy="1383993"/>
                                          <a:chOff x="7228136" y="3587324"/>
                                          <a:chExt cx="1391297" cy="1383993"/>
                                        </a:xfrm>
                                      </p:grpSpPr>
                                      <p:sp>
                                        <p:nvSpPr>
                                          <p:cNvPr id="93" name="Rounded Rectangle 92"/>
                                          <p:cNvSpPr/>
                                          <p:nvPr/>
                                        </p:nvSpPr>
                                        <p:spPr>
                                          <a:xfrm rot="20258713">
                                            <a:off x="7790495" y="3969566"/>
                                            <a:ext cx="385502" cy="207640"/>
                                          </a:xfrm>
                                          <a:prstGeom prst="roundRect">
                                            <a:avLst/>
                                          </a:prstGeom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  <p:cxnSp>
                                        <p:nvCxnSpPr>
                                          <p:cNvPr id="94" name="Straight Arrow Connector 93"/>
                                          <p:cNvCxnSpPr/>
                                          <p:nvPr/>
                                        </p:nvCxnSpPr>
                                        <p:spPr>
                                          <a:xfrm flipH="1" flipV="1">
                                            <a:off x="7875059" y="3817406"/>
                                            <a:ext cx="220701" cy="464532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9050">
                                            <a:solidFill>
                                              <a:schemeClr val="tx1"/>
                                            </a:solidFill>
                                            <a:headEnd type="none" w="med" len="med"/>
                                            <a:tailEnd type="triangle" w="med" len="med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95" name="TextBox 94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7228136" y="3587324"/>
                                            <a:ext cx="726599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peptides</a:t>
                                            </a:r>
                                            <a:endParaRPr lang="en-GB" sz="1000" baseline="300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6" name="TextBox 95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7911684" y="4263431"/>
                                            <a:ext cx="707749" cy="707886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i="1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ppA</a:t>
                                            </a:r>
                                            <a:r>
                                              <a:rPr lang="en-GB" sz="1000" i="1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, </a:t>
                                            </a:r>
                                            <a:r>
                                              <a:rPr lang="en-GB" sz="1000" i="1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ppB</a:t>
                                            </a:r>
                                            <a:r>
                                              <a:rPr lang="en-GB" sz="1000" i="1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, </a:t>
                                            </a:r>
                                            <a:r>
                                              <a:rPr lang="en-GB" sz="1000" i="1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ppD</a:t>
                                            </a:r>
                                            <a:r>
                                              <a:rPr lang="en-GB" sz="1000" i="1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, </a:t>
                                            </a:r>
                                            <a:r>
                                              <a:rPr lang="en-GB" sz="1000" i="1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ppF</a:t>
                                            </a:r>
                                            <a:r>
                                              <a:rPr lang="en-GB" sz="1000" i="1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           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7" name="Oval 96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7758706" y="3935447"/>
                                            <a:ext cx="117000" cy="108000"/>
                                          </a:xfrm>
                                          <a:prstGeom prst="ellipse">
                                            <a:avLst/>
                                          </a:prstGeom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8" name="Oval 97"/>
                                          <p:cNvSpPr/>
                                          <p:nvPr/>
                                        </p:nvSpPr>
                                        <p:spPr>
                                          <a:xfrm>
                                            <a:off x="7961480" y="3857139"/>
                                            <a:ext cx="117000" cy="108000"/>
                                          </a:xfrm>
                                          <a:prstGeom prst="ellipse">
                                            <a:avLst/>
                                          </a:prstGeom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83" name="Group 82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7965345" y="3400846"/>
                                          <a:ext cx="1844253" cy="1009671"/>
                                          <a:chOff x="7981247" y="3408797"/>
                                          <a:chExt cx="1844253" cy="1009671"/>
                                        </a:xfrm>
                                      </p:grpSpPr>
                                      <p:sp>
                                        <p:nvSpPr>
                                          <p:cNvPr id="89" name="Rounded Rectangle 88"/>
                                          <p:cNvSpPr/>
                                          <p:nvPr/>
                                        </p:nvSpPr>
                                        <p:spPr>
                                          <a:xfrm rot="19769577">
                                            <a:off x="8419980" y="3543477"/>
                                            <a:ext cx="594975" cy="360116"/>
                                          </a:xfrm>
                                          <a:prstGeom prst="roundRect">
                                            <a:avLst/>
                                          </a:prstGeom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  <p:cxnSp>
                                        <p:nvCxnSpPr>
                                          <p:cNvPr id="90" name="Straight Arrow Connector 89"/>
                                          <p:cNvCxnSpPr/>
                                          <p:nvPr/>
                                        </p:nvCxnSpPr>
                                        <p:spPr>
                                          <a:xfrm>
                                            <a:off x="8585000" y="3483523"/>
                                            <a:ext cx="365438" cy="589068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9050">
                                            <a:solidFill>
                                              <a:schemeClr val="tx1"/>
                                            </a:solidFill>
                                            <a:headEnd type="none" w="med" len="med"/>
                                            <a:tailEnd type="triangle" w="med" len="med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91" name="TextBox 90">
                                            <a:extLst>
                                              <a:ext uri="{FF2B5EF4-FFF2-40B4-BE49-F238E27FC236}">
                                                <a16:creationId xmlns:a16="http://schemas.microsoft.com/office/drawing/2014/main" xmlns="" id="{317188D3-5C9A-9C48-9CDE-C972F996C1E9}"/>
                                              </a:ext>
                                            </a:extLst>
                                          </p:cNvPr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8824906" y="4110691"/>
                                            <a:ext cx="1000594" cy="307777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none" tIns="0" bIns="0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TAT transport </a:t>
                                            </a:r>
                                          </a:p>
                                          <a:p>
                                            <a:pPr algn="ctr"/>
                                            <a:r>
                                              <a:rPr lang="en-US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system</a:t>
                                            </a: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92" name="TextBox 91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7981247" y="3408797"/>
                                            <a:ext cx="726599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proteins</a:t>
                                            </a:r>
                                            <a:endParaRPr lang="en-GB" sz="1000" baseline="300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</p:txBody>
                                      </p:sp>
                                    </p:grpSp>
                                    <p:grpSp>
                                      <p:nvGrpSpPr>
                                        <p:cNvPr id="84" name="Group 83"/>
                                        <p:cNvGrpSpPr/>
                                        <p:nvPr/>
                                      </p:nvGrpSpPr>
                                      <p:grpSpPr>
                                        <a:xfrm>
                                          <a:off x="1437418" y="3343841"/>
                                          <a:ext cx="2143452" cy="1213434"/>
                                          <a:chOff x="1524879" y="3281750"/>
                                          <a:chExt cx="2143452" cy="1213434"/>
                                        </a:xfrm>
                                      </p:grpSpPr>
                                      <p:sp>
                                        <p:nvSpPr>
                                          <p:cNvPr id="85" name="Rounded Rectangle 84"/>
                                          <p:cNvSpPr/>
                                          <p:nvPr/>
                                        </p:nvSpPr>
                                        <p:spPr>
                                          <a:xfrm rot="12374127">
                                            <a:off x="2063938" y="3836525"/>
                                            <a:ext cx="594975" cy="360116"/>
                                          </a:xfrm>
                                          <a:prstGeom prst="roundRect">
                                            <a:avLst/>
                                          </a:prstGeom>
                                        </p:spPr>
                                        <p:style>
                                          <a:lnRef idx="2">
                                            <a:schemeClr val="accent1">
                                              <a:shade val="50000"/>
                                            </a:schemeClr>
                                          </a:lnRef>
                                          <a:fillRef idx="1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lt1"/>
                                          </a:fontRef>
                                        </p:style>
                                        <p:txBody>
                                          <a:bodyPr rtlCol="0" anchor="ctr"/>
                                          <a:lstStyle/>
                                          <a:p>
                                            <a:pPr algn="ctr"/>
                                            <a:endParaRPr lang="en-GB"/>
                                          </a:p>
                                        </p:txBody>
                                      </p:sp>
                                      <p:cxnSp>
                                        <p:nvCxnSpPr>
                                          <p:cNvPr id="86" name="Straight Arrow Connector 85"/>
                                          <p:cNvCxnSpPr/>
                                          <p:nvPr/>
                                        </p:nvCxnSpPr>
                                        <p:spPr>
                                          <a:xfrm rot="14204550">
                                            <a:off x="2158592" y="3769409"/>
                                            <a:ext cx="365438" cy="540000"/>
                                          </a:xfrm>
                                          <a:prstGeom prst="straightConnector1">
                                            <a:avLst/>
                                          </a:prstGeom>
                                          <a:ln w="19050">
                                            <a:solidFill>
                                              <a:schemeClr val="tx1"/>
                                            </a:solidFill>
                                            <a:headEnd type="none" w="med" len="med"/>
                                            <a:tailEnd type="triangle" w="med" len="med"/>
                                          </a:ln>
                                        </p:spPr>
                                        <p:style>
                                          <a:lnRef idx="1">
                                            <a:schemeClr val="accent1"/>
                                          </a:lnRef>
                                          <a:fillRef idx="0">
                                            <a:schemeClr val="accent1"/>
                                          </a:fillRef>
                                          <a:effectRef idx="0">
                                            <a:schemeClr val="accent1"/>
                                          </a:effectRef>
                                          <a:fontRef idx="minor">
                                            <a:schemeClr val="tx1"/>
                                          </a:fontRef>
                                        </p:style>
                                      </p:cxnSp>
                                      <p:sp>
                                        <p:nvSpPr>
                                          <p:cNvPr id="87" name="TextBox 86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1524879" y="4248963"/>
                                            <a:ext cx="707749" cy="246221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i="1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opuABC</a:t>
                                            </a:r>
                                            <a:endParaRPr lang="en-GB" sz="1000" i="1" baseline="300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</p:txBody>
                                      </p:sp>
                                      <p:sp>
                                        <p:nvSpPr>
                                          <p:cNvPr id="88" name="TextBox 87"/>
                                          <p:cNvSpPr txBox="1"/>
                                          <p:nvPr/>
                                        </p:nvSpPr>
                                        <p:spPr>
                                          <a:xfrm>
                                            <a:off x="2413862" y="3281750"/>
                                            <a:ext cx="1254469" cy="677108"/>
                                          </a:xfrm>
                                          <a:prstGeom prst="rect">
                                            <a:avLst/>
                                          </a:prstGeom>
                                          <a:noFill/>
                                        </p:spPr>
                                        <p:txBody>
                                          <a:bodyPr wrap="square" rtlCol="0">
                                            <a:spAutoFit/>
                                          </a:bodyPr>
                                          <a:lstStyle/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Glycine betaine</a:t>
                                            </a:r>
                                          </a:p>
                                          <a:p>
                                            <a:pPr algn="ctr"/>
                                            <a:endParaRPr lang="en-GB" sz="8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Choline </a:t>
                                            </a:r>
                                            <a:r>
                                              <a:rPr lang="en-GB" sz="1000" dirty="0" err="1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sulfate</a:t>
                                            </a:r>
                                            <a:endParaRPr lang="en-GB" sz="1000" dirty="0">
                                              <a:latin typeface="Arial" panose="020B0604020202020204" pitchFamily="34" charset="0"/>
                                              <a:cs typeface="Arial" panose="020B0604020202020204" pitchFamily="34" charset="0"/>
                                            </a:endParaRPr>
                                          </a:p>
                                          <a:p>
                                            <a:pPr algn="ctr"/>
                                            <a:r>
                                              <a:rPr lang="en-GB" sz="1000" dirty="0">
                                                <a:latin typeface="Arial" panose="020B0604020202020204" pitchFamily="34" charset="0"/>
                                                <a:cs typeface="Arial" panose="020B0604020202020204" pitchFamily="34" charset="0"/>
                                              </a:rPr>
                                              <a:t>Carnitine</a:t>
                                            </a:r>
                                          </a:p>
                                        </p:txBody>
                                      </p:sp>
                                    </p:grpSp>
                                  </p:grpSp>
                                </p:grpSp>
                              </p:grpSp>
                              <p:sp>
                                <p:nvSpPr>
                                  <p:cNvPr id="72" name="Rounded Rectangle 71"/>
                                  <p:cNvSpPr/>
                                  <p:nvPr/>
                                </p:nvSpPr>
                                <p:spPr>
                                  <a:xfrm rot="21164760">
                                    <a:off x="6132635" y="4495524"/>
                                    <a:ext cx="385502" cy="207640"/>
                                  </a:xfrm>
                                  <a:prstGeom prst="roundRect">
                                    <a:avLst/>
                                  </a:prstGeom>
                                </p:spPr>
                                <p:style>
                                  <a:lnRef idx="2">
                                    <a:schemeClr val="accent1">
                                      <a:shade val="50000"/>
                                    </a:schemeClr>
                                  </a:lnRef>
                                  <a:fillRef idx="1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lt1"/>
                                  </a:fontRef>
                                </p:style>
                                <p:txBody>
                                  <a:bodyPr rtlCol="0" anchor="ctr"/>
                                  <a:lstStyle/>
                                  <a:p>
                                    <a:pPr algn="ctr"/>
                                    <a:endParaRPr lang="en-GB"/>
                                  </a:p>
                                </p:txBody>
                              </p:sp>
                              <p:sp>
                                <p:nvSpPr>
                                  <p:cNvPr id="73" name="TextBox 72"/>
                                  <p:cNvSpPr txBox="1"/>
                                  <p:nvPr/>
                                </p:nvSpPr>
                                <p:spPr>
                                  <a:xfrm>
                                    <a:off x="6452062" y="4428527"/>
                                    <a:ext cx="430854" cy="246221"/>
                                  </a:xfrm>
                                  <a:prstGeom prst="rect">
                                    <a:avLst/>
                                  </a:prstGeom>
                                  <a:noFill/>
                                </p:spPr>
                                <p:txBody>
                                  <a:bodyPr wrap="square" rtlCol="0">
                                    <a:spAutoFit/>
                                  </a:bodyPr>
                                  <a:lstStyle/>
                                  <a:p>
                                    <a:pPr algn="ctr"/>
                                    <a:r>
                                      <a:rPr lang="en-GB" sz="1000" i="1" dirty="0" err="1">
                                        <a:latin typeface="Arial" panose="020B0604020202020204" pitchFamily="34" charset="0"/>
                                        <a:cs typeface="Arial" panose="020B0604020202020204" pitchFamily="34" charset="0"/>
                                      </a:rPr>
                                      <a:t>fdh</a:t>
                                    </a:r>
                                    <a:endParaRPr lang="en-GB" sz="1000" i="1" baseline="30000" dirty="0">
                                      <a:latin typeface="Arial" panose="020B0604020202020204" pitchFamily="34" charset="0"/>
                                      <a:cs typeface="Arial" panose="020B0604020202020204" pitchFamily="34" charset="0"/>
                                    </a:endParaRPr>
                                  </a:p>
                                </p:txBody>
                              </p:sp>
                              <p:cxnSp>
                                <p:nvCxnSpPr>
                                  <p:cNvPr id="74" name="Straight Arrow Connector 73">
                                    <a:extLst>
                                      <a:ext uri="{FF2B5EF4-FFF2-40B4-BE49-F238E27FC236}">
                                        <a16:creationId xmlns:a16="http://schemas.microsoft.com/office/drawing/2014/main" xmlns="" id="{122EA4EC-1949-8C46-9213-36FBA8C4E38D}"/>
                                      </a:ext>
                                    </a:extLst>
                                  </p:cNvPr>
                                  <p:cNvCxnSpPr>
                                    <a:cxnSpLocks/>
                                  </p:cNvCxnSpPr>
                                  <p:nvPr/>
                                </p:nvCxnSpPr>
                                <p:spPr>
                                  <a:xfrm>
                                    <a:off x="6292805" y="4321808"/>
                                    <a:ext cx="89088" cy="576000"/>
                                  </a:xfrm>
                                  <a:prstGeom prst="straightConnector1">
                                    <a:avLst/>
                                  </a:prstGeom>
                                  <a:ln w="12700">
                                    <a:solidFill>
                                      <a:schemeClr val="tx1"/>
                                    </a:solidFill>
                                    <a:tailEnd type="triangle"/>
                                  </a:ln>
                                </p:spPr>
                                <p:style>
                                  <a:lnRef idx="1">
                                    <a:schemeClr val="accent1"/>
                                  </a:lnRef>
                                  <a:fillRef idx="0">
                                    <a:schemeClr val="accent1"/>
                                  </a:fillRef>
                                  <a:effectRef idx="0">
                                    <a:schemeClr val="accent1"/>
                                  </a:effectRef>
                                  <a:fontRef idx="minor">
                                    <a:schemeClr val="tx1"/>
                                  </a:fontRef>
                                </p:style>
                              </p:cxnSp>
                            </p:grpSp>
                          </p:grpSp>
                          <p:sp>
                            <p:nvSpPr>
                              <p:cNvPr id="64" name="TextBox 63"/>
                              <p:cNvSpPr txBox="1"/>
                              <p:nvPr/>
                            </p:nvSpPr>
                            <p:spPr>
                              <a:xfrm>
                                <a:off x="2962025" y="2247277"/>
                                <a:ext cx="922969" cy="246221"/>
                              </a:xfrm>
                              <a:prstGeom prst="rect">
                                <a:avLst/>
                              </a:prstGeom>
                              <a:noFill/>
                            </p:spPr>
                            <p:txBody>
                              <a:bodyPr wrap="square" rtlCol="0">
                                <a:spAutoFit/>
                              </a:bodyPr>
                              <a:lstStyle/>
                              <a:p>
                                <a:pPr algn="ctr"/>
                                <a:r>
                                  <a:rPr lang="en-GB" sz="1000" dirty="0" err="1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rPr>
                                  <a:t>Myo</a:t>
                                </a:r>
                                <a:r>
                                  <a:rPr lang="en-GB" sz="1000" dirty="0">
                                    <a:latin typeface="Arial" panose="020B0604020202020204" pitchFamily="34" charset="0"/>
                                    <a:cs typeface="Arial" panose="020B0604020202020204" pitchFamily="34" charset="0"/>
                                  </a:rPr>
                                  <a:t>-Inositol</a:t>
                                </a:r>
                                <a:endParaRPr lang="en-GB" sz="1000" baseline="30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endParaRPr>
                              </a:p>
                            </p:txBody>
                          </p:sp>
                          <p:cxnSp>
                            <p:nvCxnSpPr>
                              <p:cNvPr id="65" name="Straight Arrow Connector 64">
                                <a:extLst>
                                  <a:ext uri="{FF2B5EF4-FFF2-40B4-BE49-F238E27FC236}">
                                    <a16:creationId xmlns:a16="http://schemas.microsoft.com/office/drawing/2014/main" xmlns="" id="{122EA4EC-1949-8C46-9213-36FBA8C4E38D}"/>
                                  </a:ext>
                                </a:extLst>
                              </p:cNvPr>
                              <p:cNvCxnSpPr>
                                <a:cxnSpLocks/>
                              </p:cNvCxnSpPr>
                              <p:nvPr/>
                            </p:nvCxnSpPr>
                            <p:spPr>
                              <a:xfrm rot="16200000">
                                <a:off x="3976695" y="2255499"/>
                                <a:ext cx="0" cy="229340"/>
                              </a:xfrm>
                              <a:prstGeom prst="straightConnector1">
                                <a:avLst/>
                              </a:prstGeom>
                              <a:ln w="12700">
                                <a:solidFill>
                                  <a:schemeClr val="tx1"/>
                                </a:solidFill>
                                <a:prstDash val="sysDash"/>
                                <a:tailEnd type="triangle"/>
                              </a:ln>
                            </p:spPr>
                            <p:style>
                              <a:lnRef idx="1">
                                <a:schemeClr val="accent1"/>
                              </a:lnRef>
                              <a:fillRef idx="0">
                                <a:schemeClr val="accent1"/>
                              </a:fillRef>
                              <a:effectRef idx="0">
                                <a:schemeClr val="accent1"/>
                              </a:effectRef>
                              <a:fontRef idx="minor">
                                <a:schemeClr val="tx1"/>
                              </a:fontRef>
                            </p:style>
                          </p:cxnSp>
                        </p:grpSp>
                        <p:sp>
                          <p:nvSpPr>
                            <p:cNvPr id="57" name="Rounded Rectangle 56"/>
                            <p:cNvSpPr/>
                            <p:nvPr/>
                          </p:nvSpPr>
                          <p:spPr>
                            <a:xfrm rot="8272256">
                              <a:off x="1187943" y="1112715"/>
                              <a:ext cx="355848" cy="290206"/>
                            </a:xfrm>
                            <a:prstGeom prst="roundRect">
                              <a:avLst/>
                            </a:prstGeom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GB"/>
                            </a:p>
                          </p:txBody>
                        </p:sp>
                        <p:cxnSp>
                          <p:nvCxnSpPr>
                            <p:cNvPr id="58" name="Straight Arrow Connector 57"/>
                            <p:cNvCxnSpPr/>
                            <p:nvPr/>
                          </p:nvCxnSpPr>
                          <p:spPr>
                            <a:xfrm>
                              <a:off x="1203631" y="1081424"/>
                              <a:ext cx="359723" cy="379507"/>
                            </a:xfrm>
                            <a:prstGeom prst="straightConnector1">
                              <a:avLst/>
                            </a:prstGeom>
                            <a:ln w="19050">
                              <a:solidFill>
                                <a:schemeClr val="tx1"/>
                              </a:solidFill>
                              <a:headEnd type="none" w="med" len="med"/>
                              <a:tailEnd type="triangle" w="med" len="med"/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59" name="TextBox 58"/>
                            <p:cNvSpPr txBox="1"/>
                            <p:nvPr/>
                          </p:nvSpPr>
                          <p:spPr>
                            <a:xfrm>
                              <a:off x="748073" y="893253"/>
                              <a:ext cx="483403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GB" sz="1000" i="1" dirty="0" err="1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sulP</a:t>
                              </a:r>
                              <a:endParaRPr lang="en-GB" sz="1000" i="1" baseline="30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60" name="TextBox 59"/>
                            <p:cNvSpPr txBox="1"/>
                            <p:nvPr/>
                          </p:nvSpPr>
                          <p:spPr>
                            <a:xfrm>
                              <a:off x="1473377" y="1435339"/>
                              <a:ext cx="531742" cy="2462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GB" sz="1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SO</a:t>
                              </a:r>
                              <a:r>
                                <a:rPr lang="en-GB" sz="1000" baseline="-25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4</a:t>
                              </a:r>
                              <a:r>
                                <a:rPr lang="en-GB" sz="1000" baseline="30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2-</a:t>
                              </a:r>
                            </a:p>
                          </p:txBody>
                        </p:sp>
                        <p:cxnSp>
                          <p:nvCxnSpPr>
                            <p:cNvPr id="61" name="Straight Arrow Connector 60">
                              <a:extLst>
                                <a:ext uri="{FF2B5EF4-FFF2-40B4-BE49-F238E27FC236}">
                                  <a16:creationId xmlns:a16="http://schemas.microsoft.com/office/drawing/2014/main" xmlns="" id="{122EA4EC-1949-8C46-9213-36FBA8C4E38D}"/>
                                </a:ext>
                              </a:extLst>
                            </p:cNvPr>
                            <p:cNvCxnSpPr>
                              <a:cxnSpLocks/>
                            </p:cNvCxnSpPr>
                            <p:nvPr/>
                          </p:nvCxnSpPr>
                          <p:spPr>
                            <a:xfrm rot="16200000">
                              <a:off x="3462852" y="3685607"/>
                              <a:ext cx="0" cy="288000"/>
                            </a:xfrm>
                            <a:prstGeom prst="straightConnector1">
                              <a:avLst/>
                            </a:prstGeom>
                            <a:ln w="12700">
                              <a:solidFill>
                                <a:schemeClr val="tx1"/>
                              </a:solidFill>
                              <a:tailEnd type="triangle"/>
                            </a:ln>
                          </p:spPr>
                          <p:style>
                            <a:lnRef idx="1">
                              <a:schemeClr val="accent1"/>
                            </a:lnRef>
                            <a:fillRef idx="0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62" name="TextBox 61"/>
                            <p:cNvSpPr txBox="1"/>
                            <p:nvPr/>
                          </p:nvSpPr>
                          <p:spPr>
                            <a:xfrm>
                              <a:off x="3536191" y="3708779"/>
                              <a:ext cx="641415" cy="440121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pPr algn="ctr"/>
                              <a:r>
                                <a:rPr lang="en-GB" sz="1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Choline </a:t>
                              </a:r>
                            </a:p>
                            <a:p>
                              <a:pPr algn="ctr"/>
                              <a:r>
                                <a:rPr lang="en-GB" sz="1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+ SO</a:t>
                              </a:r>
                              <a:r>
                                <a:rPr lang="en-GB" sz="1000" baseline="-25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4</a:t>
                              </a:r>
                              <a:r>
                                <a:rPr lang="en-GB" sz="1000" baseline="30000" dirty="0">
                                  <a:latin typeface="Arial" panose="020B0604020202020204" pitchFamily="34" charset="0"/>
                                  <a:cs typeface="Arial" panose="020B0604020202020204" pitchFamily="34" charset="0"/>
                                </a:rPr>
                                <a:t>2-</a:t>
                              </a:r>
                            </a:p>
                          </p:txBody>
                        </p:sp>
                      </p:grpSp>
                      <p:sp>
                        <p:nvSpPr>
                          <p:cNvPr id="52" name="Rounded Rectangle 51"/>
                          <p:cNvSpPr/>
                          <p:nvPr/>
                        </p:nvSpPr>
                        <p:spPr>
                          <a:xfrm rot="8696924">
                            <a:off x="1657688" y="772002"/>
                            <a:ext cx="355848" cy="290206"/>
                          </a:xfrm>
                          <a:prstGeom prst="roundRect">
                            <a:avLst/>
                          </a:prstGeom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GB"/>
                          </a:p>
                        </p:txBody>
                      </p:sp>
                      <p:cxnSp>
                        <p:nvCxnSpPr>
                          <p:cNvPr id="53" name="Straight Arrow Connector 52"/>
                          <p:cNvCxnSpPr/>
                          <p:nvPr/>
                        </p:nvCxnSpPr>
                        <p:spPr>
                          <a:xfrm>
                            <a:off x="1700677" y="721883"/>
                            <a:ext cx="304442" cy="460272"/>
                          </a:xfrm>
                          <a:prstGeom prst="straightConnector1">
                            <a:avLst/>
                          </a:prstGeom>
                          <a:ln w="19050">
                            <a:solidFill>
                              <a:schemeClr val="tx1"/>
                            </a:solidFill>
                            <a:headEnd type="none" w="med" len="med"/>
                            <a:tailEnd type="triangle" w="med" len="med"/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54" name="TextBox 53"/>
                          <p:cNvSpPr txBox="1"/>
                          <p:nvPr/>
                        </p:nvSpPr>
                        <p:spPr>
                          <a:xfrm>
                            <a:off x="1783443" y="1170695"/>
                            <a:ext cx="531742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O</a:t>
                            </a:r>
                            <a:r>
                              <a:rPr lang="en-GB" sz="1000" baseline="-25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4</a:t>
                            </a:r>
                            <a:r>
                              <a:rPr lang="en-GB" sz="1000" baseline="30000" dirty="0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3-</a:t>
                            </a:r>
                          </a:p>
                        </p:txBody>
                      </p:sp>
                      <p:sp>
                        <p:nvSpPr>
                          <p:cNvPr id="55" name="TextBox 54"/>
                          <p:cNvSpPr txBox="1"/>
                          <p:nvPr/>
                        </p:nvSpPr>
                        <p:spPr>
                          <a:xfrm>
                            <a:off x="1263042" y="548180"/>
                            <a:ext cx="483403" cy="246221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pPr algn="ctr"/>
                            <a:r>
                              <a:rPr lang="en-GB" sz="1000" i="1" dirty="0" err="1">
                                <a:latin typeface="Arial" panose="020B0604020202020204" pitchFamily="34" charset="0"/>
                                <a:cs typeface="Arial" panose="020B0604020202020204" pitchFamily="34" charset="0"/>
                              </a:rPr>
                              <a:t>pstA</a:t>
                            </a:r>
                            <a:endParaRPr lang="en-GB" sz="1000" i="1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endParaRPr>
                          </a:p>
                        </p:txBody>
                      </p:sp>
                    </p:grpSp>
                    <p:sp>
                      <p:nvSpPr>
                        <p:cNvPr id="32" name="Hexagon 31"/>
                        <p:cNvSpPr/>
                        <p:nvPr/>
                      </p:nvSpPr>
                      <p:spPr>
                        <a:xfrm rot="1981454">
                          <a:off x="8521240" y="793049"/>
                          <a:ext cx="289542" cy="294246"/>
                        </a:xfrm>
                        <a:prstGeom prst="hexagon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  <p:sp>
                      <p:nvSpPr>
                        <p:cNvPr id="33" name="Rectangle 32"/>
                        <p:cNvSpPr/>
                        <p:nvPr/>
                      </p:nvSpPr>
                      <p:spPr>
                        <a:xfrm>
                          <a:off x="8502528" y="1417783"/>
                          <a:ext cx="893422" cy="307776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-type </a:t>
                          </a:r>
                        </a:p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cytochrome</a:t>
                          </a:r>
                        </a:p>
                      </p:txBody>
                    </p:sp>
                    <p:sp>
                      <p:nvSpPr>
                        <p:cNvPr id="34" name="Hexagon 33"/>
                        <p:cNvSpPr/>
                        <p:nvPr/>
                      </p:nvSpPr>
                      <p:spPr>
                        <a:xfrm rot="2758021">
                          <a:off x="9181172" y="1304020"/>
                          <a:ext cx="289542" cy="294246"/>
                        </a:xfrm>
                        <a:prstGeom prst="hexagon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  <p:sp>
                      <p:nvSpPr>
                        <p:cNvPr id="35" name="Rectangle 34"/>
                        <p:cNvSpPr/>
                        <p:nvPr/>
                      </p:nvSpPr>
                      <p:spPr>
                        <a:xfrm>
                          <a:off x="8009786" y="1074222"/>
                          <a:ext cx="893422" cy="33855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uccinate dehydrogenase</a:t>
                          </a:r>
                        </a:p>
                      </p:txBody>
                    </p:sp>
                    <p:sp>
                      <p:nvSpPr>
                        <p:cNvPr id="36" name="Arc 35">
                          <a:extLst>
                            <a:ext uri="{FF2B5EF4-FFF2-40B4-BE49-F238E27FC236}">
                              <a16:creationId xmlns:a16="http://schemas.microsoft.com/office/drawing/2014/main" xmlns="" id="{483EE1BC-1FD0-0F4F-A672-BCB19CB4E17D}"/>
                            </a:ext>
                          </a:extLst>
                        </p:cNvPr>
                        <p:cNvSpPr/>
                        <p:nvPr/>
                      </p:nvSpPr>
                      <p:spPr>
                        <a:xfrm rot="12840214">
                          <a:off x="8509599" y="491850"/>
                          <a:ext cx="720000" cy="360000"/>
                        </a:xfrm>
                        <a:prstGeom prst="arc">
                          <a:avLst>
                            <a:gd name="adj1" fmla="val 10643507"/>
                            <a:gd name="adj2" fmla="val 21476951"/>
                          </a:avLst>
                        </a:prstGeom>
                        <a:ln w="12700">
                          <a:solidFill>
                            <a:schemeClr val="tx1"/>
                          </a:solidFill>
                          <a:headEnd type="none"/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/>
                        </a:p>
                      </p:txBody>
                    </p:sp>
                    <p:sp>
                      <p:nvSpPr>
                        <p:cNvPr id="37" name="Rectangle 36"/>
                        <p:cNvSpPr/>
                        <p:nvPr/>
                      </p:nvSpPr>
                      <p:spPr>
                        <a:xfrm>
                          <a:off x="8962279" y="662393"/>
                          <a:ext cx="671241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uccinate</a:t>
                          </a:r>
                        </a:p>
                      </p:txBody>
                    </p:sp>
                    <p:sp>
                      <p:nvSpPr>
                        <p:cNvPr id="38" name="Rectangle 37"/>
                        <p:cNvSpPr/>
                        <p:nvPr/>
                      </p:nvSpPr>
                      <p:spPr>
                        <a:xfrm>
                          <a:off x="8263299" y="268747"/>
                          <a:ext cx="671241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umarate</a:t>
                          </a:r>
                        </a:p>
                      </p:txBody>
                    </p:sp>
                    <p:cxnSp>
                      <p:nvCxnSpPr>
                        <p:cNvPr id="39" name="Straight Arrow Connector 38">
                          <a:extLst>
                            <a:ext uri="{FF2B5EF4-FFF2-40B4-BE49-F238E27FC236}">
                              <a16:creationId xmlns:a16="http://schemas.microsoft.com/office/drawing/2014/main" xmlns="" id="{122EA4EC-1949-8C46-9213-36FBA8C4E38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8301639" y="718433"/>
                          <a:ext cx="176805" cy="114459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prstDash val="sysDash"/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0" name="Rectangle 39"/>
                        <p:cNvSpPr/>
                        <p:nvPr/>
                      </p:nvSpPr>
                      <p:spPr>
                        <a:xfrm>
                          <a:off x="8064783" y="586988"/>
                          <a:ext cx="284672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e</a:t>
                          </a:r>
                          <a:r>
                            <a:rPr lang="en-US" sz="800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cxnSp>
                      <p:nvCxnSpPr>
                        <p:cNvPr id="41" name="Straight Arrow Connector 40">
                          <a:extLst>
                            <a:ext uri="{FF2B5EF4-FFF2-40B4-BE49-F238E27FC236}">
                              <a16:creationId xmlns:a16="http://schemas.microsoft.com/office/drawing/2014/main" xmlns="" id="{122EA4EC-1949-8C46-9213-36FBA8C4E38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9044188" y="1190224"/>
                          <a:ext cx="136942" cy="138183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prstDash val="sysDash"/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2" name="Rectangle 41"/>
                        <p:cNvSpPr/>
                        <p:nvPr/>
                      </p:nvSpPr>
                      <p:spPr>
                        <a:xfrm>
                          <a:off x="8846977" y="1050698"/>
                          <a:ext cx="284672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e</a:t>
                          </a:r>
                          <a:r>
                            <a:rPr lang="en-US" sz="800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sp>
                      <p:nvSpPr>
                        <p:cNvPr id="43" name="Hexagon 42"/>
                        <p:cNvSpPr/>
                        <p:nvPr/>
                      </p:nvSpPr>
                      <p:spPr>
                        <a:xfrm rot="4272206">
                          <a:off x="9547923" y="1945146"/>
                          <a:ext cx="289542" cy="294246"/>
                        </a:xfrm>
                        <a:prstGeom prst="hexagon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  <p:cxnSp>
                      <p:nvCxnSpPr>
                        <p:cNvPr id="44" name="Straight Arrow Connector 43">
                          <a:extLst>
                            <a:ext uri="{FF2B5EF4-FFF2-40B4-BE49-F238E27FC236}">
                              <a16:creationId xmlns:a16="http://schemas.microsoft.com/office/drawing/2014/main" xmlns="" id="{122EA4EC-1949-8C46-9213-36FBA8C4E38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H="1" flipV="1">
                          <a:off x="9526261" y="1741792"/>
                          <a:ext cx="100276" cy="18000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prstDash val="sysDash"/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5" name="Rectangle 44"/>
                        <p:cNvSpPr/>
                        <p:nvPr/>
                      </p:nvSpPr>
                      <p:spPr>
                        <a:xfrm>
                          <a:off x="9373590" y="1574557"/>
                          <a:ext cx="284672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e</a:t>
                          </a:r>
                          <a:r>
                            <a:rPr lang="en-US" sz="800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sp>
                      <p:nvSpPr>
                        <p:cNvPr id="46" name="Rectangle 45"/>
                        <p:cNvSpPr/>
                        <p:nvPr/>
                      </p:nvSpPr>
                      <p:spPr>
                        <a:xfrm>
                          <a:off x="8734419" y="1868832"/>
                          <a:ext cx="893422" cy="461665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ADH-ubiquinone oxidoreductase</a:t>
                          </a:r>
                        </a:p>
                      </p:txBody>
                    </p:sp>
                    <p:sp>
                      <p:nvSpPr>
                        <p:cNvPr id="47" name="Hexagon 46"/>
                        <p:cNvSpPr/>
                        <p:nvPr/>
                      </p:nvSpPr>
                      <p:spPr>
                        <a:xfrm rot="6228272">
                          <a:off x="9560784" y="2713889"/>
                          <a:ext cx="289542" cy="294246"/>
                        </a:xfrm>
                        <a:prstGeom prst="hexagon">
                          <a:avLst/>
                        </a:prstGeom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GB"/>
                        </a:p>
                      </p:txBody>
                    </p:sp>
                    <p:cxnSp>
                      <p:nvCxnSpPr>
                        <p:cNvPr id="48" name="Straight Arrow Connector 47">
                          <a:extLst>
                            <a:ext uri="{FF2B5EF4-FFF2-40B4-BE49-F238E27FC236}">
                              <a16:creationId xmlns:a16="http://schemas.microsoft.com/office/drawing/2014/main" xmlns="" id="{122EA4EC-1949-8C46-9213-36FBA8C4E38D}"/>
                            </a:ext>
                          </a:extLst>
                        </p:cNvPr>
                        <p:cNvCxnSpPr>
                          <a:cxnSpLocks/>
                        </p:cNvCxnSpPr>
                        <p:nvPr/>
                      </p:nvCxnSpPr>
                      <p:spPr>
                        <a:xfrm flipV="1">
                          <a:off x="9746647" y="2484318"/>
                          <a:ext cx="17240" cy="180000"/>
                        </a:xfrm>
                        <a:prstGeom prst="straightConnector1">
                          <a:avLst/>
                        </a:prstGeom>
                        <a:ln w="12700">
                          <a:solidFill>
                            <a:schemeClr val="tx1"/>
                          </a:solidFill>
                          <a:prstDash val="sysDash"/>
                          <a:tailEnd type="triangle"/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49" name="Rectangle 48"/>
                        <p:cNvSpPr/>
                        <p:nvPr/>
                      </p:nvSpPr>
                      <p:spPr>
                        <a:xfrm>
                          <a:off x="9629502" y="2284776"/>
                          <a:ext cx="284672" cy="21544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e</a:t>
                          </a:r>
                          <a:r>
                            <a:rPr lang="en-US" sz="800" baseline="300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-</a:t>
                          </a:r>
                        </a:p>
                      </p:txBody>
                    </p:sp>
                    <p:sp>
                      <p:nvSpPr>
                        <p:cNvPr id="50" name="Rectangle 49"/>
                        <p:cNvSpPr/>
                        <p:nvPr/>
                      </p:nvSpPr>
                      <p:spPr>
                        <a:xfrm>
                          <a:off x="8705970" y="2564610"/>
                          <a:ext cx="893422" cy="338554"/>
                        </a:xfrm>
                        <a:prstGeom prst="rect">
                          <a:avLst/>
                        </a:prstGeom>
                      </p:spPr>
                      <p:txBody>
                        <a:bodyPr wrap="square">
                          <a:spAutoFit/>
                        </a:bodyPr>
                        <a:lstStyle/>
                        <a:p>
                          <a:pPr algn="ctr"/>
                          <a:r>
                            <a:rPr lang="en-US" sz="8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Glucose dehydrogenase</a:t>
                          </a:r>
                        </a:p>
                      </p:txBody>
                    </p:sp>
                  </p:grpSp>
                </p:grpSp>
                <p:cxnSp>
                  <p:nvCxnSpPr>
                    <p:cNvPr id="24" name="Straight Arrow Connector 23">
                      <a:extLst>
                        <a:ext uri="{FF2B5EF4-FFF2-40B4-BE49-F238E27FC236}">
                          <a16:creationId xmlns:a16="http://schemas.microsoft.com/office/drawing/2014/main" xmlns="" id="{122EA4EC-1949-8C46-9213-36FBA8C4E38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5408917" y="3978857"/>
                      <a:ext cx="0" cy="252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headEnd type="non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" name="TextBox 24"/>
                    <p:cNvSpPr txBox="1"/>
                    <p:nvPr/>
                  </p:nvSpPr>
                  <p:spPr>
                    <a:xfrm>
                      <a:off x="4837365" y="3981746"/>
                      <a:ext cx="48365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en-GB" sz="1000" baseline="-25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6" name="TextBox 25"/>
                    <p:cNvSpPr txBox="1"/>
                    <p:nvPr/>
                  </p:nvSpPr>
                  <p:spPr>
                    <a:xfrm>
                      <a:off x="4175968" y="3982624"/>
                      <a:ext cx="53759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</a:t>
                      </a:r>
                      <a:r>
                        <a:rPr lang="en-GB" sz="1000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GB" sz="1000" baseline="300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GB" sz="10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27" name="Straight Arrow Connector 26">
                      <a:extLst>
                        <a:ext uri="{FF2B5EF4-FFF2-40B4-BE49-F238E27FC236}">
                          <a16:creationId xmlns:a16="http://schemas.microsoft.com/office/drawing/2014/main" xmlns="" id="{122EA4EC-1949-8C46-9213-36FBA8C4E38D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rot="16200000">
                      <a:off x="4778951" y="3978857"/>
                      <a:ext cx="0" cy="252000"/>
                    </a:xfrm>
                    <a:prstGeom prst="straightConnector1">
                      <a:avLst/>
                    </a:prstGeom>
                    <a:ln w="12700">
                      <a:solidFill>
                        <a:schemeClr val="tx1"/>
                      </a:solidFill>
                      <a:headEnd type="none"/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xmlns="" id="{927885E9-4A53-844A-A71B-16C6AF18344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97287" y="4236262"/>
                      <a:ext cx="1697400" cy="50783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tIns="0" bIns="0" rtlCol="0">
                      <a:spAutoFit/>
                    </a:bodyPr>
                    <a:lstStyle/>
                    <a:p>
                      <a:pPr algn="ctr"/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trate and nitrite ammonification</a:t>
                      </a:r>
                    </a:p>
                    <a:p>
                      <a:endPara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</p:grpSp>
          <p:sp>
            <p:nvSpPr>
              <p:cNvPr id="16" name="Rectangle 15"/>
              <p:cNvSpPr/>
              <p:nvPr/>
            </p:nvSpPr>
            <p:spPr>
              <a:xfrm>
                <a:off x="8243810" y="0"/>
                <a:ext cx="972126" cy="29238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300" b="1" dirty="0"/>
                  <a:t>Respiration</a:t>
                </a:r>
                <a:endParaRPr lang="en-GB" sz="1300" dirty="0"/>
              </a:p>
            </p:txBody>
          </p:sp>
        </p:grpSp>
        <p:sp>
          <p:nvSpPr>
            <p:cNvPr id="7" name="TextBox 6"/>
            <p:cNvSpPr txBox="1"/>
            <p:nvPr/>
          </p:nvSpPr>
          <p:spPr>
            <a:xfrm>
              <a:off x="9252169" y="3477766"/>
              <a:ext cx="8257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H</a:t>
              </a:r>
              <a:r>
                <a:rPr lang="en-GB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l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38800" y="3166706"/>
              <a:ext cx="8257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H</a:t>
              </a:r>
              <a:r>
                <a:rPr lang="en-GB" sz="16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GB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l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375795" y="3048608"/>
              <a:ext cx="4128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222687" y="3352729"/>
              <a:ext cx="6427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cmuA</a:t>
              </a:r>
            </a:p>
          </p:txBody>
        </p:sp>
        <p:sp>
          <p:nvSpPr>
            <p:cNvPr id="11" name="Rounded Rectangle 10"/>
            <p:cNvSpPr/>
            <p:nvPr/>
          </p:nvSpPr>
          <p:spPr>
            <a:xfrm rot="8154138">
              <a:off x="9229481" y="3191675"/>
              <a:ext cx="355848" cy="290206"/>
            </a:xfrm>
            <a:prstGeom prst="roundRect">
              <a:avLst>
                <a:gd name="adj" fmla="val 50000"/>
              </a:avLst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9098787" y="3337108"/>
              <a:ext cx="585372" cy="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9228755" y="3152310"/>
              <a:ext cx="4128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?</a:t>
              </a:r>
            </a:p>
          </p:txBody>
        </p:sp>
        <p:cxnSp>
          <p:nvCxnSpPr>
            <p:cNvPr id="14" name="Straight Arrow Connector 13"/>
            <p:cNvCxnSpPr/>
            <p:nvPr/>
          </p:nvCxnSpPr>
          <p:spPr>
            <a:xfrm flipH="1">
              <a:off x="6528930" y="3346634"/>
              <a:ext cx="1857071" cy="1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9" name="TextBox 198"/>
          <p:cNvSpPr txBox="1"/>
          <p:nvPr/>
        </p:nvSpPr>
        <p:spPr>
          <a:xfrm>
            <a:off x="-98640" y="0"/>
            <a:ext cx="353943" cy="982636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100" b="1" dirty="0">
                <a:latin typeface="Palatino Linotype" panose="02040502050505030304" pitchFamily="18" charset="0"/>
              </a:rPr>
              <a:t>Supplementary Figure S6. Metabolic reconstruction of [</a:t>
            </a:r>
            <a:r>
              <a:rPr lang="en-GB" sz="1100" b="1" baseline="30000" dirty="0">
                <a:latin typeface="Palatino Linotype" panose="02040502050505030304" pitchFamily="18" charset="0"/>
              </a:rPr>
              <a:t>13</a:t>
            </a:r>
            <a:r>
              <a:rPr lang="en-GB" sz="1100" b="1" dirty="0">
                <a:latin typeface="Palatino Linotype" panose="02040502050505030304" pitchFamily="18" charset="0"/>
              </a:rPr>
              <a:t>C]-CH</a:t>
            </a:r>
            <a:r>
              <a:rPr lang="en-GB" sz="1100" b="1" baseline="-25000" dirty="0">
                <a:latin typeface="Palatino Linotype" panose="02040502050505030304" pitchFamily="18" charset="0"/>
              </a:rPr>
              <a:t>3</a:t>
            </a:r>
            <a:r>
              <a:rPr lang="en-GB" sz="1100" b="1" dirty="0">
                <a:latin typeface="Palatino Linotype" panose="02040502050505030304" pitchFamily="18" charset="0"/>
              </a:rPr>
              <a:t>Cl labelled metagenome assembled genome “Degraded leaves Bin 11”.</a:t>
            </a:r>
            <a:endParaRPr lang="en-US" sz="11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48750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 rot="16200000">
            <a:off x="-3685378" y="5235401"/>
            <a:ext cx="8486700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b="1" dirty="0">
                <a:latin typeface="Palatino Linotype" panose="02040502050505030304" pitchFamily="18" charset="0"/>
              </a:rPr>
              <a:t>Supplementary Table S1. Summary of metagenome-assembled genomes (MAGs) from the CH</a:t>
            </a:r>
            <a:r>
              <a:rPr lang="en-GB" sz="1050" b="1" baseline="-25000" dirty="0">
                <a:latin typeface="Palatino Linotype" panose="02040502050505030304" pitchFamily="18" charset="0"/>
              </a:rPr>
              <a:t>3</a:t>
            </a:r>
            <a:r>
              <a:rPr lang="en-GB" sz="1050" b="1" dirty="0">
                <a:latin typeface="Palatino Linotype" panose="02040502050505030304" pitchFamily="18" charset="0"/>
              </a:rPr>
              <a:t>Cl-stable isotope probing enrichment. </a:t>
            </a:r>
            <a:r>
              <a:rPr lang="en-GB" sz="1050" dirty="0">
                <a:latin typeface="Palatino Linotype" panose="02040502050505030304" pitchFamily="18" charset="0"/>
              </a:rPr>
              <a:t>Only MAGs with high quality (completeness &gt; 70%, contamination &lt;10%) are shown.</a:t>
            </a:r>
          </a:p>
          <a:p>
            <a:endParaRPr lang="en-GB" sz="1050" dirty="0">
              <a:latin typeface="Palatino Linotype" panose="02040502050505030304" pitchFamily="18" charset="0"/>
            </a:endParaRP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xmlns="" id="{A5F11640-B740-744B-90D0-AFB5727E3E85}"/>
              </a:ext>
            </a:extLst>
          </p:cNvPr>
          <p:cNvGrpSpPr/>
          <p:nvPr/>
        </p:nvGrpSpPr>
        <p:grpSpPr>
          <a:xfrm>
            <a:off x="908720" y="130255"/>
            <a:ext cx="3888433" cy="9637037"/>
            <a:chOff x="918439" y="130255"/>
            <a:chExt cx="3888433" cy="9637037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xmlns="" id="{29CC8564-91AC-2745-BFB3-370844E91A10}"/>
                </a:ext>
              </a:extLst>
            </p:cNvPr>
            <p:cNvGrpSpPr/>
            <p:nvPr/>
          </p:nvGrpSpPr>
          <p:grpSpPr>
            <a:xfrm>
              <a:off x="918440" y="130255"/>
              <a:ext cx="3888432" cy="9637037"/>
              <a:chOff x="918440" y="130255"/>
              <a:chExt cx="3888432" cy="9637037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17D13D7B-4D7D-6149-BF3B-27FB46D6E77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16200000">
                <a:off x="-1955863" y="3004558"/>
                <a:ext cx="9637037" cy="3888432"/>
              </a:xfrm>
              <a:prstGeom prst="rect">
                <a:avLst/>
              </a:prstGeom>
            </p:spPr>
          </p:pic>
          <p:cxnSp>
            <p:nvCxnSpPr>
              <p:cNvPr id="3" name="Straight Connector 2">
                <a:extLst>
                  <a:ext uri="{FF2B5EF4-FFF2-40B4-BE49-F238E27FC236}">
                    <a16:creationId xmlns:a16="http://schemas.microsoft.com/office/drawing/2014/main" xmlns="" id="{84E848CD-3B5D-C244-812A-B266A62A1247}"/>
                  </a:ext>
                </a:extLst>
              </p:cNvPr>
              <p:cNvCxnSpPr/>
              <p:nvPr/>
            </p:nvCxnSpPr>
            <p:spPr>
              <a:xfrm>
                <a:off x="927305" y="3800872"/>
                <a:ext cx="3797839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773007BF-90E4-0C44-9E50-5DDFD9CBFCCF}"/>
                </a:ext>
              </a:extLst>
            </p:cNvPr>
            <p:cNvSpPr txBox="1"/>
            <p:nvPr/>
          </p:nvSpPr>
          <p:spPr>
            <a:xfrm rot="10800000">
              <a:off x="918439" y="3374338"/>
              <a:ext cx="8659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ccession: Q9APJ8</a:t>
              </a:r>
            </a:p>
            <a:p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ength: 612 b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37448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652</TotalTime>
  <Words>1222</Words>
  <Application>Microsoft Office PowerPoint</Application>
  <PresentationFormat>A4 Paper (210x297 mm)</PresentationFormat>
  <Paragraphs>305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MS Mincho</vt:lpstr>
      <vt:lpstr>Palatino Linotype</vt:lpstr>
      <vt:lpstr>Time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roeber</dc:creator>
  <cp:lastModifiedBy>Caroline Rubince G.</cp:lastModifiedBy>
  <cp:revision>69</cp:revision>
  <cp:lastPrinted>2021-08-18T14:02:15Z</cp:lastPrinted>
  <dcterms:created xsi:type="dcterms:W3CDTF">2018-06-26T09:56:46Z</dcterms:created>
  <dcterms:modified xsi:type="dcterms:W3CDTF">2022-04-25T11:28:42Z</dcterms:modified>
</cp:coreProperties>
</file>